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slides/slide131.xml" ContentType="application/vnd.openxmlformats-officedocument.presentationml.slide+xml"/>
  <Override PartName="/ppt/slides/slide132.xml" ContentType="application/vnd.openxmlformats-officedocument.presentationml.slide+xml"/>
  <Override PartName="/ppt/slides/slide133.xml" ContentType="application/vnd.openxmlformats-officedocument.presentationml.slide+xml"/>
  <Override PartName="/ppt/slides/slide134.xml" ContentType="application/vnd.openxmlformats-officedocument.presentationml.slide+xml"/>
  <Override PartName="/ppt/slides/slide135.xml" ContentType="application/vnd.openxmlformats-officedocument.presentationml.slide+xml"/>
  <Override PartName="/ppt/slides/slide136.xml" ContentType="application/vnd.openxmlformats-officedocument.presentationml.slide+xml"/>
  <Override PartName="/ppt/slides/slide137.xml" ContentType="application/vnd.openxmlformats-officedocument.presentationml.slide+xml"/>
  <Override PartName="/ppt/slides/slide138.xml" ContentType="application/vnd.openxmlformats-officedocument.presentationml.slide+xml"/>
  <Override PartName="/ppt/slides/slide139.xml" ContentType="application/vnd.openxmlformats-officedocument.presentationml.slide+xml"/>
  <Override PartName="/ppt/slides/slide140.xml" ContentType="application/vnd.openxmlformats-officedocument.presentationml.slide+xml"/>
  <Override PartName="/ppt/slides/slide141.xml" ContentType="application/vnd.openxmlformats-officedocument.presentationml.slide+xml"/>
  <Override PartName="/ppt/slides/slide142.xml" ContentType="application/vnd.openxmlformats-officedocument.presentationml.slide+xml"/>
  <Override PartName="/ppt/slides/slide143.xml" ContentType="application/vnd.openxmlformats-officedocument.presentationml.slide+xml"/>
  <Override PartName="/ppt/slides/slide144.xml" ContentType="application/vnd.openxmlformats-officedocument.presentationml.slide+xml"/>
  <Override PartName="/ppt/slides/slide145.xml" ContentType="application/vnd.openxmlformats-officedocument.presentationml.slide+xml"/>
  <Override PartName="/ppt/slides/slide146.xml" ContentType="application/vnd.openxmlformats-officedocument.presentationml.slide+xml"/>
  <Override PartName="/ppt/slides/slide147.xml" ContentType="application/vnd.openxmlformats-officedocument.presentationml.slide+xml"/>
  <Override PartName="/ppt/slides/slide148.xml" ContentType="application/vnd.openxmlformats-officedocument.presentationml.slide+xml"/>
  <Override PartName="/ppt/slides/slide149.xml" ContentType="application/vnd.openxmlformats-officedocument.presentationml.slide+xml"/>
  <Override PartName="/ppt/slides/slide150.xml" ContentType="application/vnd.openxmlformats-officedocument.presentationml.slide+xml"/>
  <Override PartName="/ppt/slides/slide151.xml" ContentType="application/vnd.openxmlformats-officedocument.presentationml.slide+xml"/>
  <Override PartName="/ppt/slides/slide152.xml" ContentType="application/vnd.openxmlformats-officedocument.presentationml.slide+xml"/>
  <Override PartName="/ppt/slides/slide153.xml" ContentType="application/vnd.openxmlformats-officedocument.presentationml.slide+xml"/>
  <Override PartName="/ppt/slides/slide154.xml" ContentType="application/vnd.openxmlformats-officedocument.presentationml.slide+xml"/>
  <Override PartName="/ppt/slides/slide155.xml" ContentType="application/vnd.openxmlformats-officedocument.presentationml.slide+xml"/>
  <Override PartName="/ppt/slides/slide156.xml" ContentType="application/vnd.openxmlformats-officedocument.presentationml.slide+xml"/>
  <Override PartName="/ppt/slides/slide157.xml" ContentType="application/vnd.openxmlformats-officedocument.presentationml.slide+xml"/>
  <Override PartName="/ppt/slides/slide158.xml" ContentType="application/vnd.openxmlformats-officedocument.presentationml.slide+xml"/>
  <Override PartName="/ppt/slides/slide159.xml" ContentType="application/vnd.openxmlformats-officedocument.presentationml.slide+xml"/>
  <Override PartName="/ppt/slides/slide160.xml" ContentType="application/vnd.openxmlformats-officedocument.presentationml.slide+xml"/>
  <Override PartName="/ppt/slides/slide161.xml" ContentType="application/vnd.openxmlformats-officedocument.presentationml.slide+xml"/>
  <Override PartName="/ppt/slides/slide162.xml" ContentType="application/vnd.openxmlformats-officedocument.presentationml.slide+xml"/>
  <Override PartName="/ppt/slides/slide163.xml" ContentType="application/vnd.openxmlformats-officedocument.presentationml.slide+xml"/>
  <Override PartName="/ppt/slides/slide164.xml" ContentType="application/vnd.openxmlformats-officedocument.presentationml.slide+xml"/>
  <Override PartName="/ppt/slides/slide165.xml" ContentType="application/vnd.openxmlformats-officedocument.presentationml.slide+xml"/>
  <Override PartName="/ppt/slides/slide166.xml" ContentType="application/vnd.openxmlformats-officedocument.presentationml.slide+xml"/>
  <Override PartName="/ppt/slides/slide167.xml" ContentType="application/vnd.openxmlformats-officedocument.presentationml.slide+xml"/>
  <Override PartName="/ppt/slides/slide168.xml" ContentType="application/vnd.openxmlformats-officedocument.presentationml.slide+xml"/>
  <Override PartName="/ppt/slides/slide169.xml" ContentType="application/vnd.openxmlformats-officedocument.presentationml.slide+xml"/>
  <Override PartName="/ppt/slides/slide170.xml" ContentType="application/vnd.openxmlformats-officedocument.presentationml.slide+xml"/>
  <Override PartName="/ppt/slides/slide171.xml" ContentType="application/vnd.openxmlformats-officedocument.presentationml.slide+xml"/>
  <Override PartName="/ppt/slides/slide172.xml" ContentType="application/vnd.openxmlformats-officedocument.presentationml.slide+xml"/>
  <Override PartName="/ppt/slides/slide173.xml" ContentType="application/vnd.openxmlformats-officedocument.presentationml.slide+xml"/>
  <Override PartName="/ppt/slides/slide174.xml" ContentType="application/vnd.openxmlformats-officedocument.presentationml.slide+xml"/>
  <Override PartName="/ppt/slides/slide175.xml" ContentType="application/vnd.openxmlformats-officedocument.presentationml.slide+xml"/>
  <Override PartName="/ppt/slides/slide176.xml" ContentType="application/vnd.openxmlformats-officedocument.presentationml.slide+xml"/>
  <Override PartName="/ppt/slides/slide177.xml" ContentType="application/vnd.openxmlformats-officedocument.presentationml.slide+xml"/>
  <Override PartName="/ppt/slides/slide178.xml" ContentType="application/vnd.openxmlformats-officedocument.presentationml.slide+xml"/>
  <Override PartName="/ppt/slides/slide179.xml" ContentType="application/vnd.openxmlformats-officedocument.presentationml.slide+xml"/>
  <Override PartName="/ppt/slides/slide180.xml" ContentType="application/vnd.openxmlformats-officedocument.presentationml.slide+xml"/>
  <Override PartName="/ppt/slides/slide181.xml" ContentType="application/vnd.openxmlformats-officedocument.presentationml.slide+xml"/>
  <Override PartName="/ppt/slides/slide182.xml" ContentType="application/vnd.openxmlformats-officedocument.presentationml.slide+xml"/>
  <Override PartName="/ppt/slides/slide183.xml" ContentType="application/vnd.openxmlformats-officedocument.presentationml.slide+xml"/>
  <Override PartName="/ppt/slides/slide18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86"/>
  </p:notesMasterIdLst>
  <p:sldIdLst>
    <p:sldId id="490" r:id="rId2"/>
    <p:sldId id="256" r:id="rId3"/>
    <p:sldId id="257" r:id="rId4"/>
    <p:sldId id="258" r:id="rId5"/>
    <p:sldId id="259" r:id="rId6"/>
    <p:sldId id="455" r:id="rId7"/>
    <p:sldId id="456" r:id="rId8"/>
    <p:sldId id="260" r:id="rId9"/>
    <p:sldId id="457" r:id="rId10"/>
    <p:sldId id="261" r:id="rId11"/>
    <p:sldId id="262" r:id="rId12"/>
    <p:sldId id="458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  <p:sldId id="459" r:id="rId26"/>
    <p:sldId id="276" r:id="rId27"/>
    <p:sldId id="277" r:id="rId28"/>
    <p:sldId id="279" r:id="rId29"/>
    <p:sldId id="280" r:id="rId30"/>
    <p:sldId id="281" r:id="rId31"/>
    <p:sldId id="282" r:id="rId32"/>
    <p:sldId id="451" r:id="rId33"/>
    <p:sldId id="452" r:id="rId34"/>
    <p:sldId id="283" r:id="rId35"/>
    <p:sldId id="284" r:id="rId36"/>
    <p:sldId id="460" r:id="rId37"/>
    <p:sldId id="286" r:id="rId38"/>
    <p:sldId id="288" r:id="rId39"/>
    <p:sldId id="287" r:id="rId40"/>
    <p:sldId id="289" r:id="rId41"/>
    <p:sldId id="461" r:id="rId42"/>
    <p:sldId id="290" r:id="rId43"/>
    <p:sldId id="291" r:id="rId44"/>
    <p:sldId id="292" r:id="rId45"/>
    <p:sldId id="293" r:id="rId46"/>
    <p:sldId id="294" r:id="rId47"/>
    <p:sldId id="295" r:id="rId48"/>
    <p:sldId id="297" r:id="rId49"/>
    <p:sldId id="296" r:id="rId50"/>
    <p:sldId id="298" r:id="rId51"/>
    <p:sldId id="462" r:id="rId52"/>
    <p:sldId id="299" r:id="rId53"/>
    <p:sldId id="300" r:id="rId54"/>
    <p:sldId id="301" r:id="rId55"/>
    <p:sldId id="302" r:id="rId56"/>
    <p:sldId id="303" r:id="rId57"/>
    <p:sldId id="304" r:id="rId58"/>
    <p:sldId id="463" r:id="rId59"/>
    <p:sldId id="305" r:id="rId60"/>
    <p:sldId id="464" r:id="rId61"/>
    <p:sldId id="465" r:id="rId62"/>
    <p:sldId id="466" r:id="rId63"/>
    <p:sldId id="306" r:id="rId64"/>
    <p:sldId id="467" r:id="rId65"/>
    <p:sldId id="307" r:id="rId66"/>
    <p:sldId id="468" r:id="rId67"/>
    <p:sldId id="308" r:id="rId68"/>
    <p:sldId id="309" r:id="rId69"/>
    <p:sldId id="312" r:id="rId70"/>
    <p:sldId id="313" r:id="rId71"/>
    <p:sldId id="314" r:id="rId72"/>
    <p:sldId id="315" r:id="rId73"/>
    <p:sldId id="316" r:id="rId74"/>
    <p:sldId id="469" r:id="rId75"/>
    <p:sldId id="470" r:id="rId76"/>
    <p:sldId id="317" r:id="rId77"/>
    <p:sldId id="318" r:id="rId78"/>
    <p:sldId id="319" r:id="rId79"/>
    <p:sldId id="320" r:id="rId80"/>
    <p:sldId id="471" r:id="rId81"/>
    <p:sldId id="321" r:id="rId82"/>
    <p:sldId id="322" r:id="rId83"/>
    <p:sldId id="323" r:id="rId84"/>
    <p:sldId id="324" r:id="rId85"/>
    <p:sldId id="325" r:id="rId86"/>
    <p:sldId id="326" r:id="rId87"/>
    <p:sldId id="327" r:id="rId88"/>
    <p:sldId id="329" r:id="rId89"/>
    <p:sldId id="330" r:id="rId90"/>
    <p:sldId id="331" r:id="rId91"/>
    <p:sldId id="332" r:id="rId92"/>
    <p:sldId id="328" r:id="rId93"/>
    <p:sldId id="333" r:id="rId94"/>
    <p:sldId id="334" r:id="rId95"/>
    <p:sldId id="335" r:id="rId96"/>
    <p:sldId id="444" r:id="rId97"/>
    <p:sldId id="472" r:id="rId98"/>
    <p:sldId id="337" r:id="rId99"/>
    <p:sldId id="338" r:id="rId100"/>
    <p:sldId id="339" r:id="rId101"/>
    <p:sldId id="340" r:id="rId102"/>
    <p:sldId id="473" r:id="rId103"/>
    <p:sldId id="341" r:id="rId104"/>
    <p:sldId id="474" r:id="rId105"/>
    <p:sldId id="342" r:id="rId106"/>
    <p:sldId id="343" r:id="rId107"/>
    <p:sldId id="344" r:id="rId108"/>
    <p:sldId id="345" r:id="rId109"/>
    <p:sldId id="346" r:id="rId110"/>
    <p:sldId id="475" r:id="rId111"/>
    <p:sldId id="445" r:id="rId112"/>
    <p:sldId id="476" r:id="rId113"/>
    <p:sldId id="477" r:id="rId114"/>
    <p:sldId id="348" r:id="rId115"/>
    <p:sldId id="478" r:id="rId116"/>
    <p:sldId id="479" r:id="rId117"/>
    <p:sldId id="350" r:id="rId118"/>
    <p:sldId id="351" r:id="rId119"/>
    <p:sldId id="352" r:id="rId120"/>
    <p:sldId id="353" r:id="rId121"/>
    <p:sldId id="354" r:id="rId122"/>
    <p:sldId id="355" r:id="rId123"/>
    <p:sldId id="358" r:id="rId124"/>
    <p:sldId id="359" r:id="rId125"/>
    <p:sldId id="360" r:id="rId126"/>
    <p:sldId id="361" r:id="rId127"/>
    <p:sldId id="362" r:id="rId128"/>
    <p:sldId id="363" r:id="rId129"/>
    <p:sldId id="364" r:id="rId130"/>
    <p:sldId id="365" r:id="rId131"/>
    <p:sldId id="366" r:id="rId132"/>
    <p:sldId id="480" r:id="rId133"/>
    <p:sldId id="481" r:id="rId134"/>
    <p:sldId id="482" r:id="rId135"/>
    <p:sldId id="367" r:id="rId136"/>
    <p:sldId id="368" r:id="rId137"/>
    <p:sldId id="483" r:id="rId138"/>
    <p:sldId id="370" r:id="rId139"/>
    <p:sldId id="371" r:id="rId140"/>
    <p:sldId id="448" r:id="rId141"/>
    <p:sldId id="484" r:id="rId142"/>
    <p:sldId id="485" r:id="rId143"/>
    <p:sldId id="376" r:id="rId144"/>
    <p:sldId id="377" r:id="rId145"/>
    <p:sldId id="378" r:id="rId146"/>
    <p:sldId id="379" r:id="rId147"/>
    <p:sldId id="381" r:id="rId148"/>
    <p:sldId id="382" r:id="rId149"/>
    <p:sldId id="383" r:id="rId150"/>
    <p:sldId id="486" r:id="rId151"/>
    <p:sldId id="384" r:id="rId152"/>
    <p:sldId id="385" r:id="rId153"/>
    <p:sldId id="487" r:id="rId154"/>
    <p:sldId id="386" r:id="rId155"/>
    <p:sldId id="387" r:id="rId156"/>
    <p:sldId id="389" r:id="rId157"/>
    <p:sldId id="388" r:id="rId158"/>
    <p:sldId id="390" r:id="rId159"/>
    <p:sldId id="391" r:id="rId160"/>
    <p:sldId id="392" r:id="rId161"/>
    <p:sldId id="393" r:id="rId162"/>
    <p:sldId id="394" r:id="rId163"/>
    <p:sldId id="395" r:id="rId164"/>
    <p:sldId id="488" r:id="rId165"/>
    <p:sldId id="396" r:id="rId166"/>
    <p:sldId id="397" r:id="rId167"/>
    <p:sldId id="398" r:id="rId168"/>
    <p:sldId id="399" r:id="rId169"/>
    <p:sldId id="400" r:id="rId170"/>
    <p:sldId id="401" r:id="rId171"/>
    <p:sldId id="402" r:id="rId172"/>
    <p:sldId id="403" r:id="rId173"/>
    <p:sldId id="489" r:id="rId174"/>
    <p:sldId id="404" r:id="rId175"/>
    <p:sldId id="405" r:id="rId176"/>
    <p:sldId id="407" r:id="rId177"/>
    <p:sldId id="449" r:id="rId178"/>
    <p:sldId id="408" r:id="rId179"/>
    <p:sldId id="409" r:id="rId180"/>
    <p:sldId id="410" r:id="rId181"/>
    <p:sldId id="411" r:id="rId182"/>
    <p:sldId id="412" r:id="rId183"/>
    <p:sldId id="413" r:id="rId184"/>
    <p:sldId id="426" r:id="rId18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02" autoAdjust="0"/>
    <p:restoredTop sz="94660"/>
  </p:normalViewPr>
  <p:slideViewPr>
    <p:cSldViewPr>
      <p:cViewPr>
        <p:scale>
          <a:sx n="100" d="100"/>
          <a:sy n="100" d="100"/>
        </p:scale>
        <p:origin x="-2936" y="-8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42" Type="http://schemas.openxmlformats.org/officeDocument/2006/relationships/slide" Target="slides/slide141.xml"/><Relationship Id="rId143" Type="http://schemas.openxmlformats.org/officeDocument/2006/relationships/slide" Target="slides/slide142.xml"/><Relationship Id="rId144" Type="http://schemas.openxmlformats.org/officeDocument/2006/relationships/slide" Target="slides/slide143.xml"/><Relationship Id="rId145" Type="http://schemas.openxmlformats.org/officeDocument/2006/relationships/slide" Target="slides/slide144.xml"/><Relationship Id="rId146" Type="http://schemas.openxmlformats.org/officeDocument/2006/relationships/slide" Target="slides/slide145.xml"/><Relationship Id="rId147" Type="http://schemas.openxmlformats.org/officeDocument/2006/relationships/slide" Target="slides/slide146.xml"/><Relationship Id="rId148" Type="http://schemas.openxmlformats.org/officeDocument/2006/relationships/slide" Target="slides/slide147.xml"/><Relationship Id="rId149" Type="http://schemas.openxmlformats.org/officeDocument/2006/relationships/slide" Target="slides/slide148.xml"/><Relationship Id="rId180" Type="http://schemas.openxmlformats.org/officeDocument/2006/relationships/slide" Target="slides/slide179.xml"/><Relationship Id="rId181" Type="http://schemas.openxmlformats.org/officeDocument/2006/relationships/slide" Target="slides/slide180.xml"/><Relationship Id="rId182" Type="http://schemas.openxmlformats.org/officeDocument/2006/relationships/slide" Target="slides/slide181.xml"/><Relationship Id="rId40" Type="http://schemas.openxmlformats.org/officeDocument/2006/relationships/slide" Target="slides/slide39.xml"/><Relationship Id="rId41" Type="http://schemas.openxmlformats.org/officeDocument/2006/relationships/slide" Target="slides/slide40.xml"/><Relationship Id="rId42" Type="http://schemas.openxmlformats.org/officeDocument/2006/relationships/slide" Target="slides/slide41.xml"/><Relationship Id="rId43" Type="http://schemas.openxmlformats.org/officeDocument/2006/relationships/slide" Target="slides/slide42.xml"/><Relationship Id="rId44" Type="http://schemas.openxmlformats.org/officeDocument/2006/relationships/slide" Target="slides/slide43.xml"/><Relationship Id="rId45" Type="http://schemas.openxmlformats.org/officeDocument/2006/relationships/slide" Target="slides/slide44.xml"/><Relationship Id="rId46" Type="http://schemas.openxmlformats.org/officeDocument/2006/relationships/slide" Target="slides/slide45.xml"/><Relationship Id="rId47" Type="http://schemas.openxmlformats.org/officeDocument/2006/relationships/slide" Target="slides/slide46.xml"/><Relationship Id="rId48" Type="http://schemas.openxmlformats.org/officeDocument/2006/relationships/slide" Target="slides/slide47.xml"/><Relationship Id="rId49" Type="http://schemas.openxmlformats.org/officeDocument/2006/relationships/slide" Target="slides/slide48.xml"/><Relationship Id="rId183" Type="http://schemas.openxmlformats.org/officeDocument/2006/relationships/slide" Target="slides/slide182.xml"/><Relationship Id="rId184" Type="http://schemas.openxmlformats.org/officeDocument/2006/relationships/slide" Target="slides/slide183.xml"/><Relationship Id="rId185" Type="http://schemas.openxmlformats.org/officeDocument/2006/relationships/slide" Target="slides/slide184.xml"/><Relationship Id="rId186" Type="http://schemas.openxmlformats.org/officeDocument/2006/relationships/notesMaster" Target="notesMasters/notesMaster1.xml"/><Relationship Id="rId187" Type="http://schemas.openxmlformats.org/officeDocument/2006/relationships/printerSettings" Target="printerSettings/printerSettings1.bin"/><Relationship Id="rId188" Type="http://schemas.openxmlformats.org/officeDocument/2006/relationships/presProps" Target="presProps.xml"/><Relationship Id="rId189" Type="http://schemas.openxmlformats.org/officeDocument/2006/relationships/viewProps" Target="viewProps.xml"/><Relationship Id="rId80" Type="http://schemas.openxmlformats.org/officeDocument/2006/relationships/slide" Target="slides/slide79.xml"/><Relationship Id="rId81" Type="http://schemas.openxmlformats.org/officeDocument/2006/relationships/slide" Target="slides/slide80.xml"/><Relationship Id="rId82" Type="http://schemas.openxmlformats.org/officeDocument/2006/relationships/slide" Target="slides/slide81.xml"/><Relationship Id="rId83" Type="http://schemas.openxmlformats.org/officeDocument/2006/relationships/slide" Target="slides/slide82.xml"/><Relationship Id="rId84" Type="http://schemas.openxmlformats.org/officeDocument/2006/relationships/slide" Target="slides/slide83.xml"/><Relationship Id="rId85" Type="http://schemas.openxmlformats.org/officeDocument/2006/relationships/slide" Target="slides/slide84.xml"/><Relationship Id="rId86" Type="http://schemas.openxmlformats.org/officeDocument/2006/relationships/slide" Target="slides/slide85.xml"/><Relationship Id="rId87" Type="http://schemas.openxmlformats.org/officeDocument/2006/relationships/slide" Target="slides/slide86.xml"/><Relationship Id="rId88" Type="http://schemas.openxmlformats.org/officeDocument/2006/relationships/slide" Target="slides/slide87.xml"/><Relationship Id="rId89" Type="http://schemas.openxmlformats.org/officeDocument/2006/relationships/slide" Target="slides/slide88.xml"/><Relationship Id="rId110" Type="http://schemas.openxmlformats.org/officeDocument/2006/relationships/slide" Target="slides/slide109.xml"/><Relationship Id="rId111" Type="http://schemas.openxmlformats.org/officeDocument/2006/relationships/slide" Target="slides/slide110.xml"/><Relationship Id="rId112" Type="http://schemas.openxmlformats.org/officeDocument/2006/relationships/slide" Target="slides/slide111.xml"/><Relationship Id="rId113" Type="http://schemas.openxmlformats.org/officeDocument/2006/relationships/slide" Target="slides/slide112.xml"/><Relationship Id="rId114" Type="http://schemas.openxmlformats.org/officeDocument/2006/relationships/slide" Target="slides/slide113.xml"/><Relationship Id="rId115" Type="http://schemas.openxmlformats.org/officeDocument/2006/relationships/slide" Target="slides/slide114.xml"/><Relationship Id="rId116" Type="http://schemas.openxmlformats.org/officeDocument/2006/relationships/slide" Target="slides/slide115.xml"/><Relationship Id="rId117" Type="http://schemas.openxmlformats.org/officeDocument/2006/relationships/slide" Target="slides/slide116.xml"/><Relationship Id="rId118" Type="http://schemas.openxmlformats.org/officeDocument/2006/relationships/slide" Target="slides/slide117.xml"/><Relationship Id="rId119" Type="http://schemas.openxmlformats.org/officeDocument/2006/relationships/slide" Target="slides/slide118.xml"/><Relationship Id="rId150" Type="http://schemas.openxmlformats.org/officeDocument/2006/relationships/slide" Target="slides/slide149.xml"/><Relationship Id="rId151" Type="http://schemas.openxmlformats.org/officeDocument/2006/relationships/slide" Target="slides/slide150.xml"/><Relationship Id="rId152" Type="http://schemas.openxmlformats.org/officeDocument/2006/relationships/slide" Target="slides/slide151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53" Type="http://schemas.openxmlformats.org/officeDocument/2006/relationships/slide" Target="slides/slide152.xml"/><Relationship Id="rId154" Type="http://schemas.openxmlformats.org/officeDocument/2006/relationships/slide" Target="slides/slide153.xml"/><Relationship Id="rId155" Type="http://schemas.openxmlformats.org/officeDocument/2006/relationships/slide" Target="slides/slide154.xml"/><Relationship Id="rId156" Type="http://schemas.openxmlformats.org/officeDocument/2006/relationships/slide" Target="slides/slide155.xml"/><Relationship Id="rId157" Type="http://schemas.openxmlformats.org/officeDocument/2006/relationships/slide" Target="slides/slide156.xml"/><Relationship Id="rId158" Type="http://schemas.openxmlformats.org/officeDocument/2006/relationships/slide" Target="slides/slide157.xml"/><Relationship Id="rId159" Type="http://schemas.openxmlformats.org/officeDocument/2006/relationships/slide" Target="slides/slide158.xml"/><Relationship Id="rId190" Type="http://schemas.openxmlformats.org/officeDocument/2006/relationships/theme" Target="theme/theme1.xml"/><Relationship Id="rId191" Type="http://schemas.openxmlformats.org/officeDocument/2006/relationships/tableStyles" Target="tableStyles.xml"/><Relationship Id="rId50" Type="http://schemas.openxmlformats.org/officeDocument/2006/relationships/slide" Target="slides/slide49.xml"/><Relationship Id="rId51" Type="http://schemas.openxmlformats.org/officeDocument/2006/relationships/slide" Target="slides/slide50.xml"/><Relationship Id="rId52" Type="http://schemas.openxmlformats.org/officeDocument/2006/relationships/slide" Target="slides/slide51.xml"/><Relationship Id="rId53" Type="http://schemas.openxmlformats.org/officeDocument/2006/relationships/slide" Target="slides/slide52.xml"/><Relationship Id="rId54" Type="http://schemas.openxmlformats.org/officeDocument/2006/relationships/slide" Target="slides/slide53.xml"/><Relationship Id="rId55" Type="http://schemas.openxmlformats.org/officeDocument/2006/relationships/slide" Target="slides/slide54.xml"/><Relationship Id="rId56" Type="http://schemas.openxmlformats.org/officeDocument/2006/relationships/slide" Target="slides/slide55.xml"/><Relationship Id="rId57" Type="http://schemas.openxmlformats.org/officeDocument/2006/relationships/slide" Target="slides/slide56.xml"/><Relationship Id="rId58" Type="http://schemas.openxmlformats.org/officeDocument/2006/relationships/slide" Target="slides/slide57.xml"/><Relationship Id="rId59" Type="http://schemas.openxmlformats.org/officeDocument/2006/relationships/slide" Target="slides/slide58.xml"/><Relationship Id="rId90" Type="http://schemas.openxmlformats.org/officeDocument/2006/relationships/slide" Target="slides/slide89.xml"/><Relationship Id="rId91" Type="http://schemas.openxmlformats.org/officeDocument/2006/relationships/slide" Target="slides/slide90.xml"/><Relationship Id="rId92" Type="http://schemas.openxmlformats.org/officeDocument/2006/relationships/slide" Target="slides/slide91.xml"/><Relationship Id="rId93" Type="http://schemas.openxmlformats.org/officeDocument/2006/relationships/slide" Target="slides/slide92.xml"/><Relationship Id="rId94" Type="http://schemas.openxmlformats.org/officeDocument/2006/relationships/slide" Target="slides/slide93.xml"/><Relationship Id="rId95" Type="http://schemas.openxmlformats.org/officeDocument/2006/relationships/slide" Target="slides/slide94.xml"/><Relationship Id="rId96" Type="http://schemas.openxmlformats.org/officeDocument/2006/relationships/slide" Target="slides/slide95.xml"/><Relationship Id="rId97" Type="http://schemas.openxmlformats.org/officeDocument/2006/relationships/slide" Target="slides/slide96.xml"/><Relationship Id="rId98" Type="http://schemas.openxmlformats.org/officeDocument/2006/relationships/slide" Target="slides/slide97.xml"/><Relationship Id="rId99" Type="http://schemas.openxmlformats.org/officeDocument/2006/relationships/slide" Target="slides/slide98.xml"/><Relationship Id="rId120" Type="http://schemas.openxmlformats.org/officeDocument/2006/relationships/slide" Target="slides/slide119.xml"/><Relationship Id="rId121" Type="http://schemas.openxmlformats.org/officeDocument/2006/relationships/slide" Target="slides/slide120.xml"/><Relationship Id="rId122" Type="http://schemas.openxmlformats.org/officeDocument/2006/relationships/slide" Target="slides/slide121.xml"/><Relationship Id="rId123" Type="http://schemas.openxmlformats.org/officeDocument/2006/relationships/slide" Target="slides/slide122.xml"/><Relationship Id="rId124" Type="http://schemas.openxmlformats.org/officeDocument/2006/relationships/slide" Target="slides/slide123.xml"/><Relationship Id="rId125" Type="http://schemas.openxmlformats.org/officeDocument/2006/relationships/slide" Target="slides/slide124.xml"/><Relationship Id="rId126" Type="http://schemas.openxmlformats.org/officeDocument/2006/relationships/slide" Target="slides/slide125.xml"/><Relationship Id="rId127" Type="http://schemas.openxmlformats.org/officeDocument/2006/relationships/slide" Target="slides/slide126.xml"/><Relationship Id="rId128" Type="http://schemas.openxmlformats.org/officeDocument/2006/relationships/slide" Target="slides/slide127.xml"/><Relationship Id="rId129" Type="http://schemas.openxmlformats.org/officeDocument/2006/relationships/slide" Target="slides/slide128.xml"/><Relationship Id="rId160" Type="http://schemas.openxmlformats.org/officeDocument/2006/relationships/slide" Target="slides/slide159.xml"/><Relationship Id="rId161" Type="http://schemas.openxmlformats.org/officeDocument/2006/relationships/slide" Target="slides/slide160.xml"/><Relationship Id="rId162" Type="http://schemas.openxmlformats.org/officeDocument/2006/relationships/slide" Target="slides/slide161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63" Type="http://schemas.openxmlformats.org/officeDocument/2006/relationships/slide" Target="slides/slide162.xml"/><Relationship Id="rId164" Type="http://schemas.openxmlformats.org/officeDocument/2006/relationships/slide" Target="slides/slide163.xml"/><Relationship Id="rId165" Type="http://schemas.openxmlformats.org/officeDocument/2006/relationships/slide" Target="slides/slide164.xml"/><Relationship Id="rId166" Type="http://schemas.openxmlformats.org/officeDocument/2006/relationships/slide" Target="slides/slide165.xml"/><Relationship Id="rId167" Type="http://schemas.openxmlformats.org/officeDocument/2006/relationships/slide" Target="slides/slide166.xml"/><Relationship Id="rId168" Type="http://schemas.openxmlformats.org/officeDocument/2006/relationships/slide" Target="slides/slide167.xml"/><Relationship Id="rId169" Type="http://schemas.openxmlformats.org/officeDocument/2006/relationships/slide" Target="slides/slide168.xml"/><Relationship Id="rId60" Type="http://schemas.openxmlformats.org/officeDocument/2006/relationships/slide" Target="slides/slide59.xml"/><Relationship Id="rId61" Type="http://schemas.openxmlformats.org/officeDocument/2006/relationships/slide" Target="slides/slide60.xml"/><Relationship Id="rId62" Type="http://schemas.openxmlformats.org/officeDocument/2006/relationships/slide" Target="slides/slide61.xml"/><Relationship Id="rId63" Type="http://schemas.openxmlformats.org/officeDocument/2006/relationships/slide" Target="slides/slide62.xml"/><Relationship Id="rId64" Type="http://schemas.openxmlformats.org/officeDocument/2006/relationships/slide" Target="slides/slide63.xml"/><Relationship Id="rId65" Type="http://schemas.openxmlformats.org/officeDocument/2006/relationships/slide" Target="slides/slide64.xml"/><Relationship Id="rId66" Type="http://schemas.openxmlformats.org/officeDocument/2006/relationships/slide" Target="slides/slide65.xml"/><Relationship Id="rId67" Type="http://schemas.openxmlformats.org/officeDocument/2006/relationships/slide" Target="slides/slide66.xml"/><Relationship Id="rId68" Type="http://schemas.openxmlformats.org/officeDocument/2006/relationships/slide" Target="slides/slide67.xml"/><Relationship Id="rId69" Type="http://schemas.openxmlformats.org/officeDocument/2006/relationships/slide" Target="slides/slide68.xml"/><Relationship Id="rId130" Type="http://schemas.openxmlformats.org/officeDocument/2006/relationships/slide" Target="slides/slide129.xml"/><Relationship Id="rId131" Type="http://schemas.openxmlformats.org/officeDocument/2006/relationships/slide" Target="slides/slide130.xml"/><Relationship Id="rId132" Type="http://schemas.openxmlformats.org/officeDocument/2006/relationships/slide" Target="slides/slide131.xml"/><Relationship Id="rId133" Type="http://schemas.openxmlformats.org/officeDocument/2006/relationships/slide" Target="slides/slide132.xml"/><Relationship Id="rId134" Type="http://schemas.openxmlformats.org/officeDocument/2006/relationships/slide" Target="slides/slide133.xml"/><Relationship Id="rId135" Type="http://schemas.openxmlformats.org/officeDocument/2006/relationships/slide" Target="slides/slide134.xml"/><Relationship Id="rId136" Type="http://schemas.openxmlformats.org/officeDocument/2006/relationships/slide" Target="slides/slide135.xml"/><Relationship Id="rId137" Type="http://schemas.openxmlformats.org/officeDocument/2006/relationships/slide" Target="slides/slide136.xml"/><Relationship Id="rId138" Type="http://schemas.openxmlformats.org/officeDocument/2006/relationships/slide" Target="slides/slide137.xml"/><Relationship Id="rId139" Type="http://schemas.openxmlformats.org/officeDocument/2006/relationships/slide" Target="slides/slide138.xml"/><Relationship Id="rId170" Type="http://schemas.openxmlformats.org/officeDocument/2006/relationships/slide" Target="slides/slide169.xml"/><Relationship Id="rId171" Type="http://schemas.openxmlformats.org/officeDocument/2006/relationships/slide" Target="slides/slide170.xml"/><Relationship Id="rId172" Type="http://schemas.openxmlformats.org/officeDocument/2006/relationships/slide" Target="slides/slide171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slide" Target="slides/slide38.xml"/><Relationship Id="rId173" Type="http://schemas.openxmlformats.org/officeDocument/2006/relationships/slide" Target="slides/slide172.xml"/><Relationship Id="rId174" Type="http://schemas.openxmlformats.org/officeDocument/2006/relationships/slide" Target="slides/slide173.xml"/><Relationship Id="rId175" Type="http://schemas.openxmlformats.org/officeDocument/2006/relationships/slide" Target="slides/slide174.xml"/><Relationship Id="rId176" Type="http://schemas.openxmlformats.org/officeDocument/2006/relationships/slide" Target="slides/slide175.xml"/><Relationship Id="rId177" Type="http://schemas.openxmlformats.org/officeDocument/2006/relationships/slide" Target="slides/slide176.xml"/><Relationship Id="rId178" Type="http://schemas.openxmlformats.org/officeDocument/2006/relationships/slide" Target="slides/slide177.xml"/><Relationship Id="rId179" Type="http://schemas.openxmlformats.org/officeDocument/2006/relationships/slide" Target="slides/slide178.xml"/><Relationship Id="rId70" Type="http://schemas.openxmlformats.org/officeDocument/2006/relationships/slide" Target="slides/slide69.xml"/><Relationship Id="rId71" Type="http://schemas.openxmlformats.org/officeDocument/2006/relationships/slide" Target="slides/slide70.xml"/><Relationship Id="rId72" Type="http://schemas.openxmlformats.org/officeDocument/2006/relationships/slide" Target="slides/slide71.xml"/><Relationship Id="rId73" Type="http://schemas.openxmlformats.org/officeDocument/2006/relationships/slide" Target="slides/slide72.xml"/><Relationship Id="rId74" Type="http://schemas.openxmlformats.org/officeDocument/2006/relationships/slide" Target="slides/slide73.xml"/><Relationship Id="rId75" Type="http://schemas.openxmlformats.org/officeDocument/2006/relationships/slide" Target="slides/slide74.xml"/><Relationship Id="rId76" Type="http://schemas.openxmlformats.org/officeDocument/2006/relationships/slide" Target="slides/slide75.xml"/><Relationship Id="rId77" Type="http://schemas.openxmlformats.org/officeDocument/2006/relationships/slide" Target="slides/slide76.xml"/><Relationship Id="rId78" Type="http://schemas.openxmlformats.org/officeDocument/2006/relationships/slide" Target="slides/slide77.xml"/><Relationship Id="rId79" Type="http://schemas.openxmlformats.org/officeDocument/2006/relationships/slide" Target="slides/slide7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100" Type="http://schemas.openxmlformats.org/officeDocument/2006/relationships/slide" Target="slides/slide99.xml"/><Relationship Id="rId101" Type="http://schemas.openxmlformats.org/officeDocument/2006/relationships/slide" Target="slides/slide100.xml"/><Relationship Id="rId102" Type="http://schemas.openxmlformats.org/officeDocument/2006/relationships/slide" Target="slides/slide101.xml"/><Relationship Id="rId103" Type="http://schemas.openxmlformats.org/officeDocument/2006/relationships/slide" Target="slides/slide102.xml"/><Relationship Id="rId104" Type="http://schemas.openxmlformats.org/officeDocument/2006/relationships/slide" Target="slides/slide103.xml"/><Relationship Id="rId105" Type="http://schemas.openxmlformats.org/officeDocument/2006/relationships/slide" Target="slides/slide104.xml"/><Relationship Id="rId106" Type="http://schemas.openxmlformats.org/officeDocument/2006/relationships/slide" Target="slides/slide105.xml"/><Relationship Id="rId107" Type="http://schemas.openxmlformats.org/officeDocument/2006/relationships/slide" Target="slides/slide106.xml"/><Relationship Id="rId108" Type="http://schemas.openxmlformats.org/officeDocument/2006/relationships/slide" Target="slides/slide107.xml"/><Relationship Id="rId109" Type="http://schemas.openxmlformats.org/officeDocument/2006/relationships/slide" Target="slides/slide108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40" Type="http://schemas.openxmlformats.org/officeDocument/2006/relationships/slide" Target="slides/slide139.xml"/><Relationship Id="rId141" Type="http://schemas.openxmlformats.org/officeDocument/2006/relationships/slide" Target="slides/slide14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719A72-F4F2-4793-8A18-F519A27CB61B}" type="datetimeFigureOut">
              <a:rPr lang="en-US" smtClean="0"/>
              <a:t>7/21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B19C60-6001-4028-871B-FBC100C838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838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7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5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9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092672-C78E-2B43-A393-ABA453B5CF98}" type="slidenum">
              <a:rPr lang="en-US" smtClean="0"/>
              <a:pPr/>
              <a:t>37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B93875-D5FB-4532-BAFB-838F336645DB}" type="slidenum">
              <a:rPr lang="en-US" smtClean="0"/>
              <a:pPr/>
              <a:t>7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954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FBB520-D4BC-E44C-A897-637AF17D3B8E}" type="slidenum">
              <a:rPr lang="en-US" smtClean="0"/>
              <a:pPr/>
              <a:t>1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0310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FBB520-D4BC-E44C-A897-637AF17D3B8E}" type="slidenum">
              <a:rPr lang="en-US" smtClean="0"/>
              <a:pPr/>
              <a:t>1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81796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FBB520-D4BC-E44C-A897-637AF17D3B8E}" type="slidenum">
              <a:rPr lang="en-US" smtClean="0"/>
              <a:pPr/>
              <a:t>17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3507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858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47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319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71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286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205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47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036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37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246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577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7524E-4845-40E7-A706-A7C30EDA8C9C}" type="datetimeFigureOut">
              <a:rPr lang="en-US" smtClean="0"/>
              <a:t>7/2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3EE3F-37EB-4B74-84B0-A0A797FD1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720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1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emf"/><Relationship Id="rId3" Type="http://schemas.openxmlformats.org/officeDocument/2006/relationships/image" Target="../media/image18.emf"/></Relationships>
</file>

<file path=ppt/slides/_rels/slide10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0.emf"/><Relationship Id="rId3" Type="http://schemas.openxmlformats.org/officeDocument/2006/relationships/image" Target="../media/image198.emf"/></Relationships>
</file>

<file path=ppt/slides/_rels/slide10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9.emf"/><Relationship Id="rId3" Type="http://schemas.openxmlformats.org/officeDocument/2006/relationships/image" Target="../media/image200.emf"/></Relationships>
</file>

<file path=ppt/slides/_rels/slide10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1.emf"/><Relationship Id="rId3" Type="http://schemas.openxmlformats.org/officeDocument/2006/relationships/image" Target="../media/image202.emf"/></Relationships>
</file>

<file path=ppt/slides/_rels/slide10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3.emf"/><Relationship Id="rId3" Type="http://schemas.openxmlformats.org/officeDocument/2006/relationships/image" Target="../media/image204.emf"/></Relationships>
</file>

<file path=ppt/slides/_rels/slide10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5.emf"/><Relationship Id="rId3" Type="http://schemas.openxmlformats.org/officeDocument/2006/relationships/image" Target="../media/image206.emf"/></Relationships>
</file>

<file path=ppt/slides/_rels/slide10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7.emf"/><Relationship Id="rId3" Type="http://schemas.openxmlformats.org/officeDocument/2006/relationships/image" Target="../media/image208.emf"/></Relationships>
</file>

<file path=ppt/slides/_rels/slide10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9.emf"/><Relationship Id="rId3" Type="http://schemas.openxmlformats.org/officeDocument/2006/relationships/image" Target="../media/image210.emf"/></Relationships>
</file>

<file path=ppt/slides/_rels/slide10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1.emf"/><Relationship Id="rId3" Type="http://schemas.openxmlformats.org/officeDocument/2006/relationships/image" Target="../media/image212.emf"/></Relationships>
</file>

<file path=ppt/slides/_rels/slide10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3.emf"/><Relationship Id="rId3" Type="http://schemas.openxmlformats.org/officeDocument/2006/relationships/image" Target="../media/image214.emf"/></Relationships>
</file>

<file path=ppt/slides/_rels/slide10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5.emf"/><Relationship Id="rId3" Type="http://schemas.openxmlformats.org/officeDocument/2006/relationships/image" Target="../media/image216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emf"/><Relationship Id="rId3" Type="http://schemas.openxmlformats.org/officeDocument/2006/relationships/image" Target="../media/image20.emf"/></Relationships>
</file>

<file path=ppt/slides/_rels/slide1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7.emf"/><Relationship Id="rId3" Type="http://schemas.openxmlformats.org/officeDocument/2006/relationships/image" Target="../media/image218.emf"/></Relationships>
</file>

<file path=ppt/slides/_rels/slide1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9.emf"/><Relationship Id="rId3" Type="http://schemas.openxmlformats.org/officeDocument/2006/relationships/image" Target="../media/image220.emf"/></Relationships>
</file>

<file path=ppt/slides/_rels/slide1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1.emf"/><Relationship Id="rId3" Type="http://schemas.openxmlformats.org/officeDocument/2006/relationships/image" Target="../media/image222.emf"/></Relationships>
</file>

<file path=ppt/slides/_rels/slide1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3.emf"/><Relationship Id="rId3" Type="http://schemas.openxmlformats.org/officeDocument/2006/relationships/image" Target="../media/image224.emf"/></Relationships>
</file>

<file path=ppt/slides/_rels/slide1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5.emf"/><Relationship Id="rId3" Type="http://schemas.openxmlformats.org/officeDocument/2006/relationships/image" Target="../media/image226.emf"/></Relationships>
</file>

<file path=ppt/slides/_rels/slide1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7.emf"/><Relationship Id="rId3" Type="http://schemas.openxmlformats.org/officeDocument/2006/relationships/image" Target="../media/image228.emf"/></Relationships>
</file>

<file path=ppt/slides/_rels/slide1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9.emf"/><Relationship Id="rId3" Type="http://schemas.openxmlformats.org/officeDocument/2006/relationships/image" Target="../media/image230.emf"/></Relationships>
</file>

<file path=ppt/slides/_rels/slide1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1.emf"/><Relationship Id="rId3" Type="http://schemas.openxmlformats.org/officeDocument/2006/relationships/image" Target="../media/image232.emf"/></Relationships>
</file>

<file path=ppt/slides/_rels/slide1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3.emf"/><Relationship Id="rId3" Type="http://schemas.openxmlformats.org/officeDocument/2006/relationships/image" Target="../media/image234.emf"/></Relationships>
</file>

<file path=ppt/slides/_rels/slide1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5.emf"/><Relationship Id="rId4" Type="http://schemas.openxmlformats.org/officeDocument/2006/relationships/image" Target="../media/image236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emf"/><Relationship Id="rId3" Type="http://schemas.openxmlformats.org/officeDocument/2006/relationships/image" Target="../media/image22.emf"/></Relationships>
</file>

<file path=ppt/slides/_rels/slide1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7.emf"/><Relationship Id="rId3" Type="http://schemas.openxmlformats.org/officeDocument/2006/relationships/image" Target="../media/image238.emf"/></Relationships>
</file>

<file path=ppt/slides/_rels/slide1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9.emf"/><Relationship Id="rId3" Type="http://schemas.openxmlformats.org/officeDocument/2006/relationships/image" Target="../media/image240.emf"/></Relationships>
</file>

<file path=ppt/slides/_rels/slide1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1.emf"/><Relationship Id="rId3" Type="http://schemas.openxmlformats.org/officeDocument/2006/relationships/image" Target="../media/image242.emf"/></Relationships>
</file>

<file path=ppt/slides/_rels/slide1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3.emf"/><Relationship Id="rId3" Type="http://schemas.openxmlformats.org/officeDocument/2006/relationships/image" Target="../media/image244.emf"/></Relationships>
</file>

<file path=ppt/slides/_rels/slide1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5.emf"/><Relationship Id="rId3" Type="http://schemas.openxmlformats.org/officeDocument/2006/relationships/image" Target="../media/image246.emf"/></Relationships>
</file>

<file path=ppt/slides/_rels/slide1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7.emf"/><Relationship Id="rId4" Type="http://schemas.openxmlformats.org/officeDocument/2006/relationships/image" Target="../media/image248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1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9.emf"/><Relationship Id="rId3" Type="http://schemas.openxmlformats.org/officeDocument/2006/relationships/image" Target="../media/image250.emf"/></Relationships>
</file>

<file path=ppt/slides/_rels/slide1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1.emf"/><Relationship Id="rId3" Type="http://schemas.openxmlformats.org/officeDocument/2006/relationships/image" Target="../media/image252.emf"/></Relationships>
</file>

<file path=ppt/slides/_rels/slide1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3.emf"/><Relationship Id="rId3" Type="http://schemas.openxmlformats.org/officeDocument/2006/relationships/image" Target="../media/image254.emf"/></Relationships>
</file>

<file path=ppt/slides/_rels/slide1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5.emf"/><Relationship Id="rId3" Type="http://schemas.openxmlformats.org/officeDocument/2006/relationships/image" Target="../media/image256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emf"/><Relationship Id="rId3" Type="http://schemas.openxmlformats.org/officeDocument/2006/relationships/image" Target="../media/image24.emf"/></Relationships>
</file>

<file path=ppt/slides/_rels/slide1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7.emf"/><Relationship Id="rId3" Type="http://schemas.openxmlformats.org/officeDocument/2006/relationships/image" Target="../media/image258.emf"/></Relationships>
</file>

<file path=ppt/slides/_rels/slide1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9.emf"/><Relationship Id="rId3" Type="http://schemas.openxmlformats.org/officeDocument/2006/relationships/image" Target="../media/image260.emf"/></Relationships>
</file>

<file path=ppt/slides/_rels/slide1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1.emf"/><Relationship Id="rId3" Type="http://schemas.openxmlformats.org/officeDocument/2006/relationships/image" Target="../media/image262.emf"/></Relationships>
</file>

<file path=ppt/slides/_rels/slide1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3.emf"/><Relationship Id="rId3" Type="http://schemas.openxmlformats.org/officeDocument/2006/relationships/image" Target="../media/image264.emf"/></Relationships>
</file>

<file path=ppt/slides/_rels/slide1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5.emf"/><Relationship Id="rId3" Type="http://schemas.openxmlformats.org/officeDocument/2006/relationships/image" Target="../media/image266.emf"/></Relationships>
</file>

<file path=ppt/slides/_rels/slide1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7.emf"/><Relationship Id="rId3" Type="http://schemas.openxmlformats.org/officeDocument/2006/relationships/image" Target="../media/image268.emf"/></Relationships>
</file>

<file path=ppt/slides/_rels/slide1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9.emf"/><Relationship Id="rId3" Type="http://schemas.openxmlformats.org/officeDocument/2006/relationships/image" Target="../media/image270.emf"/></Relationships>
</file>

<file path=ppt/slides/_rels/slide1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1.emf"/><Relationship Id="rId3" Type="http://schemas.openxmlformats.org/officeDocument/2006/relationships/image" Target="../media/image272.emf"/></Relationships>
</file>

<file path=ppt/slides/_rels/slide1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3.emf"/><Relationship Id="rId3" Type="http://schemas.openxmlformats.org/officeDocument/2006/relationships/image" Target="../media/image274.emf"/></Relationships>
</file>

<file path=ppt/slides/_rels/slide1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5.emf"/><Relationship Id="rId3" Type="http://schemas.openxmlformats.org/officeDocument/2006/relationships/image" Target="../media/image276.e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5.emf"/><Relationship Id="rId3" Type="http://schemas.openxmlformats.org/officeDocument/2006/relationships/image" Target="../media/image26.emf"/></Relationships>
</file>

<file path=ppt/slides/_rels/slide1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7.emf"/><Relationship Id="rId3" Type="http://schemas.openxmlformats.org/officeDocument/2006/relationships/image" Target="../media/image278.emf"/></Relationships>
</file>

<file path=ppt/slides/_rels/slide1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9.emf"/><Relationship Id="rId3" Type="http://schemas.openxmlformats.org/officeDocument/2006/relationships/image" Target="../media/image280.emf"/></Relationships>
</file>

<file path=ppt/slides/_rels/slide1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1.emf"/><Relationship Id="rId3" Type="http://schemas.openxmlformats.org/officeDocument/2006/relationships/image" Target="../media/image282.emf"/></Relationships>
</file>

<file path=ppt/slides/_rels/slide1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3.emf"/><Relationship Id="rId3" Type="http://schemas.openxmlformats.org/officeDocument/2006/relationships/image" Target="../media/image284.emf"/></Relationships>
</file>

<file path=ppt/slides/_rels/slide1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5.emf"/><Relationship Id="rId3" Type="http://schemas.openxmlformats.org/officeDocument/2006/relationships/image" Target="../media/image286.emf"/></Relationships>
</file>

<file path=ppt/slides/_rels/slide1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7.emf"/><Relationship Id="rId3" Type="http://schemas.openxmlformats.org/officeDocument/2006/relationships/image" Target="../media/image288.emf"/></Relationships>
</file>

<file path=ppt/slides/_rels/slide1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9.emf"/><Relationship Id="rId3" Type="http://schemas.openxmlformats.org/officeDocument/2006/relationships/image" Target="../media/image290.emf"/></Relationships>
</file>

<file path=ppt/slides/_rels/slide1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1.emf"/><Relationship Id="rId3" Type="http://schemas.openxmlformats.org/officeDocument/2006/relationships/image" Target="../media/image292.emf"/></Relationships>
</file>

<file path=ppt/slides/_rels/slide1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3.emf"/><Relationship Id="rId3" Type="http://schemas.openxmlformats.org/officeDocument/2006/relationships/image" Target="../media/image294.emf"/></Relationships>
</file>

<file path=ppt/slides/_rels/slide1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5.emf"/><Relationship Id="rId3" Type="http://schemas.openxmlformats.org/officeDocument/2006/relationships/image" Target="../media/image296.em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.emf"/><Relationship Id="rId3" Type="http://schemas.openxmlformats.org/officeDocument/2006/relationships/image" Target="../media/image28.emf"/></Relationships>
</file>

<file path=ppt/slides/_rels/slide1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7.emf"/><Relationship Id="rId3" Type="http://schemas.openxmlformats.org/officeDocument/2006/relationships/image" Target="../media/image298.emf"/></Relationships>
</file>

<file path=ppt/slides/_rels/slide1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9.emf"/><Relationship Id="rId3" Type="http://schemas.openxmlformats.org/officeDocument/2006/relationships/image" Target="../media/image300.emf"/></Relationships>
</file>

<file path=ppt/slides/_rels/slide1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1.emf"/><Relationship Id="rId3" Type="http://schemas.openxmlformats.org/officeDocument/2006/relationships/image" Target="../media/image302.emf"/></Relationships>
</file>

<file path=ppt/slides/_rels/slide1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3.emf"/><Relationship Id="rId3" Type="http://schemas.openxmlformats.org/officeDocument/2006/relationships/image" Target="../media/image304.emf"/></Relationships>
</file>

<file path=ppt/slides/_rels/slide1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5.emf"/><Relationship Id="rId3" Type="http://schemas.openxmlformats.org/officeDocument/2006/relationships/image" Target="../media/image306.emf"/></Relationships>
</file>

<file path=ppt/slides/_rels/slide1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7.emf"/><Relationship Id="rId3" Type="http://schemas.openxmlformats.org/officeDocument/2006/relationships/image" Target="../media/image308.emf"/></Relationships>
</file>

<file path=ppt/slides/_rels/slide1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9.emf"/><Relationship Id="rId3" Type="http://schemas.openxmlformats.org/officeDocument/2006/relationships/image" Target="../media/image310.emf"/></Relationships>
</file>

<file path=ppt/slides/_rels/slide1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1.emf"/><Relationship Id="rId3" Type="http://schemas.openxmlformats.org/officeDocument/2006/relationships/image" Target="../media/image312.emf"/></Relationships>
</file>

<file path=ppt/slides/_rels/slide1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3.emf"/><Relationship Id="rId3" Type="http://schemas.openxmlformats.org/officeDocument/2006/relationships/image" Target="../media/image314.emf"/></Relationships>
</file>

<file path=ppt/slides/_rels/slide1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5.emf"/><Relationship Id="rId3" Type="http://schemas.openxmlformats.org/officeDocument/2006/relationships/image" Target="../media/image316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.emf"/><Relationship Id="rId3" Type="http://schemas.openxmlformats.org/officeDocument/2006/relationships/image" Target="../media/image30.emf"/></Relationships>
</file>

<file path=ppt/slides/_rels/slide1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7.emf"/><Relationship Id="rId3" Type="http://schemas.openxmlformats.org/officeDocument/2006/relationships/image" Target="../media/image318.emf"/></Relationships>
</file>

<file path=ppt/slides/_rels/slide1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9.emf"/><Relationship Id="rId3" Type="http://schemas.openxmlformats.org/officeDocument/2006/relationships/image" Target="../media/image320.emf"/></Relationships>
</file>

<file path=ppt/slides/_rels/slide1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1.emf"/><Relationship Id="rId3" Type="http://schemas.openxmlformats.org/officeDocument/2006/relationships/image" Target="../media/image322.emf"/></Relationships>
</file>

<file path=ppt/slides/_rels/slide1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3.emf"/><Relationship Id="rId3" Type="http://schemas.openxmlformats.org/officeDocument/2006/relationships/image" Target="../media/image324.emf"/></Relationships>
</file>

<file path=ppt/slides/_rels/slide1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5.emf"/><Relationship Id="rId3" Type="http://schemas.openxmlformats.org/officeDocument/2006/relationships/image" Target="../media/image326.emf"/></Relationships>
</file>

<file path=ppt/slides/_rels/slide1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7.emf"/><Relationship Id="rId3" Type="http://schemas.openxmlformats.org/officeDocument/2006/relationships/image" Target="../media/image328.emf"/></Relationships>
</file>

<file path=ppt/slides/_rels/slide1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9.emf"/><Relationship Id="rId3" Type="http://schemas.openxmlformats.org/officeDocument/2006/relationships/image" Target="../media/image330.emf"/></Relationships>
</file>

<file path=ppt/slides/_rels/slide1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1.emf"/><Relationship Id="rId3" Type="http://schemas.openxmlformats.org/officeDocument/2006/relationships/image" Target="../media/image332.emf"/></Relationships>
</file>

<file path=ppt/slides/_rels/slide1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3.emf"/><Relationship Id="rId3" Type="http://schemas.openxmlformats.org/officeDocument/2006/relationships/image" Target="../media/image334.emf"/></Relationships>
</file>

<file path=ppt/slides/_rels/slide1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5.emf"/><Relationship Id="rId3" Type="http://schemas.openxmlformats.org/officeDocument/2006/relationships/image" Target="../media/image336.em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emf"/><Relationship Id="rId3" Type="http://schemas.openxmlformats.org/officeDocument/2006/relationships/image" Target="../media/image32.emf"/></Relationships>
</file>

<file path=ppt/slides/_rels/slide1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7.emf"/><Relationship Id="rId3" Type="http://schemas.openxmlformats.org/officeDocument/2006/relationships/image" Target="../media/image338.emf"/></Relationships>
</file>

<file path=ppt/slides/_rels/slide1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9.emf"/><Relationship Id="rId3" Type="http://schemas.openxmlformats.org/officeDocument/2006/relationships/image" Target="../media/image340.emf"/></Relationships>
</file>

<file path=ppt/slides/_rels/slide1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41.emf"/><Relationship Id="rId3" Type="http://schemas.openxmlformats.org/officeDocument/2006/relationships/image" Target="../media/image342.emf"/></Relationships>
</file>

<file path=ppt/slides/_rels/slide1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43.emf"/><Relationship Id="rId3" Type="http://schemas.openxmlformats.org/officeDocument/2006/relationships/image" Target="../media/image344.emf"/></Relationships>
</file>

<file path=ppt/slides/_rels/slide1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45.emf"/><Relationship Id="rId3" Type="http://schemas.openxmlformats.org/officeDocument/2006/relationships/image" Target="../media/image346.emf"/></Relationships>
</file>

<file path=ppt/slides/_rels/slide1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47.emf"/><Relationship Id="rId3" Type="http://schemas.openxmlformats.org/officeDocument/2006/relationships/image" Target="../media/image348.emf"/></Relationships>
</file>

<file path=ppt/slides/_rels/slide17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9.emf"/><Relationship Id="rId4" Type="http://schemas.openxmlformats.org/officeDocument/2006/relationships/image" Target="../media/image350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1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1.emf"/><Relationship Id="rId3" Type="http://schemas.openxmlformats.org/officeDocument/2006/relationships/image" Target="../media/image352.emf"/></Relationships>
</file>

<file path=ppt/slides/_rels/slide1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3.emf"/><Relationship Id="rId3" Type="http://schemas.openxmlformats.org/officeDocument/2006/relationships/image" Target="../media/image354.emf"/></Relationships>
</file>

<file path=ppt/slides/_rels/slide1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5.emf"/><Relationship Id="rId3" Type="http://schemas.openxmlformats.org/officeDocument/2006/relationships/image" Target="../media/image356.emf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.emf"/><Relationship Id="rId3" Type="http://schemas.openxmlformats.org/officeDocument/2006/relationships/image" Target="../media/image34.emf"/></Relationships>
</file>

<file path=ppt/slides/_rels/slide1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7.emf"/><Relationship Id="rId3" Type="http://schemas.openxmlformats.org/officeDocument/2006/relationships/image" Target="../media/image358.emf"/></Relationships>
</file>

<file path=ppt/slides/_rels/slide1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9.emf"/><Relationship Id="rId3" Type="http://schemas.openxmlformats.org/officeDocument/2006/relationships/image" Target="../media/image360.emf"/></Relationships>
</file>

<file path=ppt/slides/_rels/slide1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61.emf"/><Relationship Id="rId3" Type="http://schemas.openxmlformats.org/officeDocument/2006/relationships/image" Target="../media/image362.emf"/></Relationships>
</file>

<file path=ppt/slides/_rels/slide1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63.emf"/><Relationship Id="rId3" Type="http://schemas.openxmlformats.org/officeDocument/2006/relationships/image" Target="../media/image364.emf"/></Relationships>
</file>

<file path=ppt/slides/_rels/slide1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65.emf"/><Relationship Id="rId3" Type="http://schemas.openxmlformats.org/officeDocument/2006/relationships/image" Target="../media/image366.e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5.emf"/><Relationship Id="rId3" Type="http://schemas.openxmlformats.org/officeDocument/2006/relationships/image" Target="../media/image36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emf"/><Relationship Id="rId3" Type="http://schemas.openxmlformats.org/officeDocument/2006/relationships/image" Target="../media/image38.emf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9.emf"/><Relationship Id="rId3" Type="http://schemas.openxmlformats.org/officeDocument/2006/relationships/image" Target="../media/image40.emf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1.emf"/><Relationship Id="rId3" Type="http://schemas.openxmlformats.org/officeDocument/2006/relationships/image" Target="../media/image42.emf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3.emf"/><Relationship Id="rId3" Type="http://schemas.openxmlformats.org/officeDocument/2006/relationships/image" Target="../media/image44.emf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5.emf"/><Relationship Id="rId3" Type="http://schemas.openxmlformats.org/officeDocument/2006/relationships/image" Target="../media/image46.emf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7.emf"/><Relationship Id="rId3" Type="http://schemas.openxmlformats.org/officeDocument/2006/relationships/image" Target="../media/image48.emf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9.emf"/><Relationship Id="rId3" Type="http://schemas.openxmlformats.org/officeDocument/2006/relationships/image" Target="../media/image50.emf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1.emf"/><Relationship Id="rId3" Type="http://schemas.openxmlformats.org/officeDocument/2006/relationships/image" Target="../media/image52.emf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3.emf"/><Relationship Id="rId3" Type="http://schemas.openxmlformats.org/officeDocument/2006/relationships/image" Target="../media/image54.emf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5.emf"/><Relationship Id="rId3" Type="http://schemas.openxmlformats.org/officeDocument/2006/relationships/image" Target="../media/image56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7.emf"/><Relationship Id="rId3" Type="http://schemas.openxmlformats.org/officeDocument/2006/relationships/image" Target="../media/image58.emf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9.emf"/><Relationship Id="rId3" Type="http://schemas.openxmlformats.org/officeDocument/2006/relationships/image" Target="../media/image60.emf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1.emf"/><Relationship Id="rId3" Type="http://schemas.openxmlformats.org/officeDocument/2006/relationships/image" Target="../media/image62.emf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3.emf"/><Relationship Id="rId3" Type="http://schemas.openxmlformats.org/officeDocument/2006/relationships/image" Target="../media/image64.emf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5.emf"/><Relationship Id="rId3" Type="http://schemas.openxmlformats.org/officeDocument/2006/relationships/image" Target="../media/image66.emf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7.emf"/><Relationship Id="rId3" Type="http://schemas.openxmlformats.org/officeDocument/2006/relationships/image" Target="../media/image68.emf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9.emf"/><Relationship Id="rId3" Type="http://schemas.openxmlformats.org/officeDocument/2006/relationships/image" Target="../media/image70.emf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emf"/><Relationship Id="rId4" Type="http://schemas.openxmlformats.org/officeDocument/2006/relationships/image" Target="../media/image72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3.emf"/><Relationship Id="rId3" Type="http://schemas.openxmlformats.org/officeDocument/2006/relationships/image" Target="../media/image74.emf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5.emf"/><Relationship Id="rId3" Type="http://schemas.openxmlformats.org/officeDocument/2006/relationships/image" Target="../media/image76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Relationship Id="rId3" Type="http://schemas.openxmlformats.org/officeDocument/2006/relationships/image" Target="../media/image6.emf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7.emf"/><Relationship Id="rId3" Type="http://schemas.openxmlformats.org/officeDocument/2006/relationships/image" Target="../media/image78.emf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9.emf"/><Relationship Id="rId3" Type="http://schemas.openxmlformats.org/officeDocument/2006/relationships/image" Target="../media/image80.emf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1.emf"/><Relationship Id="rId3" Type="http://schemas.openxmlformats.org/officeDocument/2006/relationships/image" Target="../media/image82.emf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3.emf"/><Relationship Id="rId3" Type="http://schemas.openxmlformats.org/officeDocument/2006/relationships/image" Target="../media/image84.emf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5.emf"/><Relationship Id="rId3" Type="http://schemas.openxmlformats.org/officeDocument/2006/relationships/image" Target="../media/image86.emf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7.emf"/><Relationship Id="rId3" Type="http://schemas.openxmlformats.org/officeDocument/2006/relationships/image" Target="../media/image88.emf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9.emf"/><Relationship Id="rId3" Type="http://schemas.openxmlformats.org/officeDocument/2006/relationships/image" Target="../media/image90.emf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1.emf"/><Relationship Id="rId3" Type="http://schemas.openxmlformats.org/officeDocument/2006/relationships/image" Target="../media/image92.emf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3.emf"/><Relationship Id="rId3" Type="http://schemas.openxmlformats.org/officeDocument/2006/relationships/image" Target="../media/image94.emf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5.emf"/><Relationship Id="rId3" Type="http://schemas.openxmlformats.org/officeDocument/2006/relationships/image" Target="../media/image96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emf"/><Relationship Id="rId3" Type="http://schemas.openxmlformats.org/officeDocument/2006/relationships/image" Target="../media/image8.emf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7.emf"/><Relationship Id="rId3" Type="http://schemas.openxmlformats.org/officeDocument/2006/relationships/image" Target="../media/image98.emf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9.emf"/><Relationship Id="rId3" Type="http://schemas.openxmlformats.org/officeDocument/2006/relationships/image" Target="../media/image100.emf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1.emf"/><Relationship Id="rId3" Type="http://schemas.openxmlformats.org/officeDocument/2006/relationships/image" Target="../media/image102.emf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3.emf"/><Relationship Id="rId3" Type="http://schemas.openxmlformats.org/officeDocument/2006/relationships/image" Target="../media/image104.emf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5.emf"/><Relationship Id="rId3" Type="http://schemas.openxmlformats.org/officeDocument/2006/relationships/image" Target="../media/image106.emf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7.emf"/><Relationship Id="rId3" Type="http://schemas.openxmlformats.org/officeDocument/2006/relationships/image" Target="../media/image108.emf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9.emf"/><Relationship Id="rId3" Type="http://schemas.openxmlformats.org/officeDocument/2006/relationships/image" Target="../media/image110.emf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1.emf"/><Relationship Id="rId3" Type="http://schemas.openxmlformats.org/officeDocument/2006/relationships/image" Target="../media/image112.emf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3.emf"/><Relationship Id="rId3" Type="http://schemas.openxmlformats.org/officeDocument/2006/relationships/image" Target="../media/image114.emf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5.emf"/><Relationship Id="rId3" Type="http://schemas.openxmlformats.org/officeDocument/2006/relationships/image" Target="../media/image116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Relationship Id="rId3" Type="http://schemas.openxmlformats.org/officeDocument/2006/relationships/image" Target="../media/image10.emf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7.emf"/><Relationship Id="rId3" Type="http://schemas.openxmlformats.org/officeDocument/2006/relationships/image" Target="../media/image118.png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9.emf"/><Relationship Id="rId3" Type="http://schemas.openxmlformats.org/officeDocument/2006/relationships/image" Target="../media/image120.emf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1.emf"/><Relationship Id="rId3" Type="http://schemas.openxmlformats.org/officeDocument/2006/relationships/image" Target="../media/image122.emf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3.emf"/><Relationship Id="rId3" Type="http://schemas.openxmlformats.org/officeDocument/2006/relationships/image" Target="../media/image124.emf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5.emf"/><Relationship Id="rId3" Type="http://schemas.openxmlformats.org/officeDocument/2006/relationships/image" Target="../media/image126.emf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7.emf"/><Relationship Id="rId3" Type="http://schemas.openxmlformats.org/officeDocument/2006/relationships/image" Target="../media/image128.emf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9.emf"/><Relationship Id="rId3" Type="http://schemas.openxmlformats.org/officeDocument/2006/relationships/image" Target="../media/image130.emf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1.emf"/><Relationship Id="rId3" Type="http://schemas.openxmlformats.org/officeDocument/2006/relationships/image" Target="../media/image132.emf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3.emf"/><Relationship Id="rId3" Type="http://schemas.openxmlformats.org/officeDocument/2006/relationships/image" Target="../media/image134.emf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5.emf"/><Relationship Id="rId3" Type="http://schemas.openxmlformats.org/officeDocument/2006/relationships/image" Target="../media/image136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emf"/><Relationship Id="rId3" Type="http://schemas.openxmlformats.org/officeDocument/2006/relationships/image" Target="../media/image12.emf"/></Relationships>
</file>

<file path=ppt/slides/_rels/slide7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8.emf"/><Relationship Id="rId4" Type="http://schemas.openxmlformats.org/officeDocument/2006/relationships/image" Target="../media/image139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7.emf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0.emf"/><Relationship Id="rId3" Type="http://schemas.openxmlformats.org/officeDocument/2006/relationships/image" Target="../media/image141.emf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2.emf"/><Relationship Id="rId3" Type="http://schemas.openxmlformats.org/officeDocument/2006/relationships/image" Target="../media/image143.emf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4.emf"/><Relationship Id="rId3" Type="http://schemas.openxmlformats.org/officeDocument/2006/relationships/image" Target="../media/image145.emf"/></Relationships>
</file>

<file path=ppt/slides/_rels/slide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6.emf"/><Relationship Id="rId3" Type="http://schemas.openxmlformats.org/officeDocument/2006/relationships/image" Target="../media/image147.emf"/></Relationships>
</file>

<file path=ppt/slides/_rels/slide7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8.emf"/><Relationship Id="rId4" Type="http://schemas.openxmlformats.org/officeDocument/2006/relationships/image" Target="../media/image149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0.emf"/><Relationship Id="rId3" Type="http://schemas.openxmlformats.org/officeDocument/2006/relationships/image" Target="../media/image151.emf"/></Relationships>
</file>

<file path=ppt/slides/_rels/slide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2.emf"/><Relationship Id="rId3" Type="http://schemas.openxmlformats.org/officeDocument/2006/relationships/image" Target="../media/image153.emf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4.emf"/><Relationship Id="rId3" Type="http://schemas.openxmlformats.org/officeDocument/2006/relationships/image" Target="../media/image155.emf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6.emf"/><Relationship Id="rId3" Type="http://schemas.openxmlformats.org/officeDocument/2006/relationships/image" Target="../media/image15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emf"/><Relationship Id="rId3" Type="http://schemas.openxmlformats.org/officeDocument/2006/relationships/image" Target="../media/image14.emf"/></Relationships>
</file>

<file path=ppt/slides/_rels/slide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8.emf"/><Relationship Id="rId3" Type="http://schemas.openxmlformats.org/officeDocument/2006/relationships/image" Target="../media/image159.emf"/></Relationships>
</file>

<file path=ppt/slides/_rels/slide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0.emf"/><Relationship Id="rId3" Type="http://schemas.openxmlformats.org/officeDocument/2006/relationships/image" Target="../media/image161.emf"/></Relationships>
</file>

<file path=ppt/slides/_rels/slide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2.emf"/><Relationship Id="rId3" Type="http://schemas.openxmlformats.org/officeDocument/2006/relationships/image" Target="../media/image163.emf"/></Relationships>
</file>

<file path=ppt/slides/_rels/slide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4.emf"/><Relationship Id="rId3" Type="http://schemas.openxmlformats.org/officeDocument/2006/relationships/image" Target="../media/image165.emf"/></Relationships>
</file>

<file path=ppt/slides/_rels/slide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6.emf"/><Relationship Id="rId3" Type="http://schemas.openxmlformats.org/officeDocument/2006/relationships/image" Target="../media/image167.emf"/></Relationships>
</file>

<file path=ppt/slides/_rels/slide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8.emf"/><Relationship Id="rId3" Type="http://schemas.openxmlformats.org/officeDocument/2006/relationships/image" Target="../media/image169.emf"/></Relationships>
</file>

<file path=ppt/slides/_rels/slide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0.emf"/><Relationship Id="rId3" Type="http://schemas.openxmlformats.org/officeDocument/2006/relationships/image" Target="../media/image171.emf"/></Relationships>
</file>

<file path=ppt/slides/_rels/slide8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2.emf"/><Relationship Id="rId3" Type="http://schemas.openxmlformats.org/officeDocument/2006/relationships/image" Target="../media/image173.emf"/></Relationships>
</file>

<file path=ppt/slides/_rels/slide8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4.emf"/><Relationship Id="rId3" Type="http://schemas.openxmlformats.org/officeDocument/2006/relationships/image" Target="../media/image175.emf"/></Relationships>
</file>

<file path=ppt/slides/_rels/slide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6.emf"/><Relationship Id="rId3" Type="http://schemas.openxmlformats.org/officeDocument/2006/relationships/image" Target="../media/image177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emf"/><Relationship Id="rId3" Type="http://schemas.openxmlformats.org/officeDocument/2006/relationships/image" Target="../media/image16.emf"/></Relationships>
</file>

<file path=ppt/slides/_rels/slide9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8.emf"/><Relationship Id="rId3" Type="http://schemas.openxmlformats.org/officeDocument/2006/relationships/image" Target="../media/image179.emf"/></Relationships>
</file>

<file path=ppt/slides/_rels/slide9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0.emf"/><Relationship Id="rId3" Type="http://schemas.openxmlformats.org/officeDocument/2006/relationships/image" Target="../media/image181.emf"/></Relationships>
</file>

<file path=ppt/slides/_rels/slide9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2.emf"/><Relationship Id="rId3" Type="http://schemas.openxmlformats.org/officeDocument/2006/relationships/image" Target="../media/image183.emf"/></Relationships>
</file>

<file path=ppt/slides/_rels/slide9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4.emf"/><Relationship Id="rId3" Type="http://schemas.openxmlformats.org/officeDocument/2006/relationships/image" Target="../media/image185.emf"/></Relationships>
</file>

<file path=ppt/slides/_rels/slide9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6.emf"/><Relationship Id="rId3" Type="http://schemas.openxmlformats.org/officeDocument/2006/relationships/image" Target="../media/image187.emf"/></Relationships>
</file>

<file path=ppt/slides/_rels/slide9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8.emf"/><Relationship Id="rId3" Type="http://schemas.openxmlformats.org/officeDocument/2006/relationships/image" Target="../media/image189.emf"/></Relationships>
</file>

<file path=ppt/slides/_rels/slide9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0.emf"/><Relationship Id="rId3" Type="http://schemas.openxmlformats.org/officeDocument/2006/relationships/image" Target="../media/image191.emf"/></Relationships>
</file>

<file path=ppt/slides/_rels/slide9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2.emf"/><Relationship Id="rId3" Type="http://schemas.openxmlformats.org/officeDocument/2006/relationships/image" Target="../media/image193.emf"/></Relationships>
</file>

<file path=ppt/slides/_rels/slide9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4.emf"/><Relationship Id="rId3" Type="http://schemas.openxmlformats.org/officeDocument/2006/relationships/image" Target="../media/image195.emf"/></Relationships>
</file>

<file path=ppt/slides/_rels/slide9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6.emf"/><Relationship Id="rId3" Type="http://schemas.openxmlformats.org/officeDocument/2006/relationships/image" Target="../media/image19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981200"/>
            <a:ext cx="9144000" cy="1200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smtClean="0">
                <a:latin typeface="Arial"/>
                <a:cs typeface="Arial"/>
              </a:rPr>
              <a:t>Figure </a:t>
            </a:r>
            <a:r>
              <a:rPr lang="en-US" sz="2400" dirty="0" smtClean="0">
                <a:latin typeface="Arial"/>
                <a:cs typeface="Arial"/>
              </a:rPr>
              <a:t>S2</a:t>
            </a:r>
          </a:p>
          <a:p>
            <a:pPr algn="ctr"/>
            <a:endParaRPr lang="en-US" sz="2400" dirty="0">
              <a:latin typeface="Arial"/>
              <a:cs typeface="Arial"/>
            </a:endParaRPr>
          </a:p>
          <a:p>
            <a:pPr algn="ctr"/>
            <a:r>
              <a:rPr lang="en-US" sz="2400" dirty="0" smtClean="0">
                <a:latin typeface="Arial"/>
                <a:cs typeface="Arial"/>
              </a:rPr>
              <a:t>MSMS Spectra 1-156 </a:t>
            </a:r>
            <a:endParaRPr lang="en-US" sz="2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271837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ACT_HUMAN</a:t>
            </a:r>
            <a:r>
              <a:rPr lang="pt-BR" dirty="0">
                <a:latin typeface="Arial"/>
                <a:cs typeface="Arial"/>
              </a:rPr>
              <a:t>@271: YTG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ALFILPDQDK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52.858, Precursor m/z 877.44 charge 2+, delta(ppm) -4.8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4412" y="1772010"/>
            <a:ext cx="3454556" cy="29523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215547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KLK11_HUMAN</a:t>
            </a:r>
            <a:r>
              <a:rPr lang="pt-BR" dirty="0">
                <a:latin typeface="Arial"/>
                <a:cs typeface="Arial"/>
              </a:rPr>
              <a:t>@131: TATESFPHPGF</a:t>
            </a:r>
            <a:r>
              <a:rPr lang="pt-BR" u="sng" dirty="0">
                <a:latin typeface="Arial"/>
                <a:cs typeface="Arial"/>
              </a:rPr>
              <a:t>NNS</a:t>
            </a:r>
            <a:r>
              <a:rPr lang="pt-BR" dirty="0">
                <a:latin typeface="Arial"/>
                <a:cs typeface="Arial"/>
              </a:rPr>
              <a:t>LPNK_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957.918, Precursor m/z 979.97 charge 2+, delta(ppm) -</a:t>
            </a:r>
            <a:r>
              <a:rPr lang="pt-BR" dirty="0" smtClean="0">
                <a:latin typeface="Arial"/>
                <a:cs typeface="Arial"/>
              </a:rPr>
              <a:t>4.3</a:t>
            </a:r>
            <a:endParaRPr lang="en-US" dirty="0"/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1181101"/>
            <a:ext cx="3176587" cy="2753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103559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KLK11_HUMAN</a:t>
            </a:r>
            <a:r>
              <a:rPr lang="pt-BR" dirty="0">
                <a:latin typeface="Arial"/>
                <a:cs typeface="Arial"/>
              </a:rPr>
              <a:t>@197: CA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IIEHQK_Carbamidomethyl(C)@1; 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26.661, Precursor m/z 664.33 charge 2+, delta(ppm) </a:t>
            </a:r>
            <a:r>
              <a:rPr lang="pt-BR" dirty="0" smtClean="0">
                <a:latin typeface="Arial"/>
                <a:cs typeface="Arial"/>
              </a:rPr>
              <a:t>11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9600" y="1943101"/>
            <a:ext cx="3553948" cy="156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53898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8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KNG1_HUMAN@294: LNAEN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FYF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32.67, Precursor m/z 716.84 charge 2+, delta(ppm) -</a:t>
            </a:r>
            <a:r>
              <a:rPr lang="pt-BR" dirty="0" smtClean="0">
                <a:latin typeface="Arial"/>
                <a:cs typeface="Arial"/>
              </a:rPr>
              <a:t>1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55786"/>
            <a:ext cx="8229600" cy="42147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2057400"/>
            <a:ext cx="3267075" cy="2514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4591270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AMA4_HUMAN</a:t>
            </a:r>
            <a:r>
              <a:rPr lang="pt-BR" dirty="0">
                <a:latin typeface="Arial"/>
                <a:cs typeface="Arial"/>
              </a:rPr>
              <a:t>@810: RPAS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ASIQR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85.67, Precursor m/z 643.84 charge 2+, delta(ppm) </a:t>
            </a:r>
            <a:r>
              <a:rPr lang="pt-BR" dirty="0" smtClean="0">
                <a:latin typeface="Arial"/>
                <a:cs typeface="Arial"/>
              </a:rPr>
              <a:t>3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0" y="1981200"/>
            <a:ext cx="2838450" cy="1703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150663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G3BP_HUMAN</a:t>
            </a:r>
            <a:r>
              <a:rPr lang="pt-BR" dirty="0">
                <a:latin typeface="Arial"/>
                <a:cs typeface="Arial"/>
              </a:rPr>
              <a:t>@69: ALGFE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QALGR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47.68, Precursor m/z 674.85 charge 2+, delta(ppm) -</a:t>
            </a:r>
            <a:r>
              <a:rPr lang="pt-BR" dirty="0" smtClean="0">
                <a:latin typeface="Arial"/>
                <a:cs typeface="Arial"/>
              </a:rPr>
              <a:t>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43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4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1981200"/>
            <a:ext cx="2838450" cy="2138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078479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G3BP_HUMAN</a:t>
            </a:r>
            <a:r>
              <a:rPr lang="pt-BR" dirty="0">
                <a:latin typeface="Arial"/>
                <a:cs typeface="Arial"/>
              </a:rPr>
              <a:t>@125: DAGVVCT</a:t>
            </a:r>
            <a:r>
              <a:rPr lang="pt-BR" u="sng" dirty="0">
                <a:latin typeface="Arial"/>
                <a:cs typeface="Arial"/>
              </a:rPr>
              <a:t>NET</a:t>
            </a:r>
            <a:r>
              <a:rPr lang="pt-BR" dirty="0">
                <a:latin typeface="Arial"/>
                <a:cs typeface="Arial"/>
              </a:rPr>
              <a:t>R_Carbamidomethyl(C)@6; 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21.53, Precursor m/z 611.77 charge 2+, delta(ppm) </a:t>
            </a:r>
            <a:r>
              <a:rPr lang="pt-BR" dirty="0" smtClean="0">
                <a:latin typeface="Arial"/>
                <a:cs typeface="Arial"/>
              </a:rPr>
              <a:t>3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1225" y="2133600"/>
            <a:ext cx="3273725" cy="1885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998281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G3BP_HUMAN</a:t>
            </a:r>
            <a:r>
              <a:rPr lang="pt-BR" dirty="0">
                <a:latin typeface="Arial"/>
                <a:cs typeface="Arial"/>
              </a:rPr>
              <a:t>@192: EPGS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MSVDAECVPMVR_Deamidated(N)@5; Oxidation(M)@8; Carbamidomethyl(C)@14; Oxidation(M)@</a:t>
            </a:r>
            <a:r>
              <a:rPr lang="pt-BR" dirty="0" smtClean="0">
                <a:latin typeface="Arial"/>
                <a:cs typeface="Arial"/>
              </a:rPr>
              <a:t>1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109.9, Precursor m/z 1055.96 charge 2+, delta(ppm) -</a:t>
            </a:r>
            <a:r>
              <a:rPr lang="pt-BR" dirty="0" smtClean="0">
                <a:latin typeface="Arial"/>
                <a:cs typeface="Arial"/>
              </a:rPr>
              <a:t>2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81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2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1676400"/>
            <a:ext cx="2543175" cy="27340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419961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G3BP_HUMAN</a:t>
            </a:r>
            <a:r>
              <a:rPr lang="pt-BR" dirty="0">
                <a:latin typeface="Arial"/>
                <a:cs typeface="Arial"/>
              </a:rPr>
              <a:t>@398: GL</a:t>
            </a:r>
            <a:r>
              <a:rPr lang="pt-BR" u="sng" dirty="0">
                <a:latin typeface="Arial"/>
                <a:cs typeface="Arial"/>
              </a:rPr>
              <a:t>NLT</a:t>
            </a:r>
            <a:r>
              <a:rPr lang="pt-BR" dirty="0">
                <a:latin typeface="Arial"/>
                <a:cs typeface="Arial"/>
              </a:rPr>
              <a:t>EDTYKPR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06.7, Precursor m/z 704.36 charge 2+, delta(ppm) -</a:t>
            </a:r>
            <a:r>
              <a:rPr lang="pt-BR" dirty="0" smtClean="0">
                <a:latin typeface="Arial"/>
                <a:cs typeface="Arial"/>
              </a:rPr>
              <a:t>3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12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632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8751" y="2185989"/>
            <a:ext cx="2609850" cy="15659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677709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9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G3BP_HUMAN</a:t>
            </a:r>
            <a:r>
              <a:rPr lang="pt-BR" dirty="0">
                <a:latin typeface="Arial"/>
                <a:cs typeface="Arial"/>
              </a:rPr>
              <a:t>@551: AAIPSALDT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K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74.636, Precursor m/z 638.33 charge 2+, delta(ppm) -</a:t>
            </a:r>
            <a:r>
              <a:rPr lang="pt-BR" dirty="0" smtClean="0">
                <a:latin typeface="Arial"/>
                <a:cs typeface="Arial"/>
              </a:rPr>
              <a:t>7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681163"/>
            <a:ext cx="2775397" cy="2052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33677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9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LG3BP_HUMAN</a:t>
            </a:r>
            <a:r>
              <a:rPr lang="pt-BR" dirty="0">
                <a:latin typeface="Arial"/>
                <a:cs typeface="Arial"/>
              </a:rPr>
              <a:t>@580: TVIRPFYLT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GVD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68.84, Precursor m/z 835.42 charge 2+, delta(ppm) </a:t>
            </a:r>
            <a:r>
              <a:rPr lang="pt-BR" dirty="0" smtClean="0">
                <a:latin typeface="Arial"/>
                <a:cs typeface="Arial"/>
              </a:rPr>
              <a:t>8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3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0" y="1676400"/>
            <a:ext cx="2897780" cy="21383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28183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GAL_HUMAN</a:t>
            </a:r>
            <a:r>
              <a:rPr lang="pt-BR" dirty="0">
                <a:latin typeface="Arial"/>
                <a:cs typeface="Arial"/>
              </a:rPr>
              <a:t>@139: LGIYADVG</a:t>
            </a:r>
            <a:r>
              <a:rPr lang="pt-BR" u="sng" dirty="0">
                <a:latin typeface="Arial"/>
                <a:cs typeface="Arial"/>
              </a:rPr>
              <a:t>NK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049.54, Precursor m/z 525.78 charge 2+, delta(ppm) -5.1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1981200"/>
            <a:ext cx="2847975" cy="1687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626804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9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145: AQGLVLEAS</a:t>
            </a:r>
            <a:r>
              <a:rPr lang="pt-BR" u="sng" dirty="0">
                <a:latin typeface="Arial"/>
                <a:cs typeface="Arial"/>
              </a:rPr>
              <a:t>NGS</a:t>
            </a:r>
            <a:r>
              <a:rPr lang="pt-BR" dirty="0">
                <a:latin typeface="Arial"/>
                <a:cs typeface="Arial"/>
              </a:rPr>
              <a:t>VLINGQR_Deamidated(N)@10; Deamidated(N)@</a:t>
            </a:r>
            <a:r>
              <a:rPr lang="pt-BR" dirty="0" smtClean="0">
                <a:latin typeface="Arial"/>
                <a:cs typeface="Arial"/>
              </a:rPr>
              <a:t>1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927.002, Precursor m/z 964.51 charge 2+, delta(ppm) -</a:t>
            </a:r>
            <a:r>
              <a:rPr lang="pt-BR" dirty="0" smtClean="0">
                <a:latin typeface="Arial"/>
                <a:cs typeface="Arial"/>
              </a:rPr>
              <a:t>2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1508125"/>
            <a:ext cx="3462337" cy="31862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02761167"/>
      </p:ext>
    </p:extLst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9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MUC5B_HUMAN@254: LDGPTEQCPDPLPLPAG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DEEGICHR_Carbamidomethyl(C)@8; Deamidated(N)@18; Carbamidomethyl(C)@19; Carbamidomethyl(C)@</a:t>
            </a:r>
            <a:r>
              <a:rPr lang="pt-BR" dirty="0" smtClean="0">
                <a:latin typeface="Arial"/>
                <a:cs typeface="Arial"/>
              </a:rPr>
              <a:t>2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148.354, Precursor m/z 1050.46 charge 3+, delta(ppm) -</a:t>
            </a:r>
            <a:r>
              <a:rPr lang="pt-BR" dirty="0" smtClean="0">
                <a:latin typeface="Arial"/>
                <a:cs typeface="Arial"/>
              </a:rPr>
              <a:t>1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447800"/>
            <a:ext cx="3414712" cy="32846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501962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9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MUC5B_HUMAN@805: VYLDCS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AGTPGAECLR_Carbamidomethyl(C)@5; Deamidated(N)@7; Carbamidomethyl(C)@</a:t>
            </a:r>
            <a:r>
              <a:rPr lang="pt-BR" dirty="0" smtClean="0">
                <a:latin typeface="Arial"/>
                <a:cs typeface="Arial"/>
              </a:rPr>
              <a:t>1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56.884, Precursor m/z 1029.45 charge 2+, delta(ppm) -</a:t>
            </a:r>
            <a:r>
              <a:rPr lang="pt-BR" dirty="0" smtClean="0">
                <a:latin typeface="Arial"/>
                <a:cs typeface="Arial"/>
              </a:rPr>
              <a:t>1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9600" y="1905000"/>
            <a:ext cx="4024312" cy="31100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625870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9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MUC5B_HUMAN@929: AQDYCGD</a:t>
            </a:r>
            <a:r>
              <a:rPr lang="pt-BR" u="sng" dirty="0">
                <a:latin typeface="Arial"/>
                <a:cs typeface="Arial"/>
              </a:rPr>
              <a:t>NTT</a:t>
            </a:r>
            <a:r>
              <a:rPr lang="pt-BR" dirty="0">
                <a:latin typeface="Arial"/>
                <a:cs typeface="Arial"/>
              </a:rPr>
              <a:t>HGTFR_Carbamidomethyl(C)@5; 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42.696, Precursor m/z 581.91 charge 3+, delta(ppm) -</a:t>
            </a:r>
            <a:r>
              <a:rPr lang="pt-BR" dirty="0" smtClean="0">
                <a:latin typeface="Arial"/>
                <a:cs typeface="Arial"/>
              </a:rPr>
              <a:t>7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19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7068" y="2209800"/>
            <a:ext cx="3945036" cy="2305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729610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9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1244: VPTAENCQSC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PSGIQCAH_Carbamidomethyl(C)@7; Carbamidomethyl(C)@10; Deamidated(N)@11; Carbamidomethyl(C)@12; Carbamidomethyl(C)@</a:t>
            </a:r>
            <a:r>
              <a:rPr lang="pt-BR" dirty="0" smtClean="0">
                <a:latin typeface="Arial"/>
                <a:cs typeface="Arial"/>
              </a:rPr>
              <a:t>1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390.935, Precursor m/z 797.99 charge 3+, delta(ppm) -</a:t>
            </a:r>
            <a:r>
              <a:rPr lang="pt-BR" dirty="0" smtClean="0">
                <a:latin typeface="Arial"/>
                <a:cs typeface="Arial"/>
              </a:rPr>
              <a:t>5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2057400"/>
            <a:ext cx="4248150" cy="33450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028824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9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1292: IAICGS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IIR_Carbamidomethyl(C)@4; 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74.666, Precursor m/z 638.34 charge 2+, delta(ppm) -</a:t>
            </a:r>
            <a:r>
              <a:rPr lang="pt-BR" dirty="0" smtClean="0">
                <a:latin typeface="Arial"/>
                <a:cs typeface="Arial"/>
              </a:rPr>
              <a:t>0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74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1600200"/>
            <a:ext cx="4305300" cy="2483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70919835"/>
      </p:ext>
    </p:extLst>
  </p:cSld>
  <p:clrMapOvr>
    <a:masterClrMapping/>
  </p:clrMapOvr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9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MUC5B_HUMAN@1556: DIECQAESFP</a:t>
            </a:r>
            <a:r>
              <a:rPr lang="pt-BR" u="sng" dirty="0">
                <a:latin typeface="Arial"/>
                <a:cs typeface="Arial"/>
              </a:rPr>
              <a:t>NWT</a:t>
            </a:r>
            <a:r>
              <a:rPr lang="pt-BR" dirty="0">
                <a:latin typeface="Arial"/>
                <a:cs typeface="Arial"/>
              </a:rPr>
              <a:t>LAQVGQK_Carbamidomethyl(C)@4; Deamidated(N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321.06, Precursor m/z 774.69 charge 3+, delta(ppm) </a:t>
            </a:r>
            <a:r>
              <a:rPr lang="pt-BR" dirty="0" smtClean="0">
                <a:latin typeface="Arial"/>
                <a:cs typeface="Arial"/>
              </a:rPr>
              <a:t>5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810138"/>
            <a:ext cx="8229600" cy="4106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1676400"/>
            <a:ext cx="2996705" cy="3067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6988585"/>
      </p:ext>
    </p:extLst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9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4960: AFGQFFSPGEVIY</a:t>
            </a:r>
            <a:r>
              <a:rPr lang="pt-BR" u="sng" dirty="0">
                <a:latin typeface="Arial"/>
                <a:cs typeface="Arial"/>
              </a:rPr>
              <a:t>NK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1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03.82, Precursor m/z 852.92 charge 2+, delta(ppm) -</a:t>
            </a:r>
            <a:r>
              <a:rPr lang="pt-BR" dirty="0" smtClean="0">
                <a:latin typeface="Arial"/>
                <a:cs typeface="Arial"/>
              </a:rPr>
              <a:t>3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4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1752600"/>
            <a:ext cx="2838450" cy="24427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623369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00 </a:t>
            </a:r>
            <a:br>
              <a:rPr lang="pt-BR" dirty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5017|5024: QV</a:t>
            </a:r>
            <a:r>
              <a:rPr lang="pt-BR" u="sng" dirty="0">
                <a:latin typeface="Arial"/>
                <a:cs typeface="Arial"/>
              </a:rPr>
              <a:t>NET</a:t>
            </a:r>
            <a:r>
              <a:rPr lang="pt-BR" dirty="0">
                <a:latin typeface="Arial"/>
                <a:cs typeface="Arial"/>
              </a:rPr>
              <a:t>WTLENCTVAR_Deamidated(N)@3; Deamidated(N)@10; Carbamidomethyl(C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21.82, Precursor m/z 911.92 charge 2+, delta(ppm) -</a:t>
            </a:r>
            <a:r>
              <a:rPr lang="pt-BR" dirty="0" smtClean="0">
                <a:latin typeface="Arial"/>
                <a:cs typeface="Arial"/>
              </a:rPr>
              <a:t>2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45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025" y="1900239"/>
            <a:ext cx="2750395" cy="2366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864073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0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5046: VVLLDPKPVA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CVNK_Deamidated(N)@11; Carbamidomethyl(C)@</a:t>
            </a:r>
            <a:r>
              <a:rPr lang="pt-BR" dirty="0" smtClean="0">
                <a:latin typeface="Arial"/>
                <a:cs typeface="Arial"/>
              </a:rPr>
              <a:t>1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66.029, Precursor m/z 934.02 charge 2+, delta(ppm) </a:t>
            </a:r>
            <a:r>
              <a:rPr lang="pt-BR" dirty="0" smtClean="0">
                <a:latin typeface="Arial"/>
                <a:cs typeface="Arial"/>
              </a:rPr>
              <a:t>1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43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2057400"/>
            <a:ext cx="2714625" cy="17837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402387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MY1_HUMAN</a:t>
            </a:r>
            <a:r>
              <a:rPr lang="pt-BR" dirty="0">
                <a:latin typeface="Arial"/>
                <a:cs typeface="Arial"/>
              </a:rPr>
              <a:t>@427: NVVDGQPFTNWYD</a:t>
            </a:r>
            <a:r>
              <a:rPr lang="pt-BR" u="sng" dirty="0">
                <a:latin typeface="Arial"/>
                <a:cs typeface="Arial"/>
              </a:rPr>
              <a:t>NGS</a:t>
            </a:r>
            <a:r>
              <a:rPr lang="pt-BR" dirty="0">
                <a:latin typeface="Arial"/>
                <a:cs typeface="Arial"/>
              </a:rPr>
              <a:t>NQVAFGR_Deamidated(N)@</a:t>
            </a:r>
            <a:r>
              <a:rPr lang="pt-BR" dirty="0" smtClean="0">
                <a:latin typeface="Arial"/>
                <a:cs typeface="Arial"/>
              </a:rPr>
              <a:t>1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585.158, Precursor m/z 1293.58 charge 2+, delta(ppm) </a:t>
            </a:r>
            <a:r>
              <a:rPr lang="pt-BR" dirty="0" smtClean="0">
                <a:latin typeface="Arial"/>
                <a:cs typeface="Arial"/>
              </a:rPr>
              <a:t>4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126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9757" y="1600200"/>
            <a:ext cx="786448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1066800"/>
            <a:ext cx="3081337" cy="33971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26050268"/>
      </p:ext>
    </p:extLst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MUC5B_HUMAN@5096: G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YVLMR_Deamidated(N)@2; Carbamidomethyl(C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13.495, Precursor m/z 557.75 charge 2+, delta(ppm) </a:t>
            </a:r>
            <a:r>
              <a:rPr lang="pt-BR" dirty="0" smtClean="0">
                <a:latin typeface="Arial"/>
                <a:cs typeface="Arial"/>
              </a:rPr>
              <a:t>8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91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905000"/>
            <a:ext cx="3076575" cy="14434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400556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304800"/>
            <a:ext cx="8229600" cy="1143000"/>
          </a:xfrm>
        </p:spPr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MUC5B_HUMAN@5111: FGNLSLYLDNHYCTASATAAAAR_Deamidated(N)@3; Carbamidomethyl(C)@</a:t>
            </a:r>
            <a:r>
              <a:rPr lang="pt-BR" dirty="0" smtClean="0">
                <a:latin typeface="Arial"/>
                <a:cs typeface="Arial"/>
              </a:rPr>
              <a:t>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487.149, Precursor m/z 830.05 charge 3+, delta(ppm) </a:t>
            </a:r>
            <a:r>
              <a:rPr lang="pt-BR" dirty="0" smtClean="0">
                <a:latin typeface="Arial"/>
                <a:cs typeface="Arial"/>
              </a:rPr>
              <a:t>8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905000"/>
            <a:ext cx="3509560" cy="3240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823822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UC5B_HUMAN</a:t>
            </a:r>
            <a:r>
              <a:rPr lang="pt-BR" dirty="0">
                <a:latin typeface="Arial"/>
                <a:cs typeface="Arial"/>
              </a:rPr>
              <a:t>@5215: LPYSLFH</a:t>
            </a:r>
            <a:r>
              <a:rPr lang="pt-BR" u="sng" dirty="0">
                <a:latin typeface="Arial"/>
                <a:cs typeface="Arial"/>
              </a:rPr>
              <a:t>NNT</a:t>
            </a:r>
            <a:r>
              <a:rPr lang="pt-BR" dirty="0">
                <a:latin typeface="Arial"/>
                <a:cs typeface="Arial"/>
              </a:rPr>
              <a:t>EGQCGTCTNNQR_Deamidated(N)@8; Carbamidomethyl(C)@14; Carbamidomethyl(C)@</a:t>
            </a:r>
            <a:r>
              <a:rPr lang="pt-BR" dirty="0" smtClean="0">
                <a:latin typeface="Arial"/>
                <a:cs typeface="Arial"/>
              </a:rPr>
              <a:t>1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611.119, Precursor m/z 871.38 charge 3+, delta(ppm) </a:t>
            </a:r>
            <a:r>
              <a:rPr lang="pt-BR" dirty="0" smtClean="0">
                <a:latin typeface="Arial"/>
                <a:cs typeface="Arial"/>
              </a:rPr>
              <a:t>0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993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533525"/>
            <a:ext cx="3581400" cy="32279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64784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0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NEUS_HUMAN</a:t>
            </a:r>
            <a:r>
              <a:rPr lang="pt-BR" dirty="0">
                <a:latin typeface="Arial"/>
                <a:cs typeface="Arial"/>
              </a:rPr>
              <a:t>@157: WVE</a:t>
            </a:r>
            <a:r>
              <a:rPr lang="pt-BR" u="sng" dirty="0">
                <a:latin typeface="Arial"/>
                <a:cs typeface="Arial"/>
              </a:rPr>
              <a:t>NNT</a:t>
            </a:r>
            <a:r>
              <a:rPr lang="pt-BR" dirty="0">
                <a:latin typeface="Arial"/>
                <a:cs typeface="Arial"/>
              </a:rPr>
              <a:t>NNLVK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30.65, Precursor m/z 666.33 charge 2+, delta(ppm) </a:t>
            </a:r>
            <a:r>
              <a:rPr lang="pt-BR" dirty="0" smtClean="0">
                <a:latin typeface="Arial"/>
                <a:cs typeface="Arial"/>
              </a:rPr>
              <a:t>3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758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025" y="2281239"/>
            <a:ext cx="3152775" cy="20370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80113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NEUS_HUMAN@321: DA</a:t>
            </a:r>
            <a:r>
              <a:rPr lang="pt-BR" u="sng" dirty="0">
                <a:latin typeface="Arial"/>
                <a:cs typeface="Arial"/>
              </a:rPr>
              <a:t>NLT</a:t>
            </a:r>
            <a:r>
              <a:rPr lang="pt-BR" dirty="0">
                <a:latin typeface="Arial"/>
                <a:cs typeface="Arial"/>
              </a:rPr>
              <a:t>GLSDNK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47.536, Precursor m/z 574.78 charge 2+, delta(ppm) -</a:t>
            </a:r>
            <a:r>
              <a:rPr lang="pt-BR" dirty="0" smtClean="0">
                <a:latin typeface="Arial"/>
                <a:cs typeface="Arial"/>
              </a:rPr>
              <a:t>8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43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403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871662"/>
            <a:ext cx="2994890" cy="1938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29557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NGAL_HUMAN@85: SY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SVLFR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85.604, Precursor m/z 593.81 charge 2+, delta(ppm) -</a:t>
            </a:r>
            <a:r>
              <a:rPr lang="pt-BR" dirty="0" smtClean="0">
                <a:latin typeface="Arial"/>
                <a:cs typeface="Arial"/>
              </a:rPr>
              <a:t>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1571625"/>
            <a:ext cx="3090862" cy="1836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341197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52600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08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ERL_HUMAN</a:t>
            </a:r>
            <a:r>
              <a:rPr lang="pt-BR" dirty="0">
                <a:latin typeface="Arial"/>
                <a:cs typeface="Arial"/>
              </a:rPr>
              <a:t>@106: ASLTNVTDPSLDLTSLSLEVGCGAPAPVVR_Deamidated(N)@5; Carbamidomethyl(C)@</a:t>
            </a:r>
            <a:r>
              <a:rPr lang="pt-BR" dirty="0" smtClean="0">
                <a:latin typeface="Arial"/>
                <a:cs typeface="Arial"/>
              </a:rPr>
              <a:t>2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039.544, Precursor m/z 1014.19 charge 3+, delta(ppm) -</a:t>
            </a:r>
            <a:r>
              <a:rPr lang="pt-BR" dirty="0" smtClean="0">
                <a:latin typeface="Arial"/>
                <a:cs typeface="Arial"/>
              </a:rPr>
              <a:t>1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447800"/>
            <a:ext cx="2219325" cy="3033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876800" y="2964571"/>
            <a:ext cx="243978" cy="24622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?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5837873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8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ERL_HUMAN@106: ASLT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DPSLDLT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46.709, Precursor m/z 724.36 charge 2+, delta(ppm) </a:t>
            </a:r>
            <a:r>
              <a:rPr lang="pt-BR" dirty="0" smtClean="0">
                <a:latin typeface="Arial"/>
                <a:cs typeface="Arial"/>
              </a:rPr>
              <a:t>2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1676400"/>
            <a:ext cx="2509837" cy="2368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940904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0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ERL_HUMAN@212: IVGYLNEEGVLDQ</a:t>
            </a:r>
            <a:r>
              <a:rPr lang="pt-BR" u="sng" dirty="0">
                <a:latin typeface="Arial"/>
                <a:cs typeface="Arial"/>
              </a:rPr>
              <a:t>NR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18.85, Precursor m/z 860.43 charge 2+, delta(ppm) </a:t>
            </a:r>
            <a:r>
              <a:rPr lang="pt-BR" dirty="0" smtClean="0">
                <a:latin typeface="Arial"/>
                <a:cs typeface="Arial"/>
              </a:rPr>
              <a:t>2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68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0" y="1524000"/>
            <a:ext cx="2771775" cy="23853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577470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ERL_HUMAN@322: 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SPLGLMAVNQEVSDHGLPYLPYDSK_Deamidated(N)@</a:t>
            </a:r>
            <a:r>
              <a:rPr lang="pt-BR" dirty="0" smtClean="0">
                <a:latin typeface="Arial"/>
                <a:cs typeface="Arial"/>
              </a:rPr>
              <a:t>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044.481, Precursor m/z 1015.83 charge 3+, delta(ppm) </a:t>
            </a:r>
            <a:r>
              <a:rPr lang="pt-BR" dirty="0" smtClean="0">
                <a:latin typeface="Arial"/>
                <a:cs typeface="Arial"/>
              </a:rPr>
              <a:t>3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295400"/>
            <a:ext cx="2700337" cy="34659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49773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2a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MY1_HUMAN</a:t>
            </a:r>
            <a:r>
              <a:rPr lang="pt-BR" dirty="0">
                <a:latin typeface="Arial"/>
                <a:cs typeface="Arial"/>
              </a:rPr>
              <a:t>@476: ING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GIK_Ammonia-loss(N)@2; Deamidated(N)@</a:t>
            </a:r>
            <a:r>
              <a:rPr lang="pt-BR" dirty="0" smtClean="0">
                <a:latin typeface="Arial"/>
                <a:cs typeface="Arial"/>
              </a:rPr>
              <a:t>4, Carbamidomethyl</a:t>
            </a:r>
            <a:r>
              <a:rPr lang="pt-BR" dirty="0">
                <a:latin typeface="Arial"/>
                <a:cs typeface="Arial"/>
              </a:rPr>
              <a:t>(C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959.439, Precursor m/z 480.73 charge 2+, delta(ppm) -7.5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1905000"/>
            <a:ext cx="3279465" cy="1585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374115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1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ERL_HUMAN</a:t>
            </a:r>
            <a:r>
              <a:rPr lang="pt-BR" dirty="0">
                <a:latin typeface="Arial"/>
                <a:cs typeface="Arial"/>
              </a:rPr>
              <a:t>@358: KPSPCEFI</a:t>
            </a:r>
            <a:r>
              <a:rPr lang="pt-BR" u="sng" dirty="0">
                <a:latin typeface="Arial"/>
                <a:cs typeface="Arial"/>
              </a:rPr>
              <a:t>NTT</a:t>
            </a:r>
            <a:r>
              <a:rPr lang="pt-BR" dirty="0">
                <a:latin typeface="Arial"/>
                <a:cs typeface="Arial"/>
              </a:rPr>
              <a:t>AR_Carbamidomethyl(C)@5; 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20.73, Precursor m/z 507.92 charge 3+, delta(ppm) -</a:t>
            </a:r>
            <a:r>
              <a:rPr lang="pt-BR" dirty="0" smtClean="0">
                <a:latin typeface="Arial"/>
                <a:cs typeface="Arial"/>
              </a:rPr>
              <a:t>5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25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270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2133600"/>
            <a:ext cx="3549129" cy="1947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613888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11a 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ERL_HUMAN</a:t>
            </a:r>
            <a:r>
              <a:rPr lang="pt-BR" dirty="0">
                <a:latin typeface="Arial"/>
                <a:cs typeface="Arial"/>
              </a:rPr>
              <a:t>@358: KPSPCEFI</a:t>
            </a:r>
            <a:r>
              <a:rPr lang="pt-BR" u="sng" dirty="0">
                <a:latin typeface="Arial"/>
                <a:cs typeface="Arial"/>
              </a:rPr>
              <a:t>NTT</a:t>
            </a:r>
            <a:r>
              <a:rPr lang="pt-BR" dirty="0">
                <a:latin typeface="Arial"/>
                <a:cs typeface="Arial"/>
              </a:rPr>
              <a:t>AR_Carbamidomethyl(C)@5; 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20.73, Precursor m/z 761.37 charge 2+, delta(ppm) </a:t>
            </a:r>
            <a:r>
              <a:rPr lang="pt-BR" dirty="0" smtClean="0">
                <a:latin typeface="Arial"/>
                <a:cs typeface="Arial"/>
              </a:rPr>
              <a:t>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7475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475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1676400"/>
            <a:ext cx="3724275" cy="20560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785117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2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83|90: A</a:t>
            </a:r>
            <a:r>
              <a:rPr lang="pt-BR" u="sng" dirty="0">
                <a:latin typeface="Arial"/>
                <a:cs typeface="Arial"/>
              </a:rPr>
              <a:t>NLTNFP</a:t>
            </a:r>
            <a:r>
              <a:rPr lang="pt-BR" dirty="0">
                <a:latin typeface="Arial"/>
                <a:cs typeface="Arial"/>
              </a:rPr>
              <a:t>ENGTFVVNIAQLSQDDSGR_Deamidated(N)@2; 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808.32, Precursor m/z 1405.17 charge 2, delta(ppm) </a:t>
            </a:r>
            <a:r>
              <a:rPr lang="pt-BR" dirty="0" smtClean="0">
                <a:latin typeface="Arial"/>
                <a:cs typeface="Arial"/>
              </a:rPr>
              <a:t>0.2</a:t>
            </a:r>
            <a:br>
              <a:rPr lang="pt-BR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PIGR_HUMAN|Sequence: A</a:t>
            </a:r>
            <a:r>
              <a:rPr lang="en-US" u="sng" dirty="0" smtClean="0">
                <a:latin typeface="Arial"/>
                <a:cs typeface="Arial"/>
              </a:rPr>
              <a:t>NLT</a:t>
            </a:r>
            <a:r>
              <a:rPr lang="en-US" dirty="0" smtClean="0">
                <a:latin typeface="Arial"/>
                <a:cs typeface="Arial"/>
              </a:rPr>
              <a:t>NFPE</a:t>
            </a:r>
            <a:r>
              <a:rPr lang="en-US" u="sng" dirty="0" smtClean="0">
                <a:latin typeface="Arial"/>
                <a:cs typeface="Arial"/>
              </a:rPr>
              <a:t>NGT</a:t>
            </a:r>
            <a:r>
              <a:rPr lang="en-US" dirty="0" smtClean="0">
                <a:latin typeface="Arial"/>
                <a:cs typeface="Arial"/>
              </a:rPr>
              <a:t>FVVNIAQLSQDDSGR </a:t>
            </a:r>
            <a:r>
              <a:rPr lang="en-US" dirty="0" err="1" smtClean="0">
                <a:latin typeface="Arial"/>
                <a:cs typeface="Arial"/>
              </a:rPr>
              <a:t>Deamidated</a:t>
            </a:r>
            <a:r>
              <a:rPr lang="en-US" dirty="0" smtClean="0">
                <a:latin typeface="Arial"/>
                <a:cs typeface="Arial"/>
              </a:rPr>
              <a:t>(N)@2;Deamidated(N)@9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err="1" smtClean="0">
                <a:latin typeface="Arial"/>
                <a:cs typeface="Arial"/>
              </a:rPr>
              <a:t>Prec</a:t>
            </a:r>
            <a:r>
              <a:rPr lang="en-US" dirty="0" smtClean="0">
                <a:latin typeface="Arial"/>
                <a:cs typeface="Arial"/>
              </a:rPr>
              <a:t> MW: 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2808.32</a:t>
            </a:r>
            <a:r>
              <a:rPr lang="en-US" dirty="0" smtClean="0">
                <a:latin typeface="Arial"/>
                <a:cs typeface="Arial"/>
              </a:rPr>
              <a:t>|Prec m/z: 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1405.167</a:t>
            </a:r>
            <a:r>
              <a:rPr lang="en-US" dirty="0" smtClean="0">
                <a:latin typeface="Arial"/>
                <a:cs typeface="Arial"/>
              </a:rPr>
              <a:t>|Delta (ppm): 7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150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29400" y="1524000"/>
            <a:ext cx="2105025" cy="2951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64226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2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83|90: ANLTNFPENGTFVVNIAQLSQDDSGR_Deamidated(N)@2; 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808.32, Precursor m/z 937.11 charge 3, delta(ppm) 4.3</a:t>
            </a:r>
            <a:br>
              <a:rPr lang="pt-BR" dirty="0">
                <a:latin typeface="Arial"/>
                <a:cs typeface="Arial"/>
              </a:rPr>
            </a:br>
            <a:r>
              <a:rPr lang="en-US" dirty="0">
                <a:latin typeface="Arial"/>
                <a:cs typeface="Arial"/>
              </a:rPr>
              <a:t/>
            </a:r>
            <a:br>
              <a:rPr lang="en-US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PIGR_HUMAN: ANLTNFPENGTFVVNIAQLSQDDSGR: </a:t>
            </a:r>
            <a:r>
              <a:rPr lang="en-US" dirty="0" err="1">
                <a:latin typeface="Arial"/>
                <a:cs typeface="Arial"/>
              </a:rPr>
              <a:t>Deamidated</a:t>
            </a:r>
            <a:r>
              <a:rPr lang="en-US" dirty="0">
                <a:latin typeface="Arial"/>
                <a:cs typeface="Arial"/>
              </a:rPr>
              <a:t>(N)@2; </a:t>
            </a:r>
            <a:r>
              <a:rPr lang="en-US" dirty="0" err="1">
                <a:latin typeface="Arial"/>
                <a:cs typeface="Arial"/>
              </a:rPr>
              <a:t>Deamidated</a:t>
            </a:r>
            <a:r>
              <a:rPr lang="en-US" dirty="0">
                <a:latin typeface="Arial"/>
                <a:cs typeface="Arial"/>
              </a:rPr>
              <a:t>(N)</a:t>
            </a:r>
            <a:r>
              <a:rPr lang="en-US" dirty="0" smtClean="0">
                <a:latin typeface="Arial"/>
                <a:cs typeface="Arial"/>
              </a:rPr>
              <a:t>@9 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 PREC </a:t>
            </a:r>
            <a:r>
              <a:rPr lang="en-US" dirty="0">
                <a:latin typeface="Arial"/>
                <a:cs typeface="Arial"/>
              </a:rPr>
              <a:t>M/Z:937.11 </a:t>
            </a:r>
            <a:r>
              <a:rPr lang="en-US" dirty="0" err="1">
                <a:latin typeface="Arial"/>
                <a:cs typeface="Arial"/>
              </a:rPr>
              <a:t>Theor</a:t>
            </a:r>
            <a:r>
              <a:rPr lang="en-US" dirty="0">
                <a:latin typeface="Arial"/>
                <a:cs typeface="Arial"/>
              </a:rPr>
              <a:t> MW: 2808.32 Delta ppm: 0</a:t>
            </a:r>
            <a:br>
              <a:rPr lang="en-US" dirty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174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55786"/>
            <a:ext cx="8229600" cy="42147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1524000"/>
            <a:ext cx="2405062" cy="31989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30417681"/>
      </p:ext>
    </p:extLst>
  </p:cSld>
  <p:clrMapOvr>
    <a:masterClrMapping/>
  </p:clrMapOvr>
</p:sld>
</file>

<file path=ppt/slides/slide1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2c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83: ANLTNFPENGTFVVN_Deamidated(N)@2; 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37.76, Precursor m/z 819.89 charge 2+, delta(ppm) -3.3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PIGR_HUMAN: ANLTNFPENGTFVV: </a:t>
            </a:r>
            <a:r>
              <a:rPr lang="en-US" dirty="0" err="1">
                <a:latin typeface="Arial"/>
                <a:cs typeface="Arial"/>
              </a:rPr>
              <a:t>Deamidated</a:t>
            </a:r>
            <a:r>
              <a:rPr lang="en-US" dirty="0">
                <a:latin typeface="Arial"/>
                <a:cs typeface="Arial"/>
              </a:rPr>
              <a:t>(N)@2; </a:t>
            </a:r>
            <a:r>
              <a:rPr lang="en-US" dirty="0" err="1">
                <a:latin typeface="Arial"/>
                <a:cs typeface="Arial"/>
              </a:rPr>
              <a:t>Deamidated</a:t>
            </a:r>
            <a:r>
              <a:rPr lang="en-US" dirty="0">
                <a:latin typeface="Arial"/>
                <a:cs typeface="Arial"/>
              </a:rPr>
              <a:t>(N)@9 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PREC </a:t>
            </a:r>
            <a:r>
              <a:rPr lang="en-US" dirty="0">
                <a:latin typeface="Arial"/>
                <a:cs typeface="Arial"/>
              </a:rPr>
              <a:t>M/Z:819.89 </a:t>
            </a:r>
            <a:r>
              <a:rPr lang="en-US" dirty="0" err="1">
                <a:latin typeface="Arial"/>
                <a:cs typeface="Arial"/>
              </a:rPr>
              <a:t>Theor</a:t>
            </a:r>
            <a:r>
              <a:rPr lang="en-US" dirty="0">
                <a:latin typeface="Arial"/>
                <a:cs typeface="Arial"/>
              </a:rPr>
              <a:t> MW: 1637.76 Delta ppm: 0</a:t>
            </a:r>
          </a:p>
        </p:txBody>
      </p:sp>
      <p:pic>
        <p:nvPicPr>
          <p:cNvPr id="133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799" y="1900238"/>
            <a:ext cx="2366961" cy="23669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43553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IGR_HUMAN@135: DVSLEVSQGPGLL</a:t>
            </a:r>
            <a:r>
              <a:rPr lang="pt-BR" u="sng" dirty="0">
                <a:latin typeface="Arial"/>
                <a:cs typeface="Arial"/>
              </a:rPr>
              <a:t>NDT</a:t>
            </a:r>
            <a:r>
              <a:rPr lang="pt-BR" dirty="0">
                <a:latin typeface="Arial"/>
                <a:cs typeface="Arial"/>
              </a:rPr>
              <a:t>K_Deamidated(N)@</a:t>
            </a:r>
            <a:r>
              <a:rPr lang="pt-BR" dirty="0" smtClean="0">
                <a:latin typeface="Arial"/>
                <a:cs typeface="Arial"/>
              </a:rPr>
              <a:t>1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71.885, Precursor m/z 886.95 charge 2+, delta(ppm) -</a:t>
            </a:r>
            <a:r>
              <a:rPr lang="pt-BR" dirty="0" smtClean="0">
                <a:latin typeface="Arial"/>
                <a:cs typeface="Arial"/>
              </a:rPr>
              <a:t>0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993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1685925"/>
            <a:ext cx="2213306" cy="2114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667082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4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186: LVIDSSGYVNP</a:t>
            </a:r>
            <a:r>
              <a:rPr lang="pt-BR" u="sng" dirty="0">
                <a:latin typeface="Arial"/>
                <a:cs typeface="Arial"/>
              </a:rPr>
              <a:t>NYT</a:t>
            </a:r>
            <a:r>
              <a:rPr lang="pt-BR" dirty="0">
                <a:latin typeface="Arial"/>
                <a:cs typeface="Arial"/>
              </a:rPr>
              <a:t>GR_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54.85, Precursor m/z 878.43 charge 2+, delta(ppm) </a:t>
            </a:r>
            <a:r>
              <a:rPr lang="pt-BR" dirty="0" smtClean="0">
                <a:latin typeface="Arial"/>
                <a:cs typeface="Arial"/>
              </a:rPr>
              <a:t>2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9937" y="1676400"/>
            <a:ext cx="2641637" cy="2324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202960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421: LSLLEEPG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FTVILNQLTSR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402.27, Precursor m/z 1202.14 charge 2+, delta(ppm) </a:t>
            </a:r>
            <a:r>
              <a:rPr lang="pt-BR" dirty="0" smtClean="0">
                <a:latin typeface="Arial"/>
                <a:cs typeface="Arial"/>
              </a:rPr>
              <a:t>1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58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122587"/>
            <a:ext cx="8229600" cy="348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200" y="1371600"/>
            <a:ext cx="2852737" cy="30151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90766673"/>
      </p:ext>
    </p:extLst>
  </p:cSld>
  <p:clrMapOvr>
    <a:masterClrMapping/>
  </p:clrMapOvr>
</p:sld>
</file>

<file path=ppt/slides/slide1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16a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469: VPG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AVLGETLK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97.78, Precursor m/z 699.9 charge 2+, delta(ppm) -</a:t>
            </a:r>
            <a:r>
              <a:rPr lang="pt-BR" dirty="0" smtClean="0">
                <a:latin typeface="Arial"/>
                <a:cs typeface="Arial"/>
              </a:rPr>
              <a:t>3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1924050"/>
            <a:ext cx="2924175" cy="22735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71051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6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469: G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AVLGETL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01.66, Precursor m/z 601.83 charge 2+, delta(ppm) </a:t>
            </a:r>
            <a:r>
              <a:rPr lang="pt-BR" dirty="0" smtClean="0">
                <a:latin typeface="Arial"/>
                <a:cs typeface="Arial"/>
              </a:rPr>
              <a:t>12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1981200"/>
            <a:ext cx="2771775" cy="19394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582708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2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MY1_HUMAN</a:t>
            </a:r>
            <a:r>
              <a:rPr lang="pt-BR" dirty="0">
                <a:latin typeface="Arial"/>
                <a:cs typeface="Arial"/>
              </a:rPr>
              <a:t>@476: ISGDKING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GIK_Deamidated(N)@7; Deamidated(N)@9; Carbamidomethyl(C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77.709, Precursor m/z 739.86 charge 2+, delta(ppm) 1.8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828800"/>
            <a:ext cx="3532271" cy="198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39546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IGR_HUMAN</a:t>
            </a:r>
            <a:r>
              <a:rPr lang="pt-BR" dirty="0">
                <a:latin typeface="Arial"/>
                <a:cs typeface="Arial"/>
              </a:rPr>
              <a:t>@499: W</a:t>
            </a:r>
            <a:r>
              <a:rPr lang="pt-BR" u="sng" dirty="0">
                <a:latin typeface="Arial"/>
                <a:cs typeface="Arial"/>
              </a:rPr>
              <a:t>NNT</a:t>
            </a:r>
            <a:r>
              <a:rPr lang="pt-BR" dirty="0">
                <a:latin typeface="Arial"/>
                <a:cs typeface="Arial"/>
              </a:rPr>
              <a:t>GCQALPSQDEGPSK_FormaldehydeAdduct(W)@1; Deamidated(N)@2; Carbamidomethyl(C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00.85, Precursor m/z 1001.43 charge 2+, delta(ppm) </a:t>
            </a:r>
            <a:r>
              <a:rPr lang="pt-BR" dirty="0" smtClean="0">
                <a:latin typeface="Arial"/>
                <a:cs typeface="Arial"/>
              </a:rPr>
              <a:t>2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286000"/>
            <a:ext cx="3117056" cy="2514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586825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1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IP_HUMAN@105: TFYWDFYT</a:t>
            </a:r>
            <a:r>
              <a:rPr lang="pt-BR" u="sng" dirty="0">
                <a:latin typeface="Arial"/>
                <a:cs typeface="Arial"/>
              </a:rPr>
              <a:t>NR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12.604, Precursor m/z 707.31 charge 2+, delta(ppm) -</a:t>
            </a:r>
            <a:r>
              <a:rPr lang="pt-BR" dirty="0" smtClean="0">
                <a:latin typeface="Arial"/>
                <a:cs typeface="Arial"/>
              </a:rPr>
              <a:t>1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122587"/>
            <a:ext cx="8229600" cy="348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9400" y="1981200"/>
            <a:ext cx="2986768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258671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1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LTP_HUMAN</a:t>
            </a:r>
            <a:r>
              <a:rPr lang="pt-BR" dirty="0">
                <a:latin typeface="Arial"/>
                <a:cs typeface="Arial"/>
              </a:rPr>
              <a:t>@64: EGHFYY</a:t>
            </a:r>
            <a:r>
              <a:rPr lang="pt-BR" u="sng" dirty="0">
                <a:latin typeface="Arial"/>
                <a:cs typeface="Arial"/>
              </a:rPr>
              <a:t>NIS</a:t>
            </a:r>
            <a:r>
              <a:rPr lang="pt-BR" dirty="0">
                <a:latin typeface="Arial"/>
                <a:cs typeface="Arial"/>
              </a:rPr>
              <a:t>EVK_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85.68, Precursor m/z 743.85 charge 2+, delta(ppm) -</a:t>
            </a:r>
            <a:r>
              <a:rPr lang="pt-BR" dirty="0" smtClean="0">
                <a:latin typeface="Arial"/>
                <a:cs typeface="Arial"/>
              </a:rPr>
              <a:t>3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5364" name="Picture 4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1981200"/>
            <a:ext cx="3605212" cy="2105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961851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LTP_HUMAN</a:t>
            </a:r>
            <a:r>
              <a:rPr lang="pt-BR" dirty="0">
                <a:latin typeface="Arial"/>
                <a:cs typeface="Arial"/>
              </a:rPr>
              <a:t>@117: FYDGGYI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AEGVSIR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18.843, Precursor m/z 910.42 charge 2+, delta(ppm) </a:t>
            </a:r>
            <a:r>
              <a:rPr lang="pt-BR" dirty="0" smtClean="0">
                <a:latin typeface="Arial"/>
                <a:cs typeface="Arial"/>
              </a:rPr>
              <a:t>9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1" y="1698625"/>
            <a:ext cx="3052762" cy="23101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517581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2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LTP_HUMAN@143: VS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CQASVSR_Deamidated(N)@3; Carbamidomethyl(C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93.6, Precursor m/z 647.81 charge 2+, delta(ppm) -</a:t>
            </a:r>
            <a:r>
              <a:rPr lang="pt-BR" dirty="0" smtClean="0">
                <a:latin typeface="Arial"/>
                <a:cs typeface="Arial"/>
              </a:rPr>
              <a:t>4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843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1981200"/>
            <a:ext cx="3200400" cy="18521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633822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22a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PLTP_HUMAN@398: IYS</a:t>
            </a:r>
            <a:r>
              <a:rPr lang="pt-BR" u="sng" dirty="0">
                <a:latin typeface="Arial"/>
                <a:cs typeface="Arial"/>
              </a:rPr>
              <a:t>NHS</a:t>
            </a:r>
            <a:r>
              <a:rPr lang="pt-BR" dirty="0">
                <a:latin typeface="Arial"/>
                <a:cs typeface="Arial"/>
              </a:rPr>
              <a:t>ALESLALIPLQAPLK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278.258, Precursor m/z 760.43 charge 3+, delta(ppm) -</a:t>
            </a:r>
            <a:r>
              <a:rPr lang="pt-BR" dirty="0" smtClean="0">
                <a:latin typeface="Arial"/>
                <a:cs typeface="Arial"/>
              </a:rPr>
              <a:t>4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76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6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676400"/>
            <a:ext cx="3476625" cy="33703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216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2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LTP_HUMAN</a:t>
            </a:r>
            <a:r>
              <a:rPr lang="pt-BR" dirty="0">
                <a:latin typeface="Arial"/>
                <a:cs typeface="Arial"/>
              </a:rPr>
              <a:t>@398: IYS</a:t>
            </a:r>
            <a:r>
              <a:rPr lang="pt-BR" u="sng" dirty="0">
                <a:latin typeface="Arial"/>
                <a:cs typeface="Arial"/>
              </a:rPr>
              <a:t>NHS</a:t>
            </a:r>
            <a:r>
              <a:rPr lang="pt-BR" dirty="0">
                <a:latin typeface="Arial"/>
                <a:cs typeface="Arial"/>
              </a:rPr>
              <a:t>ALESL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33.59, Precursor m/z 617.8 charge 2+, delta(ppm) </a:t>
            </a:r>
            <a:r>
              <a:rPr lang="pt-BR" dirty="0" smtClean="0">
                <a:latin typeface="Arial"/>
                <a:cs typeface="Arial"/>
              </a:rPr>
              <a:t>3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0" y="1981200"/>
            <a:ext cx="3533775" cy="1895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669429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PM1L_HUMAN</a:t>
            </a:r>
            <a:r>
              <a:rPr lang="pt-BR" dirty="0">
                <a:latin typeface="Arial"/>
                <a:cs typeface="Arial"/>
              </a:rPr>
              <a:t>@117: FEVLTDLA</a:t>
            </a:r>
            <a:r>
              <a:rPr lang="pt-BR" u="sng" dirty="0">
                <a:latin typeface="Arial"/>
                <a:cs typeface="Arial"/>
              </a:rPr>
              <a:t>NK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49.59, Precursor m/z 575.8 charge 2+, delta(ppm) </a:t>
            </a:r>
            <a:r>
              <a:rPr lang="pt-BR" dirty="0" smtClean="0">
                <a:latin typeface="Arial"/>
                <a:cs typeface="Arial"/>
              </a:rPr>
              <a:t>3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025" y="2376489"/>
            <a:ext cx="2771775" cy="16422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739260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4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RB2_HUMAN</a:t>
            </a:r>
            <a:r>
              <a:rPr lang="pt-BR" dirty="0">
                <a:latin typeface="Arial"/>
                <a:cs typeface="Arial"/>
              </a:rPr>
              <a:t>@168: PQGPPPQGD</a:t>
            </a:r>
            <a:r>
              <a:rPr lang="pt-BR" u="sng" dirty="0">
                <a:latin typeface="Arial"/>
                <a:cs typeface="Arial"/>
              </a:rPr>
              <a:t>NKS</a:t>
            </a:r>
            <a:r>
              <a:rPr lang="pt-BR" dirty="0">
                <a:latin typeface="Arial"/>
                <a:cs typeface="Arial"/>
              </a:rPr>
              <a:t>RSSRSPP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988.97, Precursor m/z 664.01 charge 3+, delta(ppm) -</a:t>
            </a:r>
            <a:r>
              <a:rPr lang="pt-BR" dirty="0" smtClean="0">
                <a:latin typeface="Arial"/>
                <a:cs typeface="Arial"/>
              </a:rPr>
              <a:t>19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355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55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200" y="1752600"/>
            <a:ext cx="3224212" cy="28818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41808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RB2_HUMAN</a:t>
            </a:r>
            <a:r>
              <a:rPr lang="pt-BR" dirty="0">
                <a:latin typeface="Arial"/>
                <a:cs typeface="Arial"/>
              </a:rPr>
              <a:t>@272: PQGPPPQGGNKSQGPPPPGKP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19.02, Precursor m/z 674 charge 3+, delta(ppm) </a:t>
            </a:r>
            <a:r>
              <a:rPr lang="pt-BR" dirty="0" smtClean="0">
                <a:latin typeface="Arial"/>
                <a:cs typeface="Arial"/>
              </a:rPr>
              <a:t>20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3800" y="1524000"/>
            <a:ext cx="3148012" cy="30922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733908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sz="1300" dirty="0">
                <a:latin typeface="Arial"/>
                <a:cs typeface="Arial"/>
              </a:rPr>
              <a:t>Spectrum </a:t>
            </a:r>
            <a:r>
              <a:rPr lang="pt-BR" sz="1300" dirty="0" smtClean="0">
                <a:latin typeface="Arial"/>
                <a:cs typeface="Arial"/>
              </a:rPr>
              <a:t>12c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AMY1_HUMAN</a:t>
            </a:r>
            <a:r>
              <a:rPr lang="pt-BR" sz="1300" dirty="0">
                <a:latin typeface="Arial"/>
                <a:cs typeface="Arial"/>
              </a:rPr>
              <a:t>@476: VISGDKING</a:t>
            </a:r>
            <a:r>
              <a:rPr lang="pt-BR" sz="1300" u="sng" dirty="0">
                <a:latin typeface="Arial"/>
                <a:cs typeface="Arial"/>
              </a:rPr>
              <a:t>NCT</a:t>
            </a:r>
            <a:r>
              <a:rPr lang="pt-BR" sz="1300" dirty="0">
                <a:latin typeface="Arial"/>
                <a:cs typeface="Arial"/>
              </a:rPr>
              <a:t>GIK_Deamidated(N)@8; Deamidated(N)@10; Carbamidomethyl(C)@</a:t>
            </a:r>
            <a:r>
              <a:rPr lang="pt-BR" sz="1300" dirty="0" smtClean="0">
                <a:latin typeface="Arial"/>
                <a:cs typeface="Arial"/>
              </a:rPr>
              <a:t>11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MW </a:t>
            </a:r>
            <a:r>
              <a:rPr lang="pt-BR" sz="1300" dirty="0">
                <a:latin typeface="Arial"/>
                <a:cs typeface="Arial"/>
              </a:rPr>
              <a:t>1576.777, Precursor m/z 789.4 charge 2+, delta(ppm) -5.6</a:t>
            </a:r>
            <a:br>
              <a:rPr lang="pt-BR" sz="1300" dirty="0">
                <a:latin typeface="Arial"/>
                <a:cs typeface="Arial"/>
              </a:rPr>
            </a:br>
            <a:r>
              <a:rPr lang="en-US" sz="1300" dirty="0" smtClean="0">
                <a:latin typeface="Arial"/>
                <a:cs typeface="Arial"/>
              </a:rPr>
              <a:t/>
            </a:r>
            <a:br>
              <a:rPr lang="en-US" sz="1300" dirty="0" smtClean="0">
                <a:latin typeface="Arial"/>
                <a:cs typeface="Arial"/>
              </a:rPr>
            </a:br>
            <a:endParaRPr lang="en-US" sz="1300" dirty="0">
              <a:latin typeface="Arial"/>
              <a:cs typeface="Arial"/>
            </a:endParaRPr>
          </a:p>
        </p:txBody>
      </p:sp>
      <p:pic>
        <p:nvPicPr>
          <p:cNvPr id="133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1905000"/>
            <a:ext cx="3724275" cy="21311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004509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RB3_HUMAN</a:t>
            </a:r>
            <a:r>
              <a:rPr lang="pt-BR" dirty="0">
                <a:latin typeface="Arial"/>
                <a:cs typeface="Arial"/>
              </a:rPr>
              <a:t>@66: PGKPEGPPPQGG</a:t>
            </a:r>
            <a:r>
              <a:rPr lang="pt-BR" u="sng" dirty="0">
                <a:latin typeface="Arial"/>
                <a:cs typeface="Arial"/>
              </a:rPr>
              <a:t>NQS</a:t>
            </a:r>
            <a:r>
              <a:rPr lang="pt-BR" dirty="0">
                <a:latin typeface="Arial"/>
                <a:cs typeface="Arial"/>
              </a:rPr>
              <a:t>QGPPPR_Deamidated(N)@</a:t>
            </a:r>
            <a:r>
              <a:rPr lang="pt-BR" dirty="0" smtClean="0">
                <a:latin typeface="Arial"/>
                <a:cs typeface="Arial"/>
              </a:rPr>
              <a:t>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79.014, Precursor m/z 694.0114 charge 3+, delta(ppm) </a:t>
            </a:r>
            <a:r>
              <a:rPr lang="pt-BR" dirty="0" smtClean="0">
                <a:latin typeface="Arial"/>
                <a:cs typeface="Arial"/>
              </a:rPr>
              <a:t>0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126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362" y="1600200"/>
            <a:ext cx="8119275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1600200"/>
            <a:ext cx="3271837" cy="28428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17977286"/>
      </p:ext>
    </p:extLst>
  </p:cSld>
  <p:clrMapOvr>
    <a:masterClrMapping/>
  </p:clrMapOvr>
</p:sld>
</file>

<file path=ppt/slides/slide1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ROM1_HUMAN</a:t>
            </a:r>
            <a:r>
              <a:rPr lang="pt-BR" dirty="0">
                <a:latin typeface="Arial"/>
                <a:cs typeface="Arial"/>
              </a:rPr>
              <a:t>@220: YILAQY</a:t>
            </a:r>
            <a:r>
              <a:rPr lang="pt-BR" u="sng" dirty="0">
                <a:latin typeface="Arial"/>
                <a:cs typeface="Arial"/>
              </a:rPr>
              <a:t>NTT</a:t>
            </a:r>
            <a:r>
              <a:rPr lang="pt-BR" dirty="0">
                <a:latin typeface="Arial"/>
                <a:cs typeface="Arial"/>
              </a:rPr>
              <a:t>K_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14.62, Precursor m/z 608.32 charge 2+, delta(ppm) -</a:t>
            </a:r>
            <a:r>
              <a:rPr lang="pt-BR" dirty="0" smtClean="0">
                <a:latin typeface="Arial"/>
                <a:cs typeface="Arial"/>
              </a:rPr>
              <a:t>4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0" y="1588297"/>
            <a:ext cx="2676675" cy="15859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376000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ROM1_HUMAN</a:t>
            </a:r>
            <a:r>
              <a:rPr lang="pt-BR" dirty="0">
                <a:latin typeface="Arial"/>
                <a:cs typeface="Arial"/>
              </a:rPr>
              <a:t>@395: VLNSIGSDID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QR_Deamidated(N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30.82, Precursor m/z 816.41 charge 2+, delta(ppm) </a:t>
            </a:r>
            <a:r>
              <a:rPr lang="pt-BR" dirty="0" smtClean="0">
                <a:latin typeface="Arial"/>
                <a:cs typeface="Arial"/>
              </a:rPr>
              <a:t>8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96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6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2209800"/>
            <a:ext cx="2409825" cy="2073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020507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	</a:t>
            </a:r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2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SG1_HUMAN</a:t>
            </a:r>
            <a:r>
              <a:rPr lang="pt-BR" dirty="0">
                <a:latin typeface="Arial"/>
                <a:cs typeface="Arial"/>
              </a:rPr>
              <a:t>@104: ETAYS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LLIQ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R_Deamidated(N)@6; Deamidated(N)@</a:t>
            </a:r>
            <a:r>
              <a:rPr lang="pt-BR" dirty="0" smtClean="0">
                <a:latin typeface="Arial"/>
                <a:cs typeface="Arial"/>
              </a:rPr>
              <a:t>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80.885, Precursor m/z 891.4494 charge 2+, delta(ppm) </a:t>
            </a:r>
            <a:r>
              <a:rPr lang="pt-BR" dirty="0" smtClean="0">
                <a:latin typeface="Arial"/>
                <a:cs typeface="Arial"/>
              </a:rPr>
              <a:t>0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1473103"/>
            <a:ext cx="786448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1676400"/>
            <a:ext cx="2847975" cy="2389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96938688"/>
      </p:ext>
    </p:extLst>
  </p:cSld>
  <p:clrMapOvr>
    <a:masterClrMapping/>
  </p:clrMapOvr>
</p:sld>
</file>

<file path=ppt/slides/slide1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PTPRF_HUMAN</a:t>
            </a:r>
            <a:r>
              <a:rPr lang="pt-BR" dirty="0">
                <a:latin typeface="Arial"/>
                <a:cs typeface="Arial"/>
              </a:rPr>
              <a:t>@966: DINSQQELQ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TDTR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75.88, Precursor m/z 938.95 charge 2+, delta(ppm) -</a:t>
            </a:r>
            <a:r>
              <a:rPr lang="pt-BR" dirty="0" smtClean="0">
                <a:latin typeface="Arial"/>
                <a:cs typeface="Arial"/>
              </a:rPr>
              <a:t>2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76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800228"/>
            <a:ext cx="2943322" cy="2690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700224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RNT2_HUMAN</a:t>
            </a:r>
            <a:r>
              <a:rPr lang="pt-BR" dirty="0">
                <a:latin typeface="Arial"/>
                <a:cs typeface="Arial"/>
              </a:rPr>
              <a:t>@212: QDQQLQ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EPGEQPSPK_Deamidated(N)@7; Carbamidomethyl(C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83.91, Precursor m/z 1042.96 charge 2+, delta(ppm) </a:t>
            </a:r>
            <a:r>
              <a:rPr lang="pt-BR" dirty="0" smtClean="0">
                <a:latin typeface="Arial"/>
                <a:cs typeface="Arial"/>
              </a:rPr>
              <a:t>2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86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1752600"/>
            <a:ext cx="2976562" cy="25314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41568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3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SAP_HUMAN@80: D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EEEILVYLE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65.8, Precursor m/z 833.91 charge 2+, delta(ppm) -</a:t>
            </a:r>
            <a:r>
              <a:rPr lang="pt-BR" dirty="0" smtClean="0">
                <a:latin typeface="Arial"/>
                <a:cs typeface="Arial"/>
              </a:rPr>
              <a:t>3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37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7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1447800"/>
            <a:ext cx="2857500" cy="22216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536497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SAP_HUMAN</a:t>
            </a:r>
            <a:r>
              <a:rPr lang="pt-BR" dirty="0">
                <a:latin typeface="Arial"/>
                <a:cs typeface="Arial"/>
              </a:rPr>
              <a:t>@215: T</a:t>
            </a:r>
            <a:r>
              <a:rPr lang="pt-BR" u="sng" dirty="0">
                <a:latin typeface="Arial"/>
                <a:cs typeface="Arial"/>
              </a:rPr>
              <a:t>NST</a:t>
            </a:r>
            <a:r>
              <a:rPr lang="pt-BR" dirty="0">
                <a:latin typeface="Arial"/>
                <a:cs typeface="Arial"/>
              </a:rPr>
              <a:t>FVQALVEHV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72.81, Precursor m/z 525.28 charge 3+, delta(ppm) -</a:t>
            </a:r>
            <a:r>
              <a:rPr lang="pt-BR" dirty="0" smtClean="0">
                <a:latin typeface="Arial"/>
                <a:cs typeface="Arial"/>
              </a:rPr>
              <a:t>5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5200" y="2133600"/>
            <a:ext cx="3067050" cy="21222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358801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3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SIL1_HUMAN@193: F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SSSLEE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14.53, Precursor m/z 608.27 charge 2+, delta(ppm) </a:t>
            </a:r>
            <a:r>
              <a:rPr lang="pt-BR" dirty="0" smtClean="0">
                <a:latin typeface="Arial"/>
                <a:cs typeface="Arial"/>
              </a:rPr>
              <a:t>3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2125" y="1905000"/>
            <a:ext cx="2695575" cy="17416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179616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SRPR_HUMAN</a:t>
            </a:r>
            <a:r>
              <a:rPr lang="pt-BR" dirty="0">
                <a:latin typeface="Arial"/>
                <a:cs typeface="Arial"/>
              </a:rPr>
              <a:t>@44: GG</a:t>
            </a:r>
            <a:r>
              <a:rPr lang="pt-BR" u="sng" dirty="0">
                <a:latin typeface="Arial"/>
                <a:cs typeface="Arial"/>
              </a:rPr>
              <a:t>NNS</a:t>
            </a:r>
            <a:r>
              <a:rPr lang="pt-BR" dirty="0">
                <a:latin typeface="Arial"/>
                <a:cs typeface="Arial"/>
              </a:rPr>
              <a:t>FTHEALTLK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88.72, Precursor m/z 497.25 charge 3+, delta(ppm) -</a:t>
            </a:r>
            <a:r>
              <a:rPr lang="pt-BR" dirty="0" smtClean="0">
                <a:latin typeface="Arial"/>
                <a:cs typeface="Arial"/>
              </a:rPr>
              <a:t>5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1400" y="1905000"/>
            <a:ext cx="2952670" cy="20431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792538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NGP1_HUMAN</a:t>
            </a:r>
            <a:r>
              <a:rPr lang="pt-BR" dirty="0">
                <a:latin typeface="Arial"/>
                <a:cs typeface="Arial"/>
              </a:rPr>
              <a:t>@154: LTDVETQVL</a:t>
            </a:r>
            <a:r>
              <a:rPr lang="pt-BR" u="sng" dirty="0">
                <a:latin typeface="Arial"/>
                <a:cs typeface="Arial"/>
              </a:rPr>
              <a:t>NQT</a:t>
            </a:r>
            <a:r>
              <a:rPr lang="pt-BR" dirty="0">
                <a:latin typeface="Arial"/>
                <a:cs typeface="Arial"/>
              </a:rPr>
              <a:t>SR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03.81, Precursor m/z 802.91 charge 2+, delta(ppm) 2.8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1126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1981203"/>
            <a:ext cx="2342975" cy="1890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4860673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SUMF1_HUMAN</a:t>
            </a:r>
            <a:r>
              <a:rPr lang="pt-BR" dirty="0">
                <a:latin typeface="Arial"/>
                <a:cs typeface="Arial"/>
              </a:rPr>
              <a:t>@141: FV</a:t>
            </a:r>
            <a:r>
              <a:rPr lang="pt-BR" u="sng" dirty="0">
                <a:latin typeface="Arial"/>
                <a:cs typeface="Arial"/>
              </a:rPr>
              <a:t>NST</a:t>
            </a:r>
            <a:r>
              <a:rPr lang="pt-BR" dirty="0">
                <a:latin typeface="Arial"/>
                <a:cs typeface="Arial"/>
              </a:rPr>
              <a:t>GYLTEAEK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58.69, Precursor m/z 730.35 charge 2+, delta(ppm) </a:t>
            </a:r>
            <a:r>
              <a:rPr lang="pt-BR" dirty="0" smtClean="0">
                <a:latin typeface="Arial"/>
                <a:cs typeface="Arial"/>
              </a:rPr>
              <a:t>3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9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025" y="2090739"/>
            <a:ext cx="2771775" cy="2088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553766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CO1_HUMAN</a:t>
            </a:r>
            <a:r>
              <a:rPr lang="pt-BR" dirty="0">
                <a:latin typeface="Arial"/>
                <a:cs typeface="Arial"/>
              </a:rPr>
              <a:t>@216: ADEGSLK</a:t>
            </a:r>
            <a:r>
              <a:rPr lang="pt-BR" u="sng" dirty="0">
                <a:latin typeface="Arial"/>
                <a:cs typeface="Arial"/>
              </a:rPr>
              <a:t>NIS</a:t>
            </a:r>
            <a:r>
              <a:rPr lang="pt-BR" dirty="0">
                <a:latin typeface="Arial"/>
                <a:cs typeface="Arial"/>
              </a:rPr>
              <a:t>IYTK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38.78, Precursor m/z 513.93 charge 3+, delta(ppm) </a:t>
            </a:r>
            <a:r>
              <a:rPr lang="pt-BR" dirty="0" smtClean="0">
                <a:latin typeface="Arial"/>
                <a:cs typeface="Arial"/>
              </a:rPr>
              <a:t>7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0" y="1971675"/>
            <a:ext cx="3729038" cy="2209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277074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CO1_HUMAN</a:t>
            </a:r>
            <a:r>
              <a:rPr lang="pt-BR" dirty="0">
                <a:latin typeface="Arial"/>
                <a:cs typeface="Arial"/>
              </a:rPr>
              <a:t>@337: ISV</a:t>
            </a:r>
            <a:r>
              <a:rPr lang="pt-BR" u="sng" dirty="0">
                <a:latin typeface="Arial"/>
                <a:cs typeface="Arial"/>
              </a:rPr>
              <a:t>NYS</a:t>
            </a:r>
            <a:r>
              <a:rPr lang="pt-BR" dirty="0">
                <a:latin typeface="Arial"/>
                <a:cs typeface="Arial"/>
              </a:rPr>
              <a:t>VR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937.49, Precursor m/z 469.75 charge 2+, delta(ppm) </a:t>
            </a:r>
            <a:r>
              <a:rPr lang="pt-BR" dirty="0" smtClean="0">
                <a:latin typeface="Arial"/>
                <a:cs typeface="Arial"/>
              </a:rPr>
              <a:t>4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6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025" y="2566988"/>
            <a:ext cx="2466975" cy="11971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43933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3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CO1_HUMAN</a:t>
            </a:r>
            <a:r>
              <a:rPr lang="pt-BR" dirty="0">
                <a:latin typeface="Arial"/>
                <a:cs typeface="Arial"/>
              </a:rPr>
              <a:t>@369: M</a:t>
            </a:r>
            <a:r>
              <a:rPr lang="pt-BR" u="sng" dirty="0">
                <a:latin typeface="Arial"/>
                <a:cs typeface="Arial"/>
              </a:rPr>
              <a:t>NDT</a:t>
            </a:r>
            <a:r>
              <a:rPr lang="pt-BR" dirty="0">
                <a:latin typeface="Arial"/>
                <a:cs typeface="Arial"/>
              </a:rPr>
              <a:t>IFGFTMEER_Deamidated(N)@2; Oxidation(M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06.66, Precursor m/z 804.34 charge 2+, delta(ppm) -</a:t>
            </a:r>
            <a:r>
              <a:rPr lang="pt-BR" dirty="0" smtClean="0">
                <a:latin typeface="Arial"/>
                <a:cs typeface="Arial"/>
              </a:rPr>
              <a:t>3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19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98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905000"/>
            <a:ext cx="2911229" cy="2114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680239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CO1_HUMAN</a:t>
            </a:r>
            <a:r>
              <a:rPr lang="pt-BR" dirty="0">
                <a:latin typeface="Arial"/>
                <a:cs typeface="Arial"/>
              </a:rPr>
              <a:t>@137: FQAEIENMEAH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PLTN_Oxidation(M)@8; 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31.885, Precursor m/z 1016.95 charge 2+, delta(ppm) -</a:t>
            </a:r>
            <a:r>
              <a:rPr lang="pt-BR" dirty="0" smtClean="0">
                <a:latin typeface="Arial"/>
                <a:cs typeface="Arial"/>
              </a:rPr>
              <a:t>0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676400"/>
            <a:ext cx="3652837" cy="27449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62381222"/>
      </p:ext>
    </p:extLst>
  </p:cSld>
  <p:clrMapOvr>
    <a:masterClrMapping/>
  </p:clrMapOvr>
</p:sld>
</file>

<file path=ppt/slides/slide1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dirty="0">
                <a:latin typeface="Arial"/>
                <a:cs typeface="Arial"/>
              </a:rPr>
              <a:t>Spectrum </a:t>
            </a:r>
            <a:r>
              <a:rPr lang="pt-BR" dirty="0" smtClean="0">
                <a:latin typeface="Arial"/>
                <a:cs typeface="Arial"/>
              </a:rPr>
              <a:t>14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TIMP1_HUMAN@53: FVGTPEV</a:t>
            </a:r>
            <a:r>
              <a:rPr lang="pt-BR" u="sng" dirty="0">
                <a:latin typeface="Arial"/>
                <a:cs typeface="Arial"/>
              </a:rPr>
              <a:t>NQT</a:t>
            </a:r>
            <a:r>
              <a:rPr lang="pt-BR" dirty="0">
                <a:latin typeface="Arial"/>
                <a:cs typeface="Arial"/>
              </a:rPr>
              <a:t>TLYQR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52.87, Precursor m/z 877.44 charge 2+, delta(ppm) </a:t>
            </a:r>
            <a:r>
              <a:rPr lang="pt-BR" dirty="0" smtClean="0">
                <a:latin typeface="Arial"/>
                <a:cs typeface="Arial"/>
              </a:rPr>
              <a:t>2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0350" y="1900239"/>
            <a:ext cx="2661851" cy="2290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08355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NF13_HUMAN</a:t>
            </a:r>
            <a:r>
              <a:rPr lang="pt-BR" dirty="0">
                <a:latin typeface="Arial"/>
                <a:cs typeface="Arial"/>
              </a:rPr>
              <a:t>@124: QHSVLHLVPI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SK_Gln-&gt;pyro-Glu@N-term; Deamidated(N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26.87, Precursor m/z 814.44 charge 2+, delta(ppm) </a:t>
            </a:r>
            <a:r>
              <a:rPr lang="pt-BR" dirty="0" smtClean="0">
                <a:latin typeface="Arial"/>
                <a:cs typeface="Arial"/>
              </a:rPr>
              <a:t>2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843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1895478"/>
            <a:ext cx="2838450" cy="20945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966395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NR11_HUMAN</a:t>
            </a:r>
            <a:r>
              <a:rPr lang="pt-BR" dirty="0">
                <a:latin typeface="Arial"/>
                <a:cs typeface="Arial"/>
              </a:rPr>
              <a:t>@105: ALVAVVAG</a:t>
            </a:r>
            <a:r>
              <a:rPr lang="pt-BR" u="sng" dirty="0">
                <a:latin typeface="Arial"/>
                <a:cs typeface="Arial"/>
              </a:rPr>
              <a:t>NST</a:t>
            </a:r>
            <a:r>
              <a:rPr lang="pt-BR" dirty="0">
                <a:latin typeface="Arial"/>
                <a:cs typeface="Arial"/>
              </a:rPr>
              <a:t>TPR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55.74, Precursor m/z 678.88 charge 2+, delta(ppm) -</a:t>
            </a:r>
            <a:r>
              <a:rPr lang="pt-BR" dirty="0" smtClean="0">
                <a:latin typeface="Arial"/>
                <a:cs typeface="Arial"/>
              </a:rPr>
              <a:t>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81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13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6022" y="1828800"/>
            <a:ext cx="3430253" cy="2667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304747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4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PP1_HUMAN</a:t>
            </a:r>
            <a:r>
              <a:rPr lang="pt-BR" dirty="0">
                <a:latin typeface="Arial"/>
                <a:cs typeface="Arial"/>
              </a:rPr>
              <a:t>@443: FLSSSPHLPPSSYF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GR_Deamidated(N)@</a:t>
            </a:r>
            <a:r>
              <a:rPr lang="pt-BR" dirty="0" smtClean="0">
                <a:latin typeface="Arial"/>
                <a:cs typeface="Arial"/>
              </a:rPr>
              <a:t>1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50.97, Precursor m/z 684.66 charge 3+, delta(ppm) </a:t>
            </a:r>
            <a:r>
              <a:rPr lang="pt-BR" dirty="0" smtClean="0">
                <a:latin typeface="Arial"/>
                <a:cs typeface="Arial"/>
              </a:rPr>
              <a:t>5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017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0" y="2286000"/>
            <a:ext cx="2981325" cy="27483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362445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4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TRFE_HUMAN@630: QQQHLFGS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DCSG</a:t>
            </a:r>
            <a:r>
              <a:rPr lang="pt-BR" u="sng" dirty="0">
                <a:latin typeface="Arial"/>
                <a:cs typeface="Arial"/>
              </a:rPr>
              <a:t>NFC</a:t>
            </a:r>
            <a:r>
              <a:rPr lang="pt-BR" dirty="0">
                <a:latin typeface="Arial"/>
                <a:cs typeface="Arial"/>
              </a:rPr>
              <a:t>LFR_Gln-&gt;pyro-Glu@N-term; Deamidated(N)@9; Carbamidomethyl(C)@13; Deamidated(N)@16; Carbamidomethyl(C)@</a:t>
            </a:r>
            <a:r>
              <a:rPr lang="pt-BR" dirty="0" smtClean="0">
                <a:latin typeface="Arial"/>
                <a:cs typeface="Arial"/>
              </a:rPr>
              <a:t>1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499.06, Precursor m/z 834.03 charge 3+, delta(ppm) -</a:t>
            </a:r>
            <a:r>
              <a:rPr lang="pt-BR" dirty="0" smtClean="0">
                <a:latin typeface="Arial"/>
                <a:cs typeface="Arial"/>
              </a:rPr>
              <a:t>3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905000"/>
            <a:ext cx="3786187" cy="31449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768238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sz="1300" dirty="0">
                <a:latin typeface="Arial"/>
                <a:cs typeface="Arial"/>
              </a:rPr>
              <a:t>Spectrum </a:t>
            </a:r>
            <a:r>
              <a:rPr lang="pt-BR" sz="1300" dirty="0" smtClean="0">
                <a:latin typeface="Arial"/>
                <a:cs typeface="Arial"/>
              </a:rPr>
              <a:t>14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ANGP1_HUMAN</a:t>
            </a:r>
            <a:r>
              <a:rPr lang="pt-BR" sz="1300" dirty="0">
                <a:latin typeface="Arial"/>
                <a:cs typeface="Arial"/>
              </a:rPr>
              <a:t>@295: DCADVYQAGF</a:t>
            </a:r>
            <a:r>
              <a:rPr lang="pt-BR" sz="1300" u="sng" dirty="0">
                <a:latin typeface="Arial"/>
                <a:cs typeface="Arial"/>
              </a:rPr>
              <a:t>NK</a:t>
            </a:r>
            <a:r>
              <a:rPr lang="pt-BR" sz="1300" dirty="0">
                <a:latin typeface="Arial"/>
                <a:cs typeface="Arial"/>
              </a:rPr>
              <a:t>_Carbamidomethyl(C)@2; Deamidated(N)@</a:t>
            </a:r>
            <a:r>
              <a:rPr lang="pt-BR" sz="1300" dirty="0" smtClean="0">
                <a:latin typeface="Arial"/>
                <a:cs typeface="Arial"/>
              </a:rPr>
              <a:t>11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MW </a:t>
            </a:r>
            <a:r>
              <a:rPr lang="pt-BR" sz="1300" dirty="0">
                <a:latin typeface="Arial"/>
                <a:cs typeface="Arial"/>
              </a:rPr>
              <a:t>1387.57, Precursor m/z 694.79 charge 2+, delta(ppm) 3.2</a:t>
            </a:r>
            <a:br>
              <a:rPr lang="pt-BR" sz="1300" dirty="0">
                <a:latin typeface="Arial"/>
                <a:cs typeface="Arial"/>
              </a:rPr>
            </a:br>
            <a:r>
              <a:rPr lang="en-US" sz="1300" dirty="0" smtClean="0">
                <a:latin typeface="Arial"/>
                <a:cs typeface="Arial"/>
              </a:rPr>
              <a:t/>
            </a:r>
            <a:br>
              <a:rPr lang="en-US" sz="1300" dirty="0" smtClean="0">
                <a:latin typeface="Arial"/>
                <a:cs typeface="Arial"/>
              </a:rPr>
            </a:br>
            <a:endParaRPr lang="en-US" sz="1300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3177" y="2171703"/>
            <a:ext cx="3295978" cy="1928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974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RFL_HUMAN</a:t>
            </a:r>
            <a:r>
              <a:rPr lang="pt-BR" dirty="0">
                <a:latin typeface="Arial"/>
                <a:cs typeface="Arial"/>
              </a:rPr>
              <a:t>@156: PFL</a:t>
            </a:r>
            <a:r>
              <a:rPr lang="pt-BR" u="sng" dirty="0">
                <a:latin typeface="Arial"/>
                <a:cs typeface="Arial"/>
              </a:rPr>
              <a:t>NWT</a:t>
            </a:r>
            <a:r>
              <a:rPr lang="pt-BR" dirty="0">
                <a:latin typeface="Arial"/>
                <a:cs typeface="Arial"/>
              </a:rPr>
              <a:t>GPPEPIEAAVAR_Deamidated(N)</a:t>
            </a:r>
            <a:r>
              <a:rPr lang="pt-BR" dirty="0" smtClean="0">
                <a:latin typeface="Arial"/>
                <a:cs typeface="Arial"/>
              </a:rPr>
              <a:t>@</a:t>
            </a:r>
            <a:r>
              <a:rPr lang="pt-BR" dirty="0">
                <a:latin typeface="Arial"/>
                <a:cs typeface="Arial"/>
              </a:rPr>
              <a:t>4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965, Precursor m/z 983.51 charge 2+, delta(ppm) -</a:t>
            </a:r>
            <a:r>
              <a:rPr lang="pt-BR" dirty="0" smtClean="0">
                <a:latin typeface="Arial"/>
                <a:cs typeface="Arial"/>
              </a:rPr>
              <a:t>2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355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0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1752600"/>
            <a:ext cx="2847975" cy="29090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484083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7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RFL_HUMAN</a:t>
            </a:r>
            <a:r>
              <a:rPr lang="pt-BR" dirty="0">
                <a:latin typeface="Arial"/>
                <a:cs typeface="Arial"/>
              </a:rPr>
              <a:t>@497: TAGWNIPMGLLF</a:t>
            </a:r>
            <a:r>
              <a:rPr lang="pt-BR" u="sng" dirty="0">
                <a:latin typeface="Arial"/>
                <a:cs typeface="Arial"/>
              </a:rPr>
              <a:t>NQT</a:t>
            </a:r>
            <a:r>
              <a:rPr lang="pt-BR" dirty="0">
                <a:latin typeface="Arial"/>
                <a:cs typeface="Arial"/>
              </a:rPr>
              <a:t>GSCK_Deamidated(N)@13; Carbamidomethyl(C)@</a:t>
            </a:r>
            <a:r>
              <a:rPr lang="pt-BR" dirty="0" smtClean="0">
                <a:latin typeface="Arial"/>
                <a:cs typeface="Arial"/>
              </a:rPr>
              <a:t>1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94.987, Precursor m/z 1048.5 charge 2+, delta(ppm) </a:t>
            </a:r>
            <a:r>
              <a:rPr lang="pt-BR" dirty="0" smtClean="0">
                <a:latin typeface="Arial"/>
                <a:cs typeface="Arial"/>
              </a:rPr>
              <a:t>0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47031"/>
            <a:ext cx="8229600" cy="423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4600" y="2438400"/>
            <a:ext cx="2703413" cy="2366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124200" y="3886200"/>
            <a:ext cx="243978" cy="24622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?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8208695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7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RFL_HUMAN</a:t>
            </a:r>
            <a:r>
              <a:rPr lang="pt-BR" dirty="0">
                <a:latin typeface="Arial"/>
                <a:cs typeface="Arial"/>
              </a:rPr>
              <a:t>@497: GLLF</a:t>
            </a:r>
            <a:r>
              <a:rPr lang="pt-BR" u="sng" dirty="0">
                <a:latin typeface="Arial"/>
                <a:cs typeface="Arial"/>
              </a:rPr>
              <a:t>NQT</a:t>
            </a:r>
            <a:r>
              <a:rPr lang="pt-BR" dirty="0">
                <a:latin typeface="Arial"/>
                <a:cs typeface="Arial"/>
              </a:rPr>
              <a:t>GSCK_Deamidated(N)@5; Carbamidomethyl(C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24.58, Precursor m/z 613.3 charge 2+, delta(ppm) -</a:t>
            </a:r>
            <a:r>
              <a:rPr lang="pt-BR" dirty="0" smtClean="0">
                <a:latin typeface="Arial"/>
                <a:cs typeface="Arial"/>
              </a:rPr>
              <a:t>4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25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32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2075" y="2281239"/>
            <a:ext cx="3362325" cy="18047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607309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RFL_HUMAN</a:t>
            </a:r>
            <a:r>
              <a:rPr lang="pt-BR" dirty="0">
                <a:latin typeface="Arial"/>
                <a:cs typeface="Arial"/>
              </a:rPr>
              <a:t>@642: </a:t>
            </a:r>
            <a:r>
              <a:rPr lang="pt-BR" u="sng" dirty="0">
                <a:latin typeface="Arial"/>
                <a:cs typeface="Arial"/>
              </a:rPr>
              <a:t>NGS</a:t>
            </a:r>
            <a:r>
              <a:rPr lang="pt-BR" dirty="0">
                <a:latin typeface="Arial"/>
                <a:cs typeface="Arial"/>
              </a:rPr>
              <a:t>DCPDKFCLFQSETK_Deamidated(N)@1; Carbamidomethyl(C)@5; Carbamidomethyl(C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32.851, Precursor m/z 678.62 charge 3+, delta(ppm) 6.1</a:t>
            </a: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0" y="1905000"/>
            <a:ext cx="3890962" cy="26049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1311579"/>
      </p:ext>
    </p:extLst>
  </p:cSld>
  <p:clrMapOvr>
    <a:masterClrMapping/>
  </p:clrMapOvr>
</p:sld>
</file>

<file path=ppt/slides/slide1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4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SP1_HUMAN</a:t>
            </a:r>
            <a:r>
              <a:rPr lang="pt-BR" dirty="0">
                <a:latin typeface="Arial"/>
                <a:cs typeface="Arial"/>
              </a:rPr>
              <a:t>@1067: VV</a:t>
            </a:r>
            <a:r>
              <a:rPr lang="pt-BR" u="sng" dirty="0">
                <a:latin typeface="Arial"/>
                <a:cs typeface="Arial"/>
              </a:rPr>
              <a:t>NST</a:t>
            </a:r>
            <a:r>
              <a:rPr lang="pt-BR" dirty="0">
                <a:latin typeface="Arial"/>
                <a:cs typeface="Arial"/>
              </a:rPr>
              <a:t>TGPGEHLR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66.685, Precursor m/z 684.35 charge 2+, delta(ppm) -</a:t>
            </a:r>
            <a:r>
              <a:rPr lang="pt-BR" dirty="0" smtClean="0">
                <a:latin typeface="Arial"/>
                <a:cs typeface="Arial"/>
              </a:rPr>
              <a:t>0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47031"/>
            <a:ext cx="8229600" cy="423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981200"/>
            <a:ext cx="3298400" cy="2114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940066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TTC17_HUMAN</a:t>
            </a:r>
            <a:r>
              <a:rPr lang="pt-BR" dirty="0">
                <a:latin typeface="Arial"/>
                <a:cs typeface="Arial"/>
              </a:rPr>
              <a:t>@184: V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APLLP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051.63, Precursor m/z 526.82 charge 2+, delta(ppm) </a:t>
            </a:r>
            <a:r>
              <a:rPr lang="pt-BR" dirty="0" smtClean="0">
                <a:latin typeface="Arial"/>
                <a:cs typeface="Arial"/>
              </a:rPr>
              <a:t>4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42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1486600"/>
            <a:ext cx="2771775" cy="16422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675546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46237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VTNC_HUMAN</a:t>
            </a:r>
            <a:r>
              <a:rPr lang="pt-BR" dirty="0">
                <a:latin typeface="Arial"/>
                <a:cs typeface="Arial"/>
              </a:rPr>
              <a:t>@86: N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VHEQVGGPSLTSDLQAQS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381.146, Precursor m/z 794.72 charge 3+, delta(ppm) </a:t>
            </a:r>
            <a:r>
              <a:rPr lang="pt-BR" dirty="0" smtClean="0">
                <a:latin typeface="Arial"/>
                <a:cs typeface="Arial"/>
              </a:rPr>
              <a:t>3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676400"/>
            <a:ext cx="3167062" cy="33468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461120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VTNC_HUMAN</a:t>
            </a:r>
            <a:r>
              <a:rPr lang="pt-BR" dirty="0">
                <a:latin typeface="Arial"/>
                <a:cs typeface="Arial"/>
              </a:rPr>
              <a:t>@242: NISDGFDGIPD</a:t>
            </a:r>
            <a:r>
              <a:rPr lang="pt-BR" u="sng" dirty="0">
                <a:latin typeface="Arial"/>
                <a:cs typeface="Arial"/>
              </a:rPr>
              <a:t>NVD</a:t>
            </a:r>
            <a:r>
              <a:rPr lang="pt-BR" dirty="0">
                <a:latin typeface="Arial"/>
                <a:cs typeface="Arial"/>
              </a:rPr>
              <a:t>AALALPAHSYSGR_Deamidated(N)@1; 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773.284, Precursor m/z 925.44 charge 3+, delta(ppm) -5.4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VTNC_HUMAN@1: </a:t>
            </a:r>
            <a:r>
              <a:rPr lang="en-US" u="sng" dirty="0" err="1">
                <a:latin typeface="Arial"/>
                <a:cs typeface="Arial"/>
              </a:rPr>
              <a:t>NIS</a:t>
            </a:r>
            <a:r>
              <a:rPr lang="en-US" dirty="0" err="1">
                <a:latin typeface="Arial"/>
                <a:cs typeface="Arial"/>
              </a:rPr>
              <a:t>DGFDGIPDNVDAALALPAHSYSGR|Modifications</a:t>
            </a:r>
            <a:r>
              <a:rPr lang="en-US" dirty="0">
                <a:latin typeface="Arial"/>
                <a:cs typeface="Arial"/>
              </a:rPr>
              <a:t>: </a:t>
            </a:r>
            <a:r>
              <a:rPr lang="en-US" dirty="0" err="1">
                <a:latin typeface="Arial"/>
                <a:cs typeface="Arial"/>
              </a:rPr>
              <a:t>Deamidated</a:t>
            </a:r>
            <a:r>
              <a:rPr lang="en-US" dirty="0">
                <a:latin typeface="Arial"/>
                <a:cs typeface="Arial"/>
              </a:rPr>
              <a:t>(N)@</a:t>
            </a:r>
            <a:r>
              <a:rPr lang="en-US" dirty="0" smtClean="0">
                <a:latin typeface="Arial"/>
                <a:cs typeface="Arial"/>
              </a:rPr>
              <a:t>1</a:t>
            </a:r>
            <a:r>
              <a:rPr lang="en-US" dirty="0">
                <a:latin typeface="Arial"/>
                <a:cs typeface="Arial"/>
              </a:rPr>
              <a:t/>
            </a:r>
            <a:br>
              <a:rPr lang="en-US" dirty="0">
                <a:latin typeface="Arial"/>
                <a:cs typeface="Arial"/>
              </a:rPr>
            </a:br>
            <a:r>
              <a:rPr lang="en-US" dirty="0" err="1" smtClean="0">
                <a:latin typeface="Arial"/>
                <a:cs typeface="Arial"/>
              </a:rPr>
              <a:t>Prec</a:t>
            </a:r>
            <a:r>
              <a:rPr lang="en-US" dirty="0" smtClean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MW: </a:t>
            </a:r>
            <a:r>
              <a:rPr lang="en-US" dirty="0" smtClean="0">
                <a:latin typeface="Arial"/>
                <a:cs typeface="Arial"/>
              </a:rPr>
              <a:t>2772.3|Prec </a:t>
            </a:r>
            <a:r>
              <a:rPr lang="en-US" dirty="0">
                <a:latin typeface="Arial"/>
                <a:cs typeface="Arial"/>
              </a:rPr>
              <a:t>m/z: </a:t>
            </a:r>
            <a:r>
              <a:rPr lang="en-US" dirty="0" smtClean="0">
                <a:latin typeface="Arial"/>
                <a:cs typeface="Arial"/>
              </a:rPr>
              <a:t>925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.11</a:t>
            </a:r>
            <a:r>
              <a:rPr lang="en-US" dirty="0" smtClean="0">
                <a:latin typeface="Arial"/>
                <a:cs typeface="Arial"/>
              </a:rPr>
              <a:t>|Delta </a:t>
            </a:r>
            <a:r>
              <a:rPr lang="en-US" dirty="0">
                <a:latin typeface="Arial"/>
                <a:cs typeface="Arial"/>
              </a:rPr>
              <a:t>(ppm): </a:t>
            </a:r>
            <a:r>
              <a:rPr lang="en-US" dirty="0" smtClean="0">
                <a:latin typeface="Arial"/>
                <a:cs typeface="Arial"/>
              </a:rPr>
              <a:t>7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3315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981200"/>
            <a:ext cx="3128962" cy="32380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29506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5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WFDC2_HUMAN</a:t>
            </a:r>
            <a:r>
              <a:rPr lang="pt-BR" dirty="0">
                <a:latin typeface="Arial"/>
                <a:cs typeface="Arial"/>
              </a:rPr>
              <a:t>@44: TGVCPELQADQ</a:t>
            </a:r>
            <a:r>
              <a:rPr lang="pt-BR" u="sng" dirty="0">
                <a:latin typeface="Arial"/>
                <a:cs typeface="Arial"/>
              </a:rPr>
              <a:t>NCT</a:t>
            </a:r>
            <a:r>
              <a:rPr lang="pt-BR" dirty="0">
                <a:latin typeface="Arial"/>
                <a:cs typeface="Arial"/>
              </a:rPr>
              <a:t>QECVSDSECADNLK_Carbamidomethyl(C)@4; Deamidated(N)@12; Carbamidomethyl(C)@13; Carbamidomethyl(C)@17; Carbamidomethyl(C)@23@44_MW 3228.296, Precursor m/z 1077.11 charge 3+, delta(ppm) -</a:t>
            </a:r>
            <a:r>
              <a:rPr lang="pt-BR" dirty="0" smtClean="0">
                <a:latin typeface="Arial"/>
                <a:cs typeface="Arial"/>
              </a:rPr>
              <a:t>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3315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1600200"/>
            <a:ext cx="2636236" cy="274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387345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4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ZA2G_HUMAN</a:t>
            </a:r>
            <a:r>
              <a:rPr lang="pt-BR" dirty="0">
                <a:latin typeface="Arial"/>
                <a:cs typeface="Arial"/>
              </a:rPr>
              <a:t>@109: DIVEYYNDS</a:t>
            </a:r>
            <a:r>
              <a:rPr lang="pt-BR" u="sng" dirty="0">
                <a:latin typeface="Arial"/>
                <a:cs typeface="Arial"/>
              </a:rPr>
              <a:t>NGS</a:t>
            </a:r>
            <a:r>
              <a:rPr lang="pt-BR" dirty="0">
                <a:latin typeface="Arial"/>
                <a:cs typeface="Arial"/>
              </a:rPr>
              <a:t>HVLQGR_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65.93, Precursor m/z 1033.97 charge 2+, delta(ppm) </a:t>
            </a:r>
            <a:r>
              <a:rPr lang="pt-BR" dirty="0" smtClean="0">
                <a:latin typeface="Arial"/>
                <a:cs typeface="Arial"/>
              </a:rPr>
              <a:t>2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83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37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0" y="1371600"/>
            <a:ext cx="3238500" cy="27331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040908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sz="1300" dirty="0">
                <a:latin typeface="Arial"/>
                <a:cs typeface="Arial"/>
              </a:rPr>
              <a:t>Spectrum </a:t>
            </a:r>
            <a:r>
              <a:rPr lang="pt-BR" sz="1300" dirty="0" smtClean="0">
                <a:latin typeface="Arial"/>
                <a:cs typeface="Arial"/>
              </a:rPr>
              <a:t>15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APOD_HUMAN</a:t>
            </a:r>
            <a:r>
              <a:rPr lang="pt-BR" sz="1300" dirty="0">
                <a:latin typeface="Arial"/>
                <a:cs typeface="Arial"/>
              </a:rPr>
              <a:t>@98: ADGTVNQIEGEATPV</a:t>
            </a:r>
            <a:r>
              <a:rPr lang="pt-BR" sz="1300" u="sng" dirty="0">
                <a:latin typeface="Arial"/>
                <a:cs typeface="Arial"/>
              </a:rPr>
              <a:t>NLT</a:t>
            </a:r>
            <a:r>
              <a:rPr lang="pt-BR" sz="1300" dirty="0">
                <a:latin typeface="Arial"/>
                <a:cs typeface="Arial"/>
              </a:rPr>
              <a:t>EPAKLEVK_Deamidated(N)@</a:t>
            </a:r>
            <a:r>
              <a:rPr lang="pt-BR" sz="1300" dirty="0" smtClean="0">
                <a:latin typeface="Arial"/>
                <a:cs typeface="Arial"/>
              </a:rPr>
              <a:t>16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MW </a:t>
            </a:r>
            <a:r>
              <a:rPr lang="pt-BR" sz="1300" dirty="0">
                <a:latin typeface="Arial"/>
                <a:cs typeface="Arial"/>
              </a:rPr>
              <a:t>2723.387, Precursor m/z 908.81 charge 3+, delta(ppm) -7.9</a:t>
            </a:r>
            <a:br>
              <a:rPr lang="pt-BR" sz="1300" dirty="0">
                <a:latin typeface="Arial"/>
                <a:cs typeface="Arial"/>
              </a:rPr>
            </a:br>
            <a:r>
              <a:rPr lang="en-US" sz="1300" dirty="0" smtClean="0">
                <a:latin typeface="Arial"/>
                <a:cs typeface="Arial"/>
              </a:rPr>
              <a:t/>
            </a:r>
            <a:br>
              <a:rPr lang="en-US" sz="1300" dirty="0" smtClean="0">
                <a:latin typeface="Arial"/>
                <a:cs typeface="Arial"/>
              </a:rPr>
            </a:br>
            <a:endParaRPr lang="en-US" sz="1300" dirty="0">
              <a:latin typeface="Arial"/>
              <a:cs typeface="Arial"/>
            </a:endParaRPr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6741" y="1524000"/>
            <a:ext cx="3157537" cy="36469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816654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4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ZA2G_HUMAN</a:t>
            </a:r>
            <a:r>
              <a:rPr lang="pt-BR" dirty="0">
                <a:latin typeface="Arial"/>
                <a:cs typeface="Arial"/>
              </a:rPr>
              <a:t>@109: DIVEYYNDS</a:t>
            </a:r>
            <a:r>
              <a:rPr lang="pt-BR" u="sng" dirty="0">
                <a:latin typeface="Arial"/>
                <a:cs typeface="Arial"/>
              </a:rPr>
              <a:t>NGS</a:t>
            </a:r>
            <a:r>
              <a:rPr lang="pt-BR" dirty="0">
                <a:latin typeface="Arial"/>
                <a:cs typeface="Arial"/>
              </a:rPr>
              <a:t>HVLQGR_Deamidated(N)@7; Ammonia-loss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48.91, Precursor m/z 1025.46 charge 2+, delta(ppm) </a:t>
            </a:r>
            <a:r>
              <a:rPr lang="pt-BR" dirty="0" smtClean="0">
                <a:latin typeface="Arial"/>
                <a:cs typeface="Arial"/>
              </a:rPr>
              <a:t>2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04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41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1514477"/>
            <a:ext cx="2799737" cy="2381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375463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4c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ZA2G_HUMAN</a:t>
            </a:r>
            <a:r>
              <a:rPr lang="pt-BR" dirty="0">
                <a:latin typeface="Arial"/>
                <a:cs typeface="Arial"/>
              </a:rPr>
              <a:t>@109: DIVEYY</a:t>
            </a:r>
            <a:r>
              <a:rPr lang="pt-BR" u="sng" dirty="0">
                <a:latin typeface="Arial"/>
                <a:cs typeface="Arial"/>
              </a:rPr>
              <a:t>NDSNGS</a:t>
            </a:r>
            <a:r>
              <a:rPr lang="pt-BR" dirty="0">
                <a:latin typeface="Arial"/>
                <a:cs typeface="Arial"/>
              </a:rPr>
              <a:t>H_Deamidated(N)@7; 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13.58, Precursor m/z 757.8 charge 2+, delta(ppm) -</a:t>
            </a:r>
            <a:r>
              <a:rPr lang="pt-BR" dirty="0" smtClean="0">
                <a:latin typeface="Arial"/>
                <a:cs typeface="Arial"/>
              </a:rPr>
              <a:t>3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47031"/>
            <a:ext cx="8229600" cy="423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1752600"/>
            <a:ext cx="2427869" cy="1809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263415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4d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ZA2G_HUMAN</a:t>
            </a:r>
            <a:r>
              <a:rPr lang="pt-BR" dirty="0">
                <a:latin typeface="Arial"/>
                <a:cs typeface="Arial"/>
              </a:rPr>
              <a:t>@109: EYY</a:t>
            </a:r>
            <a:r>
              <a:rPr lang="pt-BR" u="sng" dirty="0">
                <a:latin typeface="Arial"/>
                <a:cs typeface="Arial"/>
              </a:rPr>
              <a:t>NDSNGS</a:t>
            </a:r>
            <a:r>
              <a:rPr lang="pt-BR" dirty="0">
                <a:latin typeface="Arial"/>
                <a:cs typeface="Arial"/>
              </a:rPr>
              <a:t>HVLQGR_Deamidated(N)@4; 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39.739, Precursor m/z 870.87 charge 2+, delta(ppm) </a:t>
            </a:r>
            <a:r>
              <a:rPr lang="pt-BR" dirty="0" smtClean="0">
                <a:latin typeface="Arial"/>
                <a:cs typeface="Arial"/>
              </a:rPr>
              <a:t>7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47031"/>
            <a:ext cx="8229600" cy="423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2057400"/>
            <a:ext cx="2943284" cy="2152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97537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ZA2G_HUMAN</a:t>
            </a:r>
            <a:r>
              <a:rPr lang="pt-BR" dirty="0">
                <a:latin typeface="Arial"/>
                <a:cs typeface="Arial"/>
              </a:rPr>
              <a:t>@128: FGCEIE</a:t>
            </a:r>
            <a:r>
              <a:rPr lang="pt-BR" u="sng" dirty="0">
                <a:latin typeface="Arial"/>
                <a:cs typeface="Arial"/>
              </a:rPr>
              <a:t>NNR</a:t>
            </a:r>
            <a:r>
              <a:rPr lang="pt-BR" dirty="0">
                <a:latin typeface="Arial"/>
                <a:cs typeface="Arial"/>
              </a:rPr>
              <a:t>_Carbamidomethyl(C)@3; 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38.47, Precursor m/z 570.24 charge 2+, delta(ppm) </a:t>
            </a:r>
            <a:r>
              <a:rPr lang="pt-BR" dirty="0" smtClean="0">
                <a:latin typeface="Arial"/>
                <a:cs typeface="Arial"/>
              </a:rPr>
              <a:t>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07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4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0" y="1905000"/>
            <a:ext cx="3736454" cy="167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59411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15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ZA2G_HUMAN</a:t>
            </a:r>
            <a:r>
              <a:rPr lang="pt-BR" dirty="0">
                <a:latin typeface="Arial"/>
                <a:cs typeface="Arial"/>
              </a:rPr>
              <a:t>@259: GDVLH</a:t>
            </a:r>
            <a:r>
              <a:rPr lang="pt-BR" u="sng" dirty="0">
                <a:latin typeface="Arial"/>
                <a:cs typeface="Arial"/>
              </a:rPr>
              <a:t>NGNGTY</a:t>
            </a:r>
            <a:r>
              <a:rPr lang="pt-BR" dirty="0">
                <a:latin typeface="Arial"/>
                <a:cs typeface="Arial"/>
              </a:rPr>
              <a:t>QSWVVVAVPPQDTAPYSCHVQ_Carbamidomethyl(C)@29, Deamidated(N)@6; 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496.6, Precursor m/z 1166.54 charge 3+, delta(ppm) </a:t>
            </a:r>
            <a:r>
              <a:rPr lang="pt-BR" dirty="0" smtClean="0">
                <a:latin typeface="Arial"/>
                <a:cs typeface="Arial"/>
              </a:rPr>
              <a:t>0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53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1447800"/>
            <a:ext cx="3790950" cy="39666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7195498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POH_HUMAN</a:t>
            </a:r>
            <a:r>
              <a:rPr lang="pt-BR" dirty="0">
                <a:latin typeface="Arial"/>
                <a:cs typeface="Arial"/>
              </a:rPr>
              <a:t>@162: VYKPSAG</a:t>
            </a:r>
            <a:r>
              <a:rPr lang="pt-BR" u="sng" dirty="0">
                <a:latin typeface="Arial"/>
                <a:cs typeface="Arial"/>
              </a:rPr>
              <a:t>NNS</a:t>
            </a:r>
            <a:r>
              <a:rPr lang="pt-BR" dirty="0">
                <a:latin typeface="Arial"/>
                <a:cs typeface="Arial"/>
              </a:rPr>
              <a:t>LYR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68.732, Precursor m/z 490.58 charge 3+, delta(ppm) </a:t>
            </a:r>
            <a:r>
              <a:rPr lang="pt-BR" dirty="0" smtClean="0">
                <a:latin typeface="Arial"/>
                <a:cs typeface="Arial"/>
              </a:rPr>
              <a:t>8.7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2252" y="1965325"/>
            <a:ext cx="4059155" cy="2682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5387746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Spectrum 1 </a:t>
            </a:r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4F2_HUMAN@424</a:t>
            </a:r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: SLVTQYL</a:t>
            </a:r>
            <a:r>
              <a:rPr lang="pt-BR" u="sng" dirty="0">
                <a:latin typeface="Arial" panose="020B0604020202020204" pitchFamily="34" charset="0"/>
                <a:cs typeface="Arial" panose="020B0604020202020204" pitchFamily="34" charset="0"/>
              </a:rPr>
              <a:t>NAT</a:t>
            </a:r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GNR_Deamidated(N)@</a:t>
            </a:r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b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pt-BR" dirty="0" smtClean="0">
                <a:latin typeface="Arial" panose="020B0604020202020204" pitchFamily="34" charset="0"/>
                <a:cs typeface="Arial" panose="020B0604020202020204" pitchFamily="34" charset="0"/>
              </a:rPr>
              <a:t>MW </a:t>
            </a:r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1436.73, Precursor m/z 719.37 charge 2+, delta(ppm) 3.1</a:t>
            </a:r>
            <a:b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4800" y="1752600"/>
            <a:ext cx="2847975" cy="2145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580283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SAH1_HUMAN</a:t>
            </a:r>
            <a:r>
              <a:rPr lang="pt-BR" dirty="0">
                <a:latin typeface="Arial"/>
                <a:cs typeface="Arial"/>
              </a:rPr>
              <a:t>@259: TVLE</a:t>
            </a:r>
            <a:r>
              <a:rPr lang="pt-BR" u="sng" dirty="0">
                <a:latin typeface="Arial"/>
                <a:cs typeface="Arial"/>
              </a:rPr>
              <a:t>NST</a:t>
            </a:r>
            <a:r>
              <a:rPr lang="pt-BR" dirty="0">
                <a:latin typeface="Arial"/>
                <a:cs typeface="Arial"/>
              </a:rPr>
              <a:t>SYEEAK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70.673, Precursor m/z 736.34 charge 2+, delta(ppm) </a:t>
            </a:r>
            <a:r>
              <a:rPr lang="pt-BR" dirty="0" smtClean="0">
                <a:latin typeface="Arial"/>
                <a:cs typeface="Arial"/>
              </a:rPr>
              <a:t>4.8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676400"/>
            <a:ext cx="3226426" cy="190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333576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TRN_HUMAN</a:t>
            </a:r>
            <a:r>
              <a:rPr lang="pt-BR" dirty="0">
                <a:latin typeface="Arial"/>
                <a:cs typeface="Arial"/>
              </a:rPr>
              <a:t>@416: IDSTG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NELR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18.64, Precursor m/z 660.33 charge 2+, delta(ppm) -</a:t>
            </a:r>
            <a:r>
              <a:rPr lang="pt-BR" dirty="0" smtClean="0">
                <a:latin typeface="Arial"/>
                <a:cs typeface="Arial"/>
              </a:rPr>
              <a:t>4.1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133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905000"/>
            <a:ext cx="2895600" cy="20261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292911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9a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PIA2_HUMAN</a:t>
            </a:r>
            <a:r>
              <a:rPr lang="pt-BR" dirty="0">
                <a:latin typeface="Arial"/>
                <a:cs typeface="Arial"/>
              </a:rPr>
              <a:t>@124|132: GL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FPVTA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VAGPIIGQIINLK_Deamidated(N)@3; Deamidated(N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650.495, Precursor m/z 884.51 charge 3+, delta(ppm) -5.1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153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1865159"/>
            <a:ext cx="2181225" cy="30116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942788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9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PIA2_HUMAN</a:t>
            </a:r>
            <a:r>
              <a:rPr lang="pt-BR" dirty="0">
                <a:latin typeface="Arial"/>
                <a:cs typeface="Arial"/>
              </a:rPr>
              <a:t>@124|132: GL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FPVTA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_Deamidated(N)@3; Deamidated(N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33.677, Precursor m/z 667.85 charge 2+, delta(ppm) -6.7</a:t>
            </a:r>
            <a:br>
              <a:rPr lang="pt-BR" dirty="0">
                <a:latin typeface="Arial"/>
                <a:cs typeface="Arial"/>
              </a:rPr>
            </a:b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143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4178" y="1600200"/>
            <a:ext cx="5595644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1828800"/>
            <a:ext cx="2824162" cy="21198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44129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19c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PIA2_HUMAN</a:t>
            </a:r>
            <a:r>
              <a:rPr lang="pt-BR" dirty="0">
                <a:latin typeface="Arial"/>
                <a:cs typeface="Arial"/>
              </a:rPr>
              <a:t>@132: TANVTVAGPIIGQIINLK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22.057, Precursor m/z 912.03 charge 2+, delta(ppm) </a:t>
            </a:r>
            <a:r>
              <a:rPr lang="pt-BR" dirty="0" smtClean="0">
                <a:latin typeface="Arial"/>
                <a:cs typeface="Arial"/>
              </a:rPr>
              <a:t>6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4178" y="1600200"/>
            <a:ext cx="5595644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609725"/>
            <a:ext cx="2819400" cy="22508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721778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PIB2_HUMAN</a:t>
            </a:r>
            <a:r>
              <a:rPr lang="pt-BR" dirty="0">
                <a:latin typeface="Arial"/>
                <a:cs typeface="Arial"/>
              </a:rPr>
              <a:t>@96: LLAAA</a:t>
            </a:r>
            <a:r>
              <a:rPr lang="pt-BR" u="sng" dirty="0">
                <a:latin typeface="Arial"/>
                <a:cs typeface="Arial"/>
              </a:rPr>
              <a:t>NFT</a:t>
            </a:r>
            <a:r>
              <a:rPr lang="pt-BR" dirty="0">
                <a:latin typeface="Arial"/>
                <a:cs typeface="Arial"/>
              </a:rPr>
              <a:t>F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095.597, Precursor m/z 548.81 charge 2+, delta(ppm) -</a:t>
            </a:r>
            <a:r>
              <a:rPr lang="pt-BR" dirty="0" smtClean="0">
                <a:latin typeface="Arial"/>
                <a:cs typeface="Arial"/>
              </a:rPr>
              <a:t>8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6400" y="1905000"/>
            <a:ext cx="3057759" cy="2000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728057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PIB2_HUMAN</a:t>
            </a:r>
            <a:r>
              <a:rPr lang="pt-BR" dirty="0">
                <a:latin typeface="Arial"/>
                <a:cs typeface="Arial"/>
              </a:rPr>
              <a:t>@293: SDDNLL</a:t>
            </a:r>
            <a:r>
              <a:rPr lang="pt-BR" u="sng" dirty="0">
                <a:latin typeface="Arial"/>
                <a:cs typeface="Arial"/>
              </a:rPr>
              <a:t>NTS</a:t>
            </a:r>
            <a:r>
              <a:rPr lang="pt-BR" dirty="0">
                <a:latin typeface="Arial"/>
                <a:cs typeface="Arial"/>
              </a:rPr>
              <a:t>ALGR_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75.66, Precursor m/z 688.84 charge 2+, delta(ppm) -</a:t>
            </a:r>
            <a:r>
              <a:rPr lang="pt-BR" dirty="0" smtClean="0">
                <a:latin typeface="Arial"/>
                <a:cs typeface="Arial"/>
              </a:rPr>
              <a:t>3.9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174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1" name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2095501"/>
            <a:ext cx="2695575" cy="20307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535688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PIB2_HUMAN</a:t>
            </a:r>
            <a:r>
              <a:rPr lang="pt-BR" dirty="0">
                <a:latin typeface="Arial"/>
                <a:cs typeface="Arial"/>
              </a:rPr>
              <a:t>@332: LGATPVAMLHTN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LR_Deamidated(N)@</a:t>
            </a:r>
            <a:r>
              <a:rPr lang="pt-BR" dirty="0" smtClean="0">
                <a:latin typeface="Arial"/>
                <a:cs typeface="Arial"/>
              </a:rPr>
              <a:t>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79.931, Precursor m/z 890.97 charge 2+, delta(ppm) 2.6</a:t>
            </a:r>
            <a:br>
              <a:rPr lang="pt-BR" dirty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2150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1905000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50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724025"/>
            <a:ext cx="3005137" cy="2404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262664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BTD_HUMAN</a:t>
            </a:r>
            <a:r>
              <a:rPr lang="pt-BR" dirty="0">
                <a:latin typeface="Arial"/>
                <a:cs typeface="Arial"/>
              </a:rPr>
              <a:t>@150: F</a:t>
            </a:r>
            <a:r>
              <a:rPr lang="pt-BR" u="sng" dirty="0">
                <a:latin typeface="Arial"/>
                <a:cs typeface="Arial"/>
              </a:rPr>
              <a:t>NDT</a:t>
            </a:r>
            <a:r>
              <a:rPr lang="pt-BR" dirty="0">
                <a:latin typeface="Arial"/>
                <a:cs typeface="Arial"/>
              </a:rPr>
              <a:t>EVLQR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21.54, Precursor m/z 561.78 charge 2+, delta(ppm) -</a:t>
            </a:r>
            <a:r>
              <a:rPr lang="pt-BR" dirty="0" smtClean="0">
                <a:latin typeface="Arial"/>
                <a:cs typeface="Arial"/>
              </a:rPr>
              <a:t>4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945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0" y="1600200"/>
            <a:ext cx="2924175" cy="1575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786106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BTD_HUMAN@349: NPVGLIGAE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GETDPSHSK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93.99, Precursor m/z 1048 charge 2+, delta(ppm) </a:t>
            </a:r>
            <a:r>
              <a:rPr lang="pt-BR" dirty="0" smtClean="0">
                <a:latin typeface="Arial"/>
                <a:cs typeface="Arial"/>
              </a:rPr>
              <a:t>2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457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9600" y="1447800"/>
            <a:ext cx="3124200" cy="31672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797541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A1AT_HUMAN@107: ADTHDEILEGLNF</a:t>
            </a:r>
            <a:r>
              <a:rPr lang="pt-BR" u="sng" dirty="0">
                <a:latin typeface="Arial"/>
                <a:cs typeface="Arial"/>
              </a:rPr>
              <a:t>NLT</a:t>
            </a:r>
            <a:r>
              <a:rPr lang="pt-BR" dirty="0">
                <a:latin typeface="Arial"/>
                <a:cs typeface="Arial"/>
              </a:rPr>
              <a:t>EIPEAQIHEGFQELLR_Deamidated(N)@</a:t>
            </a:r>
            <a:r>
              <a:rPr lang="pt-BR" dirty="0" smtClean="0">
                <a:latin typeface="Arial"/>
                <a:cs typeface="Arial"/>
              </a:rPr>
              <a:t>1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691.801, Precursor m/z 923.95 charge 4+, delta(ppm) 8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800" y="1447800"/>
            <a:ext cx="2452687" cy="37269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171369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C1QT3_HUMAN@71: TGTVD</a:t>
            </a:r>
            <a:r>
              <a:rPr lang="pt-BR" u="sng" dirty="0">
                <a:latin typeface="Arial"/>
                <a:cs typeface="Arial"/>
              </a:rPr>
              <a:t>NNT</a:t>
            </a:r>
            <a:r>
              <a:rPr lang="pt-BR" dirty="0">
                <a:latin typeface="Arial"/>
                <a:cs typeface="Arial"/>
              </a:rPr>
              <a:t>STDL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65.63, Precursor m/z 683.82 charge 2+, delta(ppm) </a:t>
            </a:r>
            <a:r>
              <a:rPr lang="pt-BR" dirty="0" smtClean="0">
                <a:latin typeface="Arial"/>
                <a:cs typeface="Arial"/>
              </a:rPr>
              <a:t>3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66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9812" y="1905000"/>
            <a:ext cx="3038475" cy="22530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082813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5a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1QT3_HUMAN</a:t>
            </a:r>
            <a:r>
              <a:rPr lang="pt-BR" dirty="0">
                <a:latin typeface="Arial"/>
                <a:cs typeface="Arial"/>
              </a:rPr>
              <a:t>@70|71: TGTVD</a:t>
            </a:r>
            <a:r>
              <a:rPr lang="pt-BR" u="sng" dirty="0">
                <a:latin typeface="Arial"/>
                <a:cs typeface="Arial"/>
              </a:rPr>
              <a:t>NNTST</a:t>
            </a:r>
            <a:r>
              <a:rPr lang="pt-BR" dirty="0">
                <a:latin typeface="Arial"/>
                <a:cs typeface="Arial"/>
              </a:rPr>
              <a:t>DLK_Deamidated(N)@6; 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66.61, Precursor m/z 684.31 charge 2+, delta(ppm) </a:t>
            </a:r>
            <a:r>
              <a:rPr lang="pt-BR" dirty="0" smtClean="0">
                <a:latin typeface="Arial"/>
                <a:cs typeface="Arial"/>
              </a:rPr>
              <a:t>3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8493" y="1981200"/>
            <a:ext cx="2878010" cy="2128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36569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>
                <a:latin typeface="Arial"/>
                <a:cs typeface="Arial"/>
              </a:rPr>
              <a:t>Spectrum </a:t>
            </a:r>
            <a:r>
              <a:rPr lang="en-US" smtClean="0">
                <a:latin typeface="Arial"/>
                <a:cs typeface="Arial"/>
              </a:rPr>
              <a:t>26a</a:t>
            </a:r>
            <a:br>
              <a:rPr lang="en-US" smtClean="0">
                <a:latin typeface="Arial"/>
                <a:cs typeface="Arial"/>
              </a:rPr>
            </a:br>
            <a:r>
              <a:rPr lang="en-US" smtClean="0">
                <a:latin typeface="Arial"/>
                <a:cs typeface="Arial"/>
              </a:rPr>
              <a:t>CAH6_HUMAN</a:t>
            </a:r>
            <a:r>
              <a:rPr lang="en-US" dirty="0">
                <a:latin typeface="Arial"/>
                <a:cs typeface="Arial"/>
              </a:rPr>
              <a:t>@67: GLNM-&gt;</a:t>
            </a:r>
            <a:r>
              <a:rPr lang="en-US" dirty="0" smtClean="0">
                <a:latin typeface="Arial"/>
                <a:cs typeface="Arial"/>
              </a:rPr>
              <a:t>LTGYETQAGEFPMVNNGHTVQISLPSTMR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MW </a:t>
            </a:r>
            <a:r>
              <a:rPr lang="en-US" dirty="0">
                <a:latin typeface="Arial"/>
                <a:cs typeface="Arial"/>
              </a:rPr>
              <a:t>3463.64, Precursor m/z 1155.55 charge 3, delta(ppm) </a:t>
            </a:r>
            <a:r>
              <a:rPr lang="en-US" dirty="0" smtClean="0">
                <a:latin typeface="Arial"/>
                <a:cs typeface="Arial"/>
              </a:rPr>
              <a:t>4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077" name="Picture 5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31" y="1600200"/>
            <a:ext cx="8324560" cy="41534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4740" y="1447800"/>
            <a:ext cx="2373218" cy="30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999995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>
                <a:latin typeface="Arial"/>
                <a:cs typeface="Arial"/>
              </a:rPr>
              <a:t>Spectrum </a:t>
            </a:r>
            <a:r>
              <a:rPr lang="en-US" dirty="0" smtClean="0">
                <a:latin typeface="Arial"/>
                <a:cs typeface="Arial"/>
              </a:rPr>
              <a:t>26b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CAH6_HUMAN</a:t>
            </a:r>
            <a:r>
              <a:rPr lang="en-US" dirty="0">
                <a:latin typeface="Arial"/>
                <a:cs typeface="Arial"/>
              </a:rPr>
              <a:t>@67: GLNM-&gt;LTGYETQAGEFPMVNNGHTVQIS-&gt;</a:t>
            </a:r>
            <a:r>
              <a:rPr lang="en-US" dirty="0" smtClean="0">
                <a:latin typeface="Arial"/>
                <a:cs typeface="Arial"/>
              </a:rPr>
              <a:t>GLPSTMR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MW </a:t>
            </a:r>
            <a:r>
              <a:rPr lang="en-US" dirty="0">
                <a:latin typeface="Arial"/>
                <a:cs typeface="Arial"/>
              </a:rPr>
              <a:t>3434.61, Precursor m/z 1145.88 charge 3, delta(ppm) -</a:t>
            </a:r>
            <a:r>
              <a:rPr lang="en-US" dirty="0" smtClean="0">
                <a:latin typeface="Arial"/>
                <a:cs typeface="Arial"/>
              </a:rPr>
              <a:t>1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85160"/>
            <a:ext cx="8229600" cy="4356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4601" y="1828800"/>
            <a:ext cx="2373217" cy="30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0860334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7a</a:t>
            </a:r>
            <a:r>
              <a:rPr lang="pt-BR" dirty="0">
                <a:latin typeface="Arial"/>
                <a:cs typeface="Arial"/>
              </a:rPr>
              <a:t/>
            </a:r>
            <a:br>
              <a:rPr lang="pt-BR" dirty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AH6_HUMAN</a:t>
            </a:r>
            <a:r>
              <a:rPr lang="pt-BR" dirty="0">
                <a:latin typeface="Arial"/>
                <a:cs typeface="Arial"/>
              </a:rPr>
              <a:t>@256: LENSLLDHRNK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38.69, Precursor m/z 670.35 charge 2+, delta(ppm) </a:t>
            </a:r>
            <a:r>
              <a:rPr lang="pt-BR" dirty="0" smtClean="0">
                <a:latin typeface="Arial"/>
                <a:cs typeface="Arial"/>
              </a:rPr>
              <a:t>3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8675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2133600"/>
            <a:ext cx="2381250" cy="13192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101341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7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AH6_HUMAN</a:t>
            </a:r>
            <a:r>
              <a:rPr lang="pt-BR" dirty="0">
                <a:latin typeface="Arial"/>
                <a:cs typeface="Arial"/>
              </a:rPr>
              <a:t>@256: </a:t>
            </a:r>
            <a:r>
              <a:rPr lang="pt-BR" u="sng" dirty="0">
                <a:latin typeface="Arial"/>
                <a:cs typeface="Arial"/>
              </a:rPr>
              <a:t>NKT</a:t>
            </a:r>
            <a:r>
              <a:rPr lang="pt-BR" dirty="0">
                <a:latin typeface="Arial"/>
                <a:cs typeface="Arial"/>
              </a:rPr>
              <a:t>IHNDYR_Deamidated(N)@1; Formyl(K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88.55, Precursor m/z 595.28 charge 2+, delta(ppm) </a:t>
            </a:r>
            <a:r>
              <a:rPr lang="pt-BR" dirty="0" smtClean="0">
                <a:latin typeface="Arial"/>
                <a:cs typeface="Arial"/>
              </a:rPr>
              <a:t>3.8</a:t>
            </a:r>
            <a:endParaRPr lang="en-US" b="1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307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200" y="1524000"/>
            <a:ext cx="2762250" cy="1276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537239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2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ALL5_HUMAN</a:t>
            </a:r>
            <a:r>
              <a:rPr lang="pt-BR" dirty="0">
                <a:latin typeface="Arial"/>
                <a:cs typeface="Arial"/>
              </a:rPr>
              <a:t>@25: AFSAVDTDG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INAQELGAALK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263.097, Precursor m/z 1132.56 charge 2+, delta(ppm) -</a:t>
            </a:r>
            <a:r>
              <a:rPr lang="pt-BR" dirty="0" smtClean="0">
                <a:latin typeface="Arial"/>
                <a:cs typeface="Arial"/>
              </a:rPr>
              <a:t>3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43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122587"/>
            <a:ext cx="8229600" cy="348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219200"/>
            <a:ext cx="3095625" cy="33897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87545441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2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ATD_HUMAN</a:t>
            </a:r>
            <a:r>
              <a:rPr lang="pt-BR" dirty="0">
                <a:latin typeface="Arial"/>
                <a:cs typeface="Arial"/>
              </a:rPr>
              <a:t>@263: GSLSYL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R_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09.57, Precursor m/z 555.79 charge 2+, delta(ppm) </a:t>
            </a:r>
            <a:r>
              <a:rPr lang="pt-BR" dirty="0" smtClean="0">
                <a:latin typeface="Arial"/>
                <a:cs typeface="Arial"/>
              </a:rPr>
              <a:t>4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27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0" y="2057400"/>
            <a:ext cx="2933893" cy="17383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858210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3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BPD_HUMAN</a:t>
            </a:r>
            <a:r>
              <a:rPr lang="pt-BR" dirty="0">
                <a:latin typeface="Arial"/>
                <a:cs typeface="Arial"/>
              </a:rPr>
              <a:t>@522: FANEYP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R_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24.58, Precursor m/z 613.3 charge 2+, delta(ppm) -</a:t>
            </a:r>
            <a:r>
              <a:rPr lang="pt-BR" dirty="0" smtClean="0">
                <a:latin typeface="Arial"/>
                <a:cs typeface="Arial"/>
              </a:rPr>
              <a:t>4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1371600"/>
            <a:ext cx="3552825" cy="2105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165790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3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BPD_HUMAN</a:t>
            </a:r>
            <a:r>
              <a:rPr lang="pt-BR" dirty="0">
                <a:latin typeface="Arial"/>
                <a:cs typeface="Arial"/>
              </a:rPr>
              <a:t>@1070: DLDTDFTN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QPETK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95.77, Precursor m/z 898.89 charge 2+, delta(ppm) </a:t>
            </a:r>
            <a:r>
              <a:rPr lang="pt-BR" dirty="0" smtClean="0">
                <a:latin typeface="Arial"/>
                <a:cs typeface="Arial"/>
              </a:rPr>
              <a:t>2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48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7600" y="1676400"/>
            <a:ext cx="2771775" cy="25339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913117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1AT_HUMAN</a:t>
            </a:r>
            <a:r>
              <a:rPr lang="pt-BR" dirty="0">
                <a:latin typeface="Arial"/>
                <a:cs typeface="Arial"/>
              </a:rPr>
              <a:t>@271: YLG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AIFFLPDEGK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55.87, Precursor m/z 878.94 charge 2+, delta(ppm) 2.6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1804989"/>
            <a:ext cx="2526569" cy="2309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516145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3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BPE_HUMAN</a:t>
            </a:r>
            <a:r>
              <a:rPr lang="pt-BR" dirty="0">
                <a:latin typeface="Arial"/>
                <a:cs typeface="Arial"/>
              </a:rPr>
              <a:t>@139: G</a:t>
            </a:r>
            <a:r>
              <a:rPr lang="pt-BR" u="sng" dirty="0">
                <a:latin typeface="Arial"/>
                <a:cs typeface="Arial"/>
              </a:rPr>
              <a:t>NET</a:t>
            </a:r>
            <a:r>
              <a:rPr lang="pt-BR" dirty="0">
                <a:latin typeface="Arial"/>
                <a:cs typeface="Arial"/>
              </a:rPr>
              <a:t>IVNLIHSTR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53.753, Precursor m/z 727.88 charge 2+, delta(ppm) </a:t>
            </a:r>
            <a:r>
              <a:rPr lang="pt-BR" dirty="0" smtClean="0">
                <a:latin typeface="Arial"/>
                <a:cs typeface="Arial"/>
              </a:rPr>
              <a:t>4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841679"/>
            <a:ext cx="3124200" cy="20397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832168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3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ERU_HUMAN</a:t>
            </a:r>
            <a:r>
              <a:rPr lang="pt-BR" dirty="0">
                <a:latin typeface="Arial"/>
                <a:cs typeface="Arial"/>
              </a:rPr>
              <a:t>@138: EHEGAIYPD</a:t>
            </a:r>
            <a:r>
              <a:rPr lang="pt-BR" u="sng" dirty="0">
                <a:latin typeface="Arial"/>
                <a:cs typeface="Arial"/>
              </a:rPr>
              <a:t>NTT</a:t>
            </a:r>
            <a:r>
              <a:rPr lang="pt-BR" dirty="0">
                <a:latin typeface="Arial"/>
                <a:cs typeface="Arial"/>
              </a:rPr>
              <a:t>DFQR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92.818, Precursor m/z 631.9462 charge 3+, delta(ppm) </a:t>
            </a:r>
            <a:r>
              <a:rPr lang="pt-BR" dirty="0" smtClean="0">
                <a:latin typeface="Arial"/>
                <a:cs typeface="Arial"/>
              </a:rPr>
              <a:t>0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810138"/>
            <a:ext cx="8229600" cy="4106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981200"/>
            <a:ext cx="3307851" cy="2239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535808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34a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>
                <a:latin typeface="Arial"/>
                <a:cs typeface="Arial"/>
              </a:rPr>
              <a:t> </a:t>
            </a:r>
            <a:r>
              <a:rPr lang="pt-BR" dirty="0" smtClean="0">
                <a:latin typeface="Arial"/>
                <a:cs typeface="Arial"/>
              </a:rPr>
              <a:t>CF058_HUMAN</a:t>
            </a:r>
            <a:r>
              <a:rPr lang="pt-BR" dirty="0">
                <a:latin typeface="Arial"/>
                <a:cs typeface="Arial"/>
              </a:rPr>
              <a:t>@24: GTS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ETEPPLWK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58.75, Precursor m/z 780.38 charge 2+, delta(ppm) </a:t>
            </a:r>
            <a:r>
              <a:rPr lang="pt-BR" dirty="0" smtClean="0">
                <a:latin typeface="Arial"/>
                <a:cs typeface="Arial"/>
              </a:rPr>
              <a:t>2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477" y="1600200"/>
            <a:ext cx="685104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676400"/>
            <a:ext cx="2728912" cy="2177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983700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34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F058_HUMAN</a:t>
            </a:r>
            <a:r>
              <a:rPr lang="pt-BR" dirty="0">
                <a:latin typeface="Arial"/>
                <a:cs typeface="Arial"/>
              </a:rPr>
              <a:t>@24: S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ETEPPLW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00.683, Precursor m/z 701.35 charge 2+, delta(ppm) -</a:t>
            </a:r>
            <a:r>
              <a:rPr lang="pt-BR" dirty="0" smtClean="0">
                <a:latin typeface="Arial"/>
                <a:cs typeface="Arial"/>
              </a:rPr>
              <a:t>2.2</a:t>
            </a:r>
            <a:endParaRPr lang="en-US" dirty="0" smtClean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2057400"/>
            <a:ext cx="3157537" cy="21319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029542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3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F058_HUMAN</a:t>
            </a:r>
            <a:r>
              <a:rPr lang="pt-BR" dirty="0">
                <a:latin typeface="Arial"/>
                <a:cs typeface="Arial"/>
              </a:rPr>
              <a:t>@69: IIL</a:t>
            </a:r>
            <a:r>
              <a:rPr lang="pt-BR" u="sng" dirty="0">
                <a:latin typeface="Arial"/>
                <a:cs typeface="Arial"/>
              </a:rPr>
              <a:t>NQT</a:t>
            </a:r>
            <a:r>
              <a:rPr lang="pt-BR" dirty="0">
                <a:latin typeface="Arial"/>
                <a:cs typeface="Arial"/>
              </a:rPr>
              <a:t>AR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928.535, Precursor m/z 465.28 charge 2+, delta(ppm) -</a:t>
            </a:r>
            <a:r>
              <a:rPr lang="pt-BR" dirty="0" smtClean="0">
                <a:latin typeface="Arial"/>
                <a:cs typeface="Arial"/>
              </a:rPr>
              <a:t>1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477" y="1600200"/>
            <a:ext cx="685104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6400" y="2133600"/>
            <a:ext cx="3012178" cy="148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853986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3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LIC1_HUMAN</a:t>
            </a:r>
            <a:r>
              <a:rPr lang="pt-BR" dirty="0">
                <a:latin typeface="Arial"/>
                <a:cs typeface="Arial"/>
              </a:rPr>
              <a:t>@42: GVTF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TVDTK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81.65, Precursor m/z 641.83 charge 2+, delta(ppm) </a:t>
            </a:r>
            <a:r>
              <a:rPr lang="pt-BR" dirty="0" smtClean="0">
                <a:latin typeface="Arial"/>
                <a:cs typeface="Arial"/>
              </a:rPr>
              <a:t>3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89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2185987"/>
            <a:ext cx="2000250" cy="13996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510888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3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LUS_HUMAN</a:t>
            </a:r>
            <a:r>
              <a:rPr lang="pt-BR" dirty="0">
                <a:latin typeface="Arial"/>
                <a:cs typeface="Arial"/>
              </a:rPr>
              <a:t>@374: LA</a:t>
            </a:r>
            <a:r>
              <a:rPr lang="pt-BR" u="sng" dirty="0">
                <a:latin typeface="Arial"/>
                <a:cs typeface="Arial"/>
              </a:rPr>
              <a:t>NLT</a:t>
            </a:r>
            <a:r>
              <a:rPr lang="pt-BR" dirty="0">
                <a:latin typeface="Arial"/>
                <a:cs typeface="Arial"/>
              </a:rPr>
              <a:t>QGEDQYYLR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83.81, Precursor m/z 842.91 charge 2+, delta(ppm) </a:t>
            </a:r>
            <a:r>
              <a:rPr lang="pt-BR" dirty="0" smtClean="0">
                <a:latin typeface="Arial"/>
                <a:cs typeface="Arial"/>
              </a:rPr>
              <a:t>2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1676400"/>
            <a:ext cx="2720684" cy="2195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778327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3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NTRL_HUMAN</a:t>
            </a:r>
            <a:r>
              <a:rPr lang="pt-BR" dirty="0">
                <a:latin typeface="Arial"/>
                <a:cs typeface="Arial"/>
              </a:rPr>
              <a:t>@153: </a:t>
            </a:r>
            <a:r>
              <a:rPr lang="pt-BR" u="sng" dirty="0">
                <a:latin typeface="Arial"/>
                <a:cs typeface="Arial"/>
              </a:rPr>
              <a:t>NLS</a:t>
            </a:r>
            <a:r>
              <a:rPr lang="pt-BR" dirty="0">
                <a:latin typeface="Arial"/>
                <a:cs typeface="Arial"/>
              </a:rPr>
              <a:t>YNK_Deamidated(N)@</a:t>
            </a:r>
            <a:r>
              <a:rPr lang="pt-BR" dirty="0" smtClean="0">
                <a:latin typeface="Arial"/>
                <a:cs typeface="Arial"/>
              </a:rPr>
              <a:t>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738.355, Precursor m/z 739.36 charge 1+, delta(ppm) </a:t>
            </a:r>
            <a:r>
              <a:rPr lang="pt-BR" dirty="0" smtClean="0">
                <a:latin typeface="Arial"/>
                <a:cs typeface="Arial"/>
              </a:rPr>
              <a:t>2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477" y="1600200"/>
            <a:ext cx="685104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6894" y="1981200"/>
            <a:ext cx="2547937" cy="11551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084670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3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O4A_HUMAN</a:t>
            </a:r>
            <a:r>
              <a:rPr lang="pt-BR" dirty="0">
                <a:latin typeface="Arial"/>
                <a:cs typeface="Arial"/>
              </a:rPr>
              <a:t>@226: FSDGLES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TQFEVK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74.79, Precursor m/z 888.4 charge 2+, delta(ppm) </a:t>
            </a:r>
            <a:r>
              <a:rPr lang="pt-BR" dirty="0" smtClean="0">
                <a:latin typeface="Arial"/>
                <a:cs typeface="Arial"/>
              </a:rPr>
              <a:t>2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6477" y="1600200"/>
            <a:ext cx="685104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1815000"/>
            <a:ext cx="2800350" cy="252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107306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pt-BR" sz="1300" dirty="0">
                <a:latin typeface="Arial"/>
                <a:cs typeface="Arial"/>
              </a:rPr>
              <a:t>Spectrum 40 </a:t>
            </a:r>
            <a:r>
              <a:rPr lang="pt-BR" sz="1300" dirty="0" smtClean="0">
                <a:latin typeface="Arial"/>
                <a:cs typeface="Arial"/>
              </a:rPr>
              <a:t/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CO4A_HUMAN</a:t>
            </a:r>
            <a:r>
              <a:rPr lang="pt-BR" sz="1300" dirty="0">
                <a:latin typeface="Arial"/>
                <a:cs typeface="Arial"/>
              </a:rPr>
              <a:t>@1328: GL</a:t>
            </a:r>
            <a:r>
              <a:rPr lang="pt-BR" sz="1300" u="sng" dirty="0">
                <a:latin typeface="Arial"/>
                <a:cs typeface="Arial"/>
              </a:rPr>
              <a:t>NVT</a:t>
            </a:r>
            <a:r>
              <a:rPr lang="pt-BR" sz="1300" dirty="0">
                <a:latin typeface="Arial"/>
                <a:cs typeface="Arial"/>
              </a:rPr>
              <a:t>LSSTGR_Deamidated(N)@</a:t>
            </a:r>
            <a:r>
              <a:rPr lang="pt-BR" sz="1300" dirty="0" smtClean="0">
                <a:latin typeface="Arial"/>
                <a:cs typeface="Arial"/>
              </a:rPr>
              <a:t>3</a:t>
            </a:r>
            <a:br>
              <a:rPr lang="pt-BR" sz="1300" dirty="0" smtClean="0">
                <a:latin typeface="Arial"/>
                <a:cs typeface="Arial"/>
              </a:rPr>
            </a:br>
            <a:r>
              <a:rPr lang="pt-BR" sz="1300" dirty="0" smtClean="0">
                <a:latin typeface="Arial"/>
                <a:cs typeface="Arial"/>
              </a:rPr>
              <a:t>MW </a:t>
            </a:r>
            <a:r>
              <a:rPr lang="pt-BR" sz="1300" dirty="0">
                <a:latin typeface="Arial"/>
                <a:cs typeface="Arial"/>
              </a:rPr>
              <a:t>1104.578, Precursor m/z 553.3 charge 2+, delta(ppm) -</a:t>
            </a:r>
            <a:r>
              <a:rPr lang="pt-BR" sz="1300" dirty="0" smtClean="0">
                <a:latin typeface="Arial"/>
                <a:cs typeface="Arial"/>
              </a:rPr>
              <a:t>7.1</a:t>
            </a:r>
            <a:r>
              <a:rPr lang="pt-BR" sz="1300" dirty="0">
                <a:latin typeface="Arial"/>
                <a:cs typeface="Arial"/>
              </a:rPr>
              <a:t/>
            </a:r>
            <a:br>
              <a:rPr lang="pt-BR" sz="1300" dirty="0">
                <a:latin typeface="Arial"/>
                <a:cs typeface="Arial"/>
              </a:rPr>
            </a:br>
            <a:endParaRPr lang="en-US" sz="1300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1600200"/>
            <a:ext cx="685104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2133600"/>
            <a:ext cx="3224212" cy="214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627106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>
                <a:latin typeface="Arial"/>
                <a:cs typeface="Arial"/>
              </a:rPr>
              <a:t>Spectrum 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2GL_HUMAN</a:t>
            </a:r>
            <a:r>
              <a:rPr lang="pt-BR" dirty="0">
                <a:latin typeface="Arial"/>
                <a:cs typeface="Arial"/>
              </a:rPr>
              <a:t>@186: LPPGLLA</a:t>
            </a:r>
            <a:r>
              <a:rPr lang="pt-BR" u="sng" dirty="0">
                <a:latin typeface="Arial"/>
                <a:cs typeface="Arial"/>
              </a:rPr>
              <a:t>NFT</a:t>
            </a:r>
            <a:r>
              <a:rPr lang="pt-BR" dirty="0">
                <a:latin typeface="Arial"/>
                <a:cs typeface="Arial"/>
              </a:rPr>
              <a:t>LLR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24.84, Precursor m/z 713.43 charge 2+, delta(ppm) -</a:t>
            </a:r>
            <a:r>
              <a:rPr lang="pt-BR" dirty="0" smtClean="0">
                <a:latin typeface="Arial"/>
                <a:cs typeface="Arial"/>
              </a:rPr>
              <a:t>4.4</a:t>
            </a:r>
            <a:r>
              <a:rPr lang="en-US" sz="1200" dirty="0" smtClean="0">
                <a:latin typeface="Arial"/>
                <a:cs typeface="Arial"/>
              </a:rPr>
              <a:t/>
            </a:r>
            <a:br>
              <a:rPr lang="en-US" sz="1200" dirty="0" smtClean="0">
                <a:latin typeface="Arial"/>
                <a:cs typeface="Arial"/>
              </a:rPr>
            </a:br>
            <a:r>
              <a:rPr lang="en-US" sz="1200" dirty="0" smtClean="0">
                <a:latin typeface="Arial"/>
                <a:cs typeface="Arial"/>
              </a:rPr>
              <a:t/>
            </a:r>
            <a:br>
              <a:rPr lang="en-US" sz="1200" dirty="0" smtClean="0">
                <a:latin typeface="Arial"/>
                <a:cs typeface="Arial"/>
              </a:rPr>
            </a:b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4178" y="1600200"/>
            <a:ext cx="5595644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1828800"/>
            <a:ext cx="2867226" cy="196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107921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76400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981200"/>
            <a:ext cx="3667125" cy="2324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O6A1_HUMAN</a:t>
            </a:r>
            <a:r>
              <a:rPr lang="pt-BR" dirty="0">
                <a:latin typeface="Arial"/>
                <a:cs typeface="Arial"/>
              </a:rPr>
              <a:t>@212: </a:t>
            </a:r>
            <a:r>
              <a:rPr lang="pt-BR" u="sng" dirty="0">
                <a:latin typeface="Arial"/>
                <a:cs typeface="Arial"/>
              </a:rPr>
              <a:t>NFT</a:t>
            </a:r>
            <a:r>
              <a:rPr lang="pt-BR" dirty="0">
                <a:latin typeface="Arial"/>
                <a:cs typeface="Arial"/>
              </a:rPr>
              <a:t>AADWGQSR_Deamidated(N)@</a:t>
            </a:r>
            <a:r>
              <a:rPr lang="pt-BR" dirty="0" smtClean="0">
                <a:latin typeface="Arial"/>
                <a:cs typeface="Arial"/>
              </a:rPr>
              <a:t>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52.548, Precursor m/z 627.28 charge 2+, delta(ppm) </a:t>
            </a:r>
            <a:r>
              <a:rPr lang="pt-BR" dirty="0" smtClean="0">
                <a:latin typeface="Arial"/>
                <a:cs typeface="Arial"/>
              </a:rPr>
              <a:t>1.4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09879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O6A1_HUMAN</a:t>
            </a:r>
            <a:r>
              <a:rPr lang="pt-BR" dirty="0">
                <a:latin typeface="Arial"/>
                <a:cs typeface="Arial"/>
              </a:rPr>
              <a:t>@516: GEDGPAG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EGFPGFPGYPGNR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249.962, Precursor m/z 1125.9873 charge 2+, delta(ppm) </a:t>
            </a:r>
            <a:r>
              <a:rPr lang="pt-BR" dirty="0" smtClean="0">
                <a:latin typeface="Arial"/>
                <a:cs typeface="Arial"/>
              </a:rPr>
              <a:t>0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945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45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1295400"/>
            <a:ext cx="2928937" cy="32291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3919813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O6A2_HUMAN</a:t>
            </a:r>
            <a:r>
              <a:rPr lang="pt-BR" dirty="0">
                <a:latin typeface="Arial"/>
                <a:cs typeface="Arial"/>
              </a:rPr>
              <a:t>@140: GTFTDCALA</a:t>
            </a:r>
            <a:r>
              <a:rPr lang="pt-BR" u="sng" dirty="0">
                <a:latin typeface="Arial"/>
                <a:cs typeface="Arial"/>
              </a:rPr>
              <a:t>NMT</a:t>
            </a:r>
            <a:r>
              <a:rPr lang="pt-BR" dirty="0">
                <a:latin typeface="Arial"/>
                <a:cs typeface="Arial"/>
              </a:rPr>
              <a:t>EQIR_Carbamidomethyl(C)@6; Deamidated(N)@10; Oxidation(M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43.81, Precursor m/z 922.91 charge 2+, delta(ppm) 2.4</a:t>
            </a:r>
            <a:br>
              <a:rPr lang="pt-BR" dirty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475" y="1643064"/>
            <a:ext cx="3133725" cy="25163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334481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4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OEA1_HUMAN</a:t>
            </a:r>
            <a:r>
              <a:rPr lang="pt-BR" dirty="0">
                <a:latin typeface="Arial"/>
                <a:cs typeface="Arial"/>
              </a:rPr>
              <a:t>@1384: AM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ANITSDGVEVLGK_Oxidation(M)@2; 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92.85, Precursor m/z 897.43 charge 2+, delta(ppm) </a:t>
            </a:r>
            <a:r>
              <a:rPr lang="pt-BR" dirty="0" smtClean="0">
                <a:latin typeface="Arial"/>
                <a:cs typeface="Arial"/>
              </a:rPr>
              <a:t>2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43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33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581150"/>
            <a:ext cx="2667000" cy="267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499013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4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COEA1_HUMAN</a:t>
            </a:r>
            <a:r>
              <a:rPr lang="pt-BR" dirty="0">
                <a:latin typeface="Arial"/>
                <a:cs typeface="Arial"/>
              </a:rPr>
              <a:t>@1384|1388: AM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A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SDGVEVLGK_Oxidation(M)@2; Deamidated(N)@3; Deamidated(N)@</a:t>
            </a:r>
            <a:r>
              <a:rPr lang="pt-BR" dirty="0" smtClean="0">
                <a:latin typeface="Arial"/>
                <a:cs typeface="Arial"/>
              </a:rPr>
              <a:t>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93.84, Precursor m/z 897.92 charge 2+, delta(ppm) </a:t>
            </a:r>
            <a:r>
              <a:rPr lang="pt-BR" dirty="0" smtClean="0">
                <a:latin typeface="Arial"/>
                <a:cs typeface="Arial"/>
              </a:rPr>
              <a:t>8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2" y="1600200"/>
            <a:ext cx="8268172" cy="5105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9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1676400"/>
            <a:ext cx="2890837" cy="2883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464436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DAF_HUMAN</a:t>
            </a:r>
            <a:r>
              <a:rPr lang="pt-BR" dirty="0">
                <a:latin typeface="Arial"/>
                <a:cs typeface="Arial"/>
              </a:rPr>
              <a:t>@95: GSQWSDIEEFC</a:t>
            </a:r>
            <a:r>
              <a:rPr lang="pt-BR" u="sng" dirty="0">
                <a:latin typeface="Arial"/>
                <a:cs typeface="Arial"/>
              </a:rPr>
              <a:t>NR</a:t>
            </a:r>
            <a:r>
              <a:rPr lang="pt-BR" dirty="0">
                <a:latin typeface="Arial"/>
                <a:cs typeface="Arial"/>
              </a:rPr>
              <a:t>_Carbamidomethyl(C)@11; 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27.66, Precursor m/z 814.84 charge 2+, delta(ppm) -</a:t>
            </a:r>
            <a:r>
              <a:rPr lang="pt-BR" dirty="0" smtClean="0">
                <a:latin typeface="Arial"/>
                <a:cs typeface="Arial"/>
              </a:rPr>
              <a:t>3.3</a:t>
            </a:r>
            <a:r>
              <a:rPr lang="en-US" dirty="0">
                <a:latin typeface="Arial"/>
                <a:cs typeface="Arial"/>
              </a:rPr>
              <a:t/>
            </a:r>
            <a:br>
              <a:rPr lang="en-US" dirty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8195" name="Picture 3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2085978"/>
            <a:ext cx="3112420" cy="1947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000341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DMBT1_HUMAN</a:t>
            </a:r>
            <a:r>
              <a:rPr lang="pt-BR" dirty="0">
                <a:latin typeface="Arial"/>
                <a:cs typeface="Arial"/>
              </a:rPr>
              <a:t>@1889: LVNL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YGLCAGR_Carbamidomethyl(C)@11; 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23.74, Precursor m/z 762.88 charge 2+, delta(ppm) -</a:t>
            </a:r>
            <a:r>
              <a:rPr lang="pt-BR" dirty="0" smtClean="0">
                <a:latin typeface="Arial"/>
                <a:cs typeface="Arial"/>
              </a:rPr>
              <a:t>3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0" y="1905000"/>
            <a:ext cx="3583820" cy="24241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821747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dirty="0">
                <a:latin typeface="Arial"/>
                <a:cs typeface="Arial"/>
              </a:rPr>
              <a:t>Spectrum 4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DNER_HUMAN</a:t>
            </a:r>
            <a:r>
              <a:rPr lang="pt-BR" dirty="0">
                <a:latin typeface="Arial"/>
                <a:cs typeface="Arial"/>
              </a:rPr>
              <a:t>@223: LVSFEVPQ</a:t>
            </a:r>
            <a:r>
              <a:rPr lang="pt-BR" u="sng" dirty="0">
                <a:latin typeface="Arial"/>
                <a:cs typeface="Arial"/>
              </a:rPr>
              <a:t>NTS</a:t>
            </a:r>
            <a:r>
              <a:rPr lang="pt-BR" dirty="0">
                <a:latin typeface="Arial"/>
                <a:cs typeface="Arial"/>
              </a:rPr>
              <a:t>VK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47.76, Precursor m/z 724.88 charge 2+, delta(ppm) </a:t>
            </a:r>
            <a:r>
              <a:rPr lang="pt-BR" dirty="0" smtClean="0">
                <a:latin typeface="Arial"/>
                <a:cs typeface="Arial"/>
              </a:rPr>
              <a:t>10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433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5240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090739"/>
            <a:ext cx="2484448" cy="18716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798486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DSC2_HUMAN</a:t>
            </a:r>
            <a:r>
              <a:rPr lang="pt-BR" dirty="0">
                <a:latin typeface="Arial"/>
                <a:cs typeface="Arial"/>
              </a:rPr>
              <a:t>@34: 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LHVPSK_Deamidated(N)@</a:t>
            </a:r>
            <a:r>
              <a:rPr lang="pt-BR" dirty="0" smtClean="0">
                <a:latin typeface="Arial"/>
                <a:cs typeface="Arial"/>
              </a:rPr>
              <a:t>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994.545, Precursor m/z 498.28 charge 2+, delta(ppm) -</a:t>
            </a:r>
            <a:r>
              <a:rPr lang="pt-BR" dirty="0" smtClean="0">
                <a:latin typeface="Arial"/>
                <a:cs typeface="Arial"/>
              </a:rPr>
              <a:t>0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810138"/>
            <a:ext cx="8229600" cy="4106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828800"/>
            <a:ext cx="2976936" cy="1352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765856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4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DSG1_HUMAN</a:t>
            </a:r>
            <a:r>
              <a:rPr lang="pt-BR" dirty="0">
                <a:latin typeface="Arial"/>
                <a:cs typeface="Arial"/>
              </a:rPr>
              <a:t>@110: TGEI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SIVDR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17.678, Precursor m/z 659.84 charge 2+, delta(ppm) </a:t>
            </a:r>
            <a:r>
              <a:rPr lang="pt-BR" dirty="0" smtClean="0">
                <a:latin typeface="Arial"/>
                <a:cs typeface="Arial"/>
              </a:rPr>
              <a:t>9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2171700"/>
            <a:ext cx="2967759" cy="2019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140962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2ML1_HUMAN</a:t>
            </a:r>
            <a:r>
              <a:rPr lang="pt-BR" dirty="0">
                <a:latin typeface="Arial"/>
                <a:cs typeface="Arial"/>
              </a:rPr>
              <a:t>@120: QG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FVQTDKPLYTPGQQVYFR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644.293, Precursor m/z 882.44 charge 3+, delta(ppm) -</a:t>
            </a:r>
            <a:r>
              <a:rPr lang="pt-BR" dirty="0" smtClean="0">
                <a:latin typeface="Arial"/>
                <a:cs typeface="Arial"/>
              </a:rPr>
              <a:t>2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122587"/>
            <a:ext cx="8229600" cy="348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1447800"/>
            <a:ext cx="3819525" cy="35965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315940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AM3D_HUMAN</a:t>
            </a:r>
            <a:r>
              <a:rPr lang="pt-BR" dirty="0">
                <a:latin typeface="Arial"/>
                <a:cs typeface="Arial"/>
              </a:rPr>
              <a:t>@107: GLNIALV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TGAVLGQK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25.963, Precursor m/z 863.99 charge 2+, delta(ppm) -</a:t>
            </a:r>
            <a:r>
              <a:rPr lang="pt-BR" dirty="0" smtClean="0">
                <a:latin typeface="Arial"/>
                <a:cs typeface="Arial"/>
              </a:rPr>
              <a:t>1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1752600"/>
            <a:ext cx="3535363" cy="3097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71396043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75: LLISSLSESPASVSILSQAD</a:t>
            </a:r>
            <a:r>
              <a:rPr lang="pt-BR" u="sng" dirty="0">
                <a:latin typeface="Arial"/>
                <a:cs typeface="Arial"/>
              </a:rPr>
              <a:t>NTS</a:t>
            </a:r>
            <a:r>
              <a:rPr lang="pt-BR" dirty="0">
                <a:latin typeface="Arial"/>
                <a:cs typeface="Arial"/>
              </a:rPr>
              <a:t>K_Deamidated(N)@</a:t>
            </a:r>
            <a:r>
              <a:rPr lang="pt-BR" dirty="0" smtClean="0">
                <a:latin typeface="Arial"/>
                <a:cs typeface="Arial"/>
              </a:rPr>
              <a:t>2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447.265, Precursor m/z 1224.64 charge 2+, delta(ppm) -</a:t>
            </a:r>
            <a:r>
              <a:rPr lang="pt-BR" dirty="0" smtClean="0">
                <a:latin typeface="Arial"/>
                <a:cs typeface="Arial"/>
              </a:rPr>
              <a:t>0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68733" y="1600200"/>
            <a:ext cx="2133600" cy="26950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946791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91: VTVRPGESVMV</a:t>
            </a:r>
            <a:r>
              <a:rPr lang="pt-BR" u="sng" dirty="0">
                <a:latin typeface="Arial"/>
                <a:cs typeface="Arial"/>
              </a:rPr>
              <a:t>NIS</a:t>
            </a:r>
            <a:r>
              <a:rPr lang="pt-BR" dirty="0">
                <a:latin typeface="Arial"/>
                <a:cs typeface="Arial"/>
              </a:rPr>
              <a:t>AK_Deamidated(N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686.898, Precursor m/z 563.31 charge 3+, delta(ppm) -6.3</a:t>
            </a:r>
            <a:br>
              <a:rPr lang="pt-BR" dirty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1905000"/>
            <a:ext cx="2988616" cy="2244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523173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3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1317: VITVQVA</a:t>
            </a:r>
            <a:r>
              <a:rPr lang="pt-BR" u="sng" dirty="0">
                <a:latin typeface="Arial"/>
                <a:cs typeface="Arial"/>
              </a:rPr>
              <a:t>NFT</a:t>
            </a:r>
            <a:r>
              <a:rPr lang="pt-BR" dirty="0">
                <a:latin typeface="Arial"/>
                <a:cs typeface="Arial"/>
              </a:rPr>
              <a:t>LR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60.772, Precursor m/z 681.39 charge 2+, delta(ppm) </a:t>
            </a:r>
            <a:r>
              <a:rPr lang="pt-BR" dirty="0" smtClean="0">
                <a:latin typeface="Arial"/>
                <a:cs typeface="Arial"/>
              </a:rPr>
              <a:t>4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1265" name="Picture 1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1828800"/>
            <a:ext cx="2969762" cy="2078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146516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4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1743: VVTVAALGT</a:t>
            </a:r>
            <a:r>
              <a:rPr lang="pt-BR" u="sng" dirty="0">
                <a:latin typeface="Arial"/>
                <a:cs typeface="Arial"/>
              </a:rPr>
              <a:t>NIS</a:t>
            </a:r>
            <a:r>
              <a:rPr lang="pt-BR" dirty="0">
                <a:latin typeface="Arial"/>
                <a:cs typeface="Arial"/>
              </a:rPr>
              <a:t>IHKDEIGK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65.142, Precursor m/z 689.38 charge 3+, delta(ppm) </a:t>
            </a:r>
            <a:r>
              <a:rPr lang="pt-BR" dirty="0" smtClean="0">
                <a:latin typeface="Arial"/>
                <a:cs typeface="Arial"/>
              </a:rPr>
              <a:t>11.5</a:t>
            </a:r>
            <a:endParaRPr lang="en-US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1752600"/>
            <a:ext cx="4191000" cy="3381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83818818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2111: HGPPLGAE</a:t>
            </a:r>
            <a:r>
              <a:rPr lang="pt-BR" u="sng" dirty="0">
                <a:latin typeface="Arial"/>
                <a:cs typeface="Arial"/>
              </a:rPr>
              <a:t>NFT</a:t>
            </a:r>
            <a:r>
              <a:rPr lang="pt-BR" dirty="0">
                <a:latin typeface="Arial"/>
                <a:cs typeface="Arial"/>
              </a:rPr>
              <a:t>VTVANEHR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45.992, Precursor m/z 683 charge 3+, delta(ppm) </a:t>
            </a:r>
            <a:r>
              <a:rPr lang="pt-BR" dirty="0" smtClean="0">
                <a:latin typeface="Arial"/>
                <a:cs typeface="Arial"/>
              </a:rPr>
              <a:t>6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828800"/>
            <a:ext cx="3575694" cy="3067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687809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4232: NPNNDQVFP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LAPSIPIWGGSWR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737.325, Precursor m/z 913.45 charge 3+, delta(ppm) -</a:t>
            </a:r>
            <a:r>
              <a:rPr lang="pt-BR" dirty="0" smtClean="0">
                <a:latin typeface="Arial"/>
                <a:cs typeface="Arial"/>
              </a:rPr>
              <a:t>1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1447800"/>
            <a:ext cx="3005137" cy="3586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46772907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5186: YLPV</a:t>
            </a:r>
            <a:r>
              <a:rPr lang="pt-BR" u="sng" dirty="0">
                <a:latin typeface="Arial"/>
                <a:cs typeface="Arial"/>
              </a:rPr>
              <a:t>NSS</a:t>
            </a:r>
            <a:r>
              <a:rPr lang="pt-BR" dirty="0">
                <a:latin typeface="Arial"/>
                <a:cs typeface="Arial"/>
              </a:rPr>
              <a:t>LLTSDCSER_Deamidated(N)@5; Carbamidomethyl(C)@</a:t>
            </a:r>
            <a:r>
              <a:rPr lang="pt-BR" dirty="0" smtClean="0">
                <a:latin typeface="Arial"/>
                <a:cs typeface="Arial"/>
              </a:rPr>
              <a:t>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840.852, Precursor m/z 921.43 charge 2+, delta(ppm) </a:t>
            </a:r>
            <a:r>
              <a:rPr lang="pt-BR" dirty="0" smtClean="0">
                <a:latin typeface="Arial"/>
                <a:cs typeface="Arial"/>
              </a:rPr>
              <a:t>3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1728631"/>
            <a:ext cx="3789425" cy="276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818580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CGBP_HUMAN</a:t>
            </a:r>
            <a:r>
              <a:rPr lang="pt-BR" dirty="0">
                <a:latin typeface="Arial"/>
                <a:cs typeface="Arial"/>
              </a:rPr>
              <a:t>@5242: SVGA</a:t>
            </a:r>
            <a:r>
              <a:rPr lang="pt-BR" u="sng" dirty="0">
                <a:latin typeface="Arial"/>
                <a:cs typeface="Arial"/>
              </a:rPr>
              <a:t>NLT</a:t>
            </a:r>
            <a:r>
              <a:rPr lang="pt-BR" dirty="0">
                <a:latin typeface="Arial"/>
                <a:cs typeface="Arial"/>
              </a:rPr>
              <a:t>TFDGAR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08.632, Precursor m/z 655.32 charge 2+, delta(ppm) </a:t>
            </a:r>
            <a:r>
              <a:rPr lang="pt-BR" dirty="0" smtClean="0">
                <a:latin typeface="Arial"/>
                <a:cs typeface="Arial"/>
              </a:rPr>
              <a:t>4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843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9200" y="1828800"/>
            <a:ext cx="3724275" cy="2705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537728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5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IBB_HUMAN</a:t>
            </a:r>
            <a:r>
              <a:rPr lang="pt-BR" dirty="0">
                <a:latin typeface="Arial"/>
                <a:cs typeface="Arial"/>
              </a:rPr>
              <a:t>@394: ALMDGASQLMGE</a:t>
            </a:r>
            <a:r>
              <a:rPr lang="pt-BR" u="sng" dirty="0">
                <a:latin typeface="Arial"/>
                <a:cs typeface="Arial"/>
              </a:rPr>
              <a:t>NR</a:t>
            </a:r>
            <a:r>
              <a:rPr lang="pt-BR" dirty="0">
                <a:latin typeface="Arial"/>
                <a:cs typeface="Arial"/>
              </a:rPr>
              <a:t>_Oxidation(M)@3; Oxidation(M)@10; Deamidated(N)@</a:t>
            </a:r>
            <a:r>
              <a:rPr lang="pt-BR" dirty="0" smtClean="0">
                <a:latin typeface="Arial"/>
                <a:cs typeface="Arial"/>
              </a:rPr>
              <a:t>1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24.655, Precursor m/z 763.33 charge 2+, delta(ppm) </a:t>
            </a:r>
            <a:r>
              <a:rPr lang="pt-BR" dirty="0" smtClean="0">
                <a:latin typeface="Arial"/>
                <a:cs typeface="Arial"/>
              </a:rPr>
              <a:t>6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0" y="1905000"/>
            <a:ext cx="2495550" cy="19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1488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2ML1_HUMAN</a:t>
            </a:r>
            <a:r>
              <a:rPr lang="pt-BR" dirty="0">
                <a:latin typeface="Arial"/>
                <a:cs typeface="Arial"/>
              </a:rPr>
              <a:t>@409: TLETSGW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DVSLEGK_Deamidated(N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93.832, Precursor m/z 897.92 charge 2+, delta(ppm) </a:t>
            </a:r>
            <a:r>
              <a:rPr lang="pt-BR" dirty="0" smtClean="0">
                <a:latin typeface="Arial"/>
                <a:cs typeface="Arial"/>
              </a:rPr>
              <a:t>3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1698625"/>
            <a:ext cx="3386137" cy="2807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25962111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IBG_HUMAN</a:t>
            </a:r>
            <a:r>
              <a:rPr lang="pt-BR" dirty="0">
                <a:latin typeface="Arial"/>
                <a:cs typeface="Arial"/>
              </a:rPr>
              <a:t>@78: VDKDLQSLEDILHQVE</a:t>
            </a:r>
            <a:r>
              <a:rPr lang="pt-BR" u="sng" dirty="0">
                <a:latin typeface="Arial"/>
                <a:cs typeface="Arial"/>
              </a:rPr>
              <a:t>NK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1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123.075, Precursor m/z 708.7 charge 3+, delta(ppm) -</a:t>
            </a:r>
            <a:r>
              <a:rPr lang="pt-BR" dirty="0" smtClean="0">
                <a:latin typeface="Arial"/>
                <a:cs typeface="Arial"/>
              </a:rPr>
              <a:t>1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828800"/>
            <a:ext cx="3328987" cy="28856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45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5275" y="2209800"/>
            <a:ext cx="1076326" cy="326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917397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61 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STL1_HUMAN@144: GS</a:t>
            </a:r>
            <a:r>
              <a:rPr lang="pt-BR" u="sng" dirty="0" smtClean="0">
                <a:latin typeface="Arial"/>
                <a:cs typeface="Arial"/>
              </a:rPr>
              <a:t>NYS</a:t>
            </a:r>
            <a:r>
              <a:rPr lang="pt-BR" dirty="0" smtClean="0">
                <a:latin typeface="Arial"/>
                <a:cs typeface="Arial"/>
              </a:rPr>
              <a:t>EILDK_Deamidated(N)@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1125.52, </a:t>
            </a:r>
            <a:r>
              <a:rPr lang="pt-BR" dirty="0">
                <a:latin typeface="Arial"/>
                <a:cs typeface="Arial"/>
              </a:rPr>
              <a:t>Precursor m/z 563.77 charge 2+, delta(ppm) -</a:t>
            </a:r>
            <a:r>
              <a:rPr lang="pt-BR" dirty="0" smtClean="0">
                <a:latin typeface="Arial"/>
                <a:cs typeface="Arial"/>
              </a:rPr>
              <a:t>5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1752600"/>
            <a:ext cx="3299052" cy="198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638760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2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FURIN_HUMAN</a:t>
            </a:r>
            <a:r>
              <a:rPr lang="pt-BR" dirty="0">
                <a:latin typeface="Arial"/>
                <a:cs typeface="Arial"/>
              </a:rPr>
              <a:t>@440: LAQ</a:t>
            </a:r>
            <a:r>
              <a:rPr lang="pt-BR" u="sng" dirty="0">
                <a:latin typeface="Arial"/>
                <a:cs typeface="Arial"/>
              </a:rPr>
              <a:t>NWT</a:t>
            </a:r>
            <a:r>
              <a:rPr lang="pt-BR" dirty="0">
                <a:latin typeface="Arial"/>
                <a:cs typeface="Arial"/>
              </a:rPr>
              <a:t>TVAPQR_Deamidated(N)@</a:t>
            </a:r>
            <a:r>
              <a:rPr lang="pt-BR" dirty="0" smtClean="0">
                <a:latin typeface="Arial"/>
                <a:cs typeface="Arial"/>
              </a:rPr>
              <a:t>4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84.71, Precursor m/z 693.36 charge 2+, delta(ppm) </a:t>
            </a:r>
            <a:r>
              <a:rPr lang="pt-BR" dirty="0" smtClean="0">
                <a:latin typeface="Arial"/>
                <a:cs typeface="Arial"/>
              </a:rPr>
              <a:t>3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843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15240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1" y="1752601"/>
            <a:ext cx="3049168" cy="213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334560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6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GOLM1_HUMAN</a:t>
            </a:r>
            <a:r>
              <a:rPr lang="pt-BR" dirty="0">
                <a:latin typeface="Arial"/>
                <a:cs typeface="Arial"/>
              </a:rPr>
              <a:t>@109: AVLVN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TGER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86.684, Precursor m/z 644.35 charge 2+, delta(ppm) -</a:t>
            </a:r>
            <a:r>
              <a:rPr lang="pt-BR" dirty="0" smtClean="0">
                <a:latin typeface="Arial"/>
                <a:cs typeface="Arial"/>
              </a:rPr>
              <a:t>1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3400" y="1905001"/>
            <a:ext cx="3276600" cy="2035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742375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4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GTR11_HUMAN</a:t>
            </a:r>
            <a:r>
              <a:rPr lang="pt-BR" dirty="0">
                <a:latin typeface="Arial"/>
                <a:cs typeface="Arial"/>
              </a:rPr>
              <a:t>@289: </a:t>
            </a:r>
            <a:r>
              <a:rPr lang="en-US" dirty="0">
                <a:latin typeface="Arial"/>
                <a:cs typeface="Arial"/>
              </a:rPr>
              <a:t>GTR11_HUMAN@289: </a:t>
            </a:r>
            <a:r>
              <a:rPr lang="en-US" dirty="0" err="1">
                <a:latin typeface="Arial"/>
                <a:cs typeface="Arial"/>
              </a:rPr>
              <a:t>ALRRQVTSLVVLGSAMELCGNDSVYAYASSVFR_Carbamidomethyl</a:t>
            </a:r>
            <a:r>
              <a:rPr lang="en-US" dirty="0">
                <a:latin typeface="Arial"/>
                <a:cs typeface="Arial"/>
              </a:rPr>
              <a:t>(C)@19; </a:t>
            </a:r>
            <a:r>
              <a:rPr lang="en-US" dirty="0" err="1">
                <a:latin typeface="Arial"/>
                <a:cs typeface="Arial"/>
              </a:rPr>
              <a:t>Deamidated</a:t>
            </a:r>
            <a:r>
              <a:rPr lang="en-US" dirty="0">
                <a:latin typeface="Arial"/>
                <a:cs typeface="Arial"/>
              </a:rPr>
              <a:t>(N)@</a:t>
            </a:r>
            <a:r>
              <a:rPr lang="en-US" dirty="0" smtClean="0">
                <a:latin typeface="Arial"/>
                <a:cs typeface="Arial"/>
              </a:rPr>
              <a:t>21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MW </a:t>
            </a:r>
            <a:r>
              <a:rPr lang="en-US" dirty="0">
                <a:latin typeface="Arial"/>
                <a:cs typeface="Arial"/>
              </a:rPr>
              <a:t>3619.813, Precursor m/z 905.96 charge 4+, delta(ppm) -0.5</a:t>
            </a:r>
            <a:endParaRPr lang="en-US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1371600"/>
            <a:ext cx="3886200" cy="39581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86037983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EMO_HUMAN</a:t>
            </a:r>
            <a:r>
              <a:rPr lang="pt-BR" dirty="0">
                <a:latin typeface="Arial"/>
                <a:cs typeface="Arial"/>
              </a:rPr>
              <a:t>@187: SWPAVGNCSSALR_Deamidated(N)@7; Carbamidomethyl(C)@</a:t>
            </a:r>
            <a:r>
              <a:rPr lang="pt-BR" dirty="0" smtClean="0">
                <a:latin typeface="Arial"/>
                <a:cs typeface="Arial"/>
              </a:rPr>
              <a:t>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04.646, Precursor m/z 703.33 charge 2+, delta(ppm) </a:t>
            </a:r>
            <a:r>
              <a:rPr lang="pt-BR" dirty="0" smtClean="0">
                <a:latin typeface="Arial"/>
                <a:cs typeface="Arial"/>
              </a:rPr>
              <a:t>0.1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810138"/>
            <a:ext cx="8229600" cy="4106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800" y="2209800"/>
            <a:ext cx="2962275" cy="20017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779657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EXA_HUMAN</a:t>
            </a:r>
            <a:r>
              <a:rPr lang="pt-BR" dirty="0">
                <a:latin typeface="Arial"/>
                <a:cs typeface="Arial"/>
              </a:rPr>
              <a:t>@157: SAEGTFFI</a:t>
            </a:r>
            <a:r>
              <a:rPr lang="pt-BR" u="sng" dirty="0">
                <a:latin typeface="Arial"/>
                <a:cs typeface="Arial"/>
              </a:rPr>
              <a:t>NK</a:t>
            </a:r>
            <a:r>
              <a:rPr lang="pt-BR" dirty="0">
                <a:latin typeface="Arial"/>
                <a:cs typeface="Arial"/>
              </a:rPr>
              <a:t>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13.53, Precursor m/z 557.77 charge 2+, delta(ppm) </a:t>
            </a:r>
            <a:r>
              <a:rPr lang="pt-BR" dirty="0" smtClean="0">
                <a:latin typeface="Arial"/>
                <a:cs typeface="Arial"/>
              </a:rPr>
              <a:t>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1000" y="2514600"/>
            <a:ext cx="2695575" cy="1597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813475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7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PT_HUMAN</a:t>
            </a:r>
            <a:r>
              <a:rPr lang="pt-BR" dirty="0">
                <a:latin typeface="Arial"/>
                <a:cs typeface="Arial"/>
              </a:rPr>
              <a:t>@207|211: NLFL</a:t>
            </a:r>
            <a:r>
              <a:rPr lang="pt-BR" u="sng" dirty="0">
                <a:latin typeface="Arial"/>
                <a:cs typeface="Arial"/>
              </a:rPr>
              <a:t>NHS</a:t>
            </a:r>
            <a:r>
              <a:rPr lang="pt-BR" dirty="0">
                <a:latin typeface="Arial"/>
                <a:cs typeface="Arial"/>
              </a:rPr>
              <a:t>ENATAK_Deamidated(N)@5; 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59.695, Precursor m/z 730.85 charge 2+, delta(ppm) </a:t>
            </a:r>
            <a:r>
              <a:rPr lang="pt-BR" dirty="0" smtClean="0">
                <a:latin typeface="Arial"/>
                <a:cs typeface="Arial"/>
              </a:rPr>
              <a:t>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828800"/>
            <a:ext cx="3105150" cy="1990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14352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6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PT_HUMAN</a:t>
            </a:r>
            <a:r>
              <a:rPr lang="pt-BR" dirty="0">
                <a:latin typeface="Arial"/>
                <a:cs typeface="Arial"/>
              </a:rPr>
              <a:t>@241: VVLHP</a:t>
            </a:r>
            <a:r>
              <a:rPr lang="pt-BR" u="sng" dirty="0">
                <a:latin typeface="Arial"/>
                <a:cs typeface="Arial"/>
              </a:rPr>
              <a:t>NYS</a:t>
            </a:r>
            <a:r>
              <a:rPr lang="pt-BR" dirty="0">
                <a:latin typeface="Arial"/>
                <a:cs typeface="Arial"/>
              </a:rPr>
              <a:t>QVDIGLI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94.989, Precursor m/z 599.34 charge 3+, delta(ppm) -</a:t>
            </a:r>
            <a:r>
              <a:rPr lang="pt-BR" dirty="0" smtClean="0">
                <a:latin typeface="Arial"/>
                <a:cs typeface="Arial"/>
              </a:rPr>
              <a:t>5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25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057400"/>
            <a:ext cx="3162300" cy="2472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812860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/>
            </a:r>
            <a:br>
              <a:rPr lang="en-US" dirty="0" smtClean="0"/>
            </a:br>
            <a:r>
              <a:rPr lang="pt-BR" dirty="0">
                <a:latin typeface="Arial"/>
                <a:cs typeface="Arial"/>
              </a:rPr>
              <a:t>Spectrum 6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YOU1_HUMAN</a:t>
            </a:r>
            <a:r>
              <a:rPr lang="pt-BR" dirty="0">
                <a:latin typeface="Arial"/>
                <a:cs typeface="Arial"/>
              </a:rPr>
              <a:t>@515: VFGSQ</a:t>
            </a:r>
            <a:r>
              <a:rPr lang="pt-BR" u="sng" dirty="0">
                <a:latin typeface="Arial"/>
                <a:cs typeface="Arial"/>
              </a:rPr>
              <a:t>NLT</a:t>
            </a:r>
            <a:r>
              <a:rPr lang="pt-BR" dirty="0">
                <a:latin typeface="Arial"/>
                <a:cs typeface="Arial"/>
              </a:rPr>
              <a:t>TV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93.63, Precursor m/z 597.82 charge 2+, delta(ppm) </a:t>
            </a:r>
            <a:r>
              <a:rPr lang="pt-BR" dirty="0" smtClean="0">
                <a:latin typeface="Arial"/>
                <a:cs typeface="Arial"/>
              </a:rPr>
              <a:t>3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253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8400" y="2133600"/>
            <a:ext cx="2847975" cy="1840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184496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2ML1_HUMAN</a:t>
            </a:r>
            <a:r>
              <a:rPr lang="pt-BR" dirty="0">
                <a:latin typeface="Arial"/>
                <a:cs typeface="Arial"/>
              </a:rPr>
              <a:t>@857: THHW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AVK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06.615, Precursor m/z 403.21 charge 3+, delta(ppm) 5.2</a:t>
            </a:r>
            <a:br>
              <a:rPr lang="pt-BR" dirty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4178" y="1600200"/>
            <a:ext cx="5595644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200" y="2209800"/>
            <a:ext cx="3465059" cy="167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190553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0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YOU1_HUMAN</a:t>
            </a:r>
            <a:r>
              <a:rPr lang="pt-BR" dirty="0">
                <a:latin typeface="Arial"/>
                <a:cs typeface="Arial"/>
              </a:rPr>
              <a:t>@596: E</a:t>
            </a:r>
            <a:r>
              <a:rPr lang="pt-BR" u="sng" dirty="0">
                <a:latin typeface="Arial"/>
                <a:cs typeface="Arial"/>
              </a:rPr>
              <a:t>NGT</a:t>
            </a:r>
            <a:r>
              <a:rPr lang="pt-BR" dirty="0">
                <a:latin typeface="Arial"/>
                <a:cs typeface="Arial"/>
              </a:rPr>
              <a:t>DTVQEEEESPAEGSK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035.835, Precursor m/z 1018.92 charge 2+, delta(ppm) </a:t>
            </a:r>
            <a:r>
              <a:rPr lang="pt-BR" dirty="0" smtClean="0">
                <a:latin typeface="Arial"/>
                <a:cs typeface="Arial"/>
              </a:rPr>
              <a:t>4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76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122587"/>
            <a:ext cx="8229600" cy="348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0" y="1600200"/>
            <a:ext cx="3081337" cy="28356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9238130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5" b="6125"/>
          <a:stretch>
            <a:fillRect/>
          </a:stretch>
        </p:blipFill>
        <p:spPr bwMode="auto">
          <a:xfrm>
            <a:off x="457200" y="2103437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1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HYOU1_HUMAN</a:t>
            </a:r>
            <a:r>
              <a:rPr lang="pt-BR" dirty="0">
                <a:latin typeface="Arial"/>
                <a:cs typeface="Arial"/>
              </a:rPr>
              <a:t>@931: AEPPL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ASDQGE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13.69, Precursor m/z 757.85 charge 2+, delta(ppm) 2.7</a:t>
            </a:r>
            <a:br>
              <a:rPr lang="pt-BR" dirty="0">
                <a:latin typeface="Arial"/>
                <a:cs typeface="Arial"/>
              </a:rPr>
            </a:br>
            <a:endParaRPr lang="en-US" dirty="0">
              <a:latin typeface="Arial"/>
              <a:cs typeface="Arial"/>
            </a:endParaRPr>
          </a:p>
        </p:txBody>
      </p:sp>
      <p:pic>
        <p:nvPicPr>
          <p:cNvPr id="296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371600"/>
            <a:ext cx="2870239" cy="2301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879443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rmAutofit/>
          </a:bodyPr>
          <a:lstStyle/>
          <a:p>
            <a:r>
              <a:rPr lang="en-US" dirty="0" smtClean="0">
                <a:latin typeface="Arial"/>
                <a:cs typeface="Arial"/>
              </a:rPr>
              <a:t>Spectrum </a:t>
            </a:r>
            <a:r>
              <a:rPr lang="en-US" dirty="0">
                <a:latin typeface="Arial"/>
                <a:cs typeface="Arial"/>
              </a:rPr>
              <a:t>72a 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IGHA1_HUMAN</a:t>
            </a:r>
            <a:r>
              <a:rPr lang="en-US" dirty="0">
                <a:latin typeface="Arial"/>
                <a:cs typeface="Arial"/>
              </a:rPr>
              <a:t>@144 or KGHA2@131: </a:t>
            </a:r>
            <a:r>
              <a:rPr lang="en-US" dirty="0" err="1">
                <a:latin typeface="Arial"/>
                <a:cs typeface="Arial"/>
              </a:rPr>
              <a:t>PALEDLLLGSEA</a:t>
            </a:r>
            <a:r>
              <a:rPr lang="en-US" u="sng" dirty="0" err="1">
                <a:latin typeface="Arial"/>
                <a:cs typeface="Arial"/>
              </a:rPr>
              <a:t>NLT</a:t>
            </a:r>
            <a:r>
              <a:rPr lang="en-US" dirty="0" err="1">
                <a:latin typeface="Arial"/>
                <a:cs typeface="Arial"/>
              </a:rPr>
              <a:t>CTLTGLR_Deamidated</a:t>
            </a:r>
            <a:r>
              <a:rPr lang="en-US" dirty="0">
                <a:latin typeface="Arial"/>
                <a:cs typeface="Arial"/>
              </a:rPr>
              <a:t>(N)@13; </a:t>
            </a:r>
            <a:r>
              <a:rPr lang="en-US" dirty="0" err="1">
                <a:latin typeface="Arial"/>
                <a:cs typeface="Arial"/>
              </a:rPr>
              <a:t>Carbamidomethyl</a:t>
            </a:r>
            <a:r>
              <a:rPr lang="en-US" dirty="0">
                <a:latin typeface="Arial"/>
                <a:cs typeface="Arial"/>
              </a:rPr>
              <a:t>(C)@</a:t>
            </a:r>
            <a:r>
              <a:rPr lang="en-US" dirty="0" smtClean="0">
                <a:latin typeface="Arial"/>
                <a:cs typeface="Arial"/>
              </a:rPr>
              <a:t>16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MW </a:t>
            </a:r>
            <a:r>
              <a:rPr lang="en-US" dirty="0">
                <a:latin typeface="Arial"/>
                <a:cs typeface="Arial"/>
              </a:rPr>
              <a:t>2357.21, Precursor m/z 1179.61 charge 2+, delta(ppm) </a:t>
            </a:r>
            <a:r>
              <a:rPr lang="en-US" dirty="0" smtClean="0">
                <a:latin typeface="Arial"/>
                <a:cs typeface="Arial"/>
              </a:rPr>
              <a:t>1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60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0" y="1371600"/>
            <a:ext cx="2724150" cy="2971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399572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latin typeface="Arial"/>
                <a:cs typeface="Arial"/>
              </a:rPr>
              <a:t>Spectrum 72b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 </a:t>
            </a:r>
            <a:r>
              <a:rPr lang="en-US" dirty="0">
                <a:latin typeface="Arial"/>
                <a:cs typeface="Arial"/>
              </a:rPr>
              <a:t>IGHA1_HUMAN@144 or KGHA2@131: </a:t>
            </a:r>
            <a:r>
              <a:rPr lang="en-US" dirty="0" err="1">
                <a:latin typeface="Arial"/>
                <a:cs typeface="Arial"/>
              </a:rPr>
              <a:t>DLLLGSEA</a:t>
            </a:r>
            <a:r>
              <a:rPr lang="en-US" u="sng" dirty="0" err="1">
                <a:latin typeface="Arial"/>
                <a:cs typeface="Arial"/>
              </a:rPr>
              <a:t>NLT</a:t>
            </a:r>
            <a:r>
              <a:rPr lang="en-US" dirty="0" err="1">
                <a:latin typeface="Arial"/>
                <a:cs typeface="Arial"/>
              </a:rPr>
              <a:t>CTLTGLR_Deamidated</a:t>
            </a:r>
            <a:r>
              <a:rPr lang="en-US" dirty="0">
                <a:latin typeface="Arial"/>
                <a:cs typeface="Arial"/>
              </a:rPr>
              <a:t>(N)@9; </a:t>
            </a:r>
            <a:r>
              <a:rPr lang="en-US" dirty="0" err="1">
                <a:latin typeface="Arial"/>
                <a:cs typeface="Arial"/>
              </a:rPr>
              <a:t>Carbamidomethyl</a:t>
            </a:r>
            <a:r>
              <a:rPr lang="en-US" dirty="0">
                <a:latin typeface="Arial"/>
                <a:cs typeface="Arial"/>
              </a:rPr>
              <a:t>(C)@</a:t>
            </a:r>
            <a:r>
              <a:rPr lang="en-US" dirty="0" smtClean="0">
                <a:latin typeface="Arial"/>
                <a:cs typeface="Arial"/>
              </a:rPr>
              <a:t>12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MW </a:t>
            </a:r>
            <a:r>
              <a:rPr lang="en-US" dirty="0">
                <a:latin typeface="Arial"/>
                <a:cs typeface="Arial"/>
              </a:rPr>
              <a:t>1946.999, Precursor m/z 974.51 charge 2+, delta(ppm) -</a:t>
            </a:r>
            <a:r>
              <a:rPr lang="en-US" dirty="0" smtClean="0">
                <a:latin typeface="Arial"/>
                <a:cs typeface="Arial"/>
              </a:rPr>
              <a:t>3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0" y="1600200"/>
            <a:ext cx="2714625" cy="22631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124118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latin typeface="Arial"/>
                <a:cs typeface="Arial"/>
              </a:rPr>
              <a:t>Spectrum </a:t>
            </a:r>
            <a:r>
              <a:rPr lang="en-US" dirty="0">
                <a:latin typeface="Arial"/>
                <a:cs typeface="Arial"/>
              </a:rPr>
              <a:t>72c </a:t>
            </a:r>
            <a:r>
              <a:rPr lang="en-US" dirty="0" smtClean="0">
                <a:latin typeface="Arial"/>
                <a:cs typeface="Arial"/>
              </a:rPr>
              <a:t/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IGHA1_HUMAN</a:t>
            </a:r>
            <a:r>
              <a:rPr lang="en-US" dirty="0">
                <a:latin typeface="Arial"/>
                <a:cs typeface="Arial"/>
              </a:rPr>
              <a:t>@144 or KGHA2@131: </a:t>
            </a:r>
            <a:r>
              <a:rPr lang="en-US" dirty="0" err="1">
                <a:latin typeface="Arial"/>
                <a:cs typeface="Arial"/>
              </a:rPr>
              <a:t>GSEA</a:t>
            </a:r>
            <a:r>
              <a:rPr lang="en-US" u="sng" dirty="0" err="1">
                <a:latin typeface="Arial"/>
                <a:cs typeface="Arial"/>
              </a:rPr>
              <a:t>NLT</a:t>
            </a:r>
            <a:r>
              <a:rPr lang="en-US" dirty="0" err="1">
                <a:latin typeface="Arial"/>
                <a:cs typeface="Arial"/>
              </a:rPr>
              <a:t>CTLTGLR_Deamidated</a:t>
            </a:r>
            <a:r>
              <a:rPr lang="en-US" dirty="0">
                <a:latin typeface="Arial"/>
                <a:cs typeface="Arial"/>
              </a:rPr>
              <a:t>(N)@5; </a:t>
            </a:r>
            <a:r>
              <a:rPr lang="en-US" dirty="0" err="1">
                <a:latin typeface="Arial"/>
                <a:cs typeface="Arial"/>
              </a:rPr>
              <a:t>Carbamidomethyl</a:t>
            </a:r>
            <a:r>
              <a:rPr lang="en-US" dirty="0">
                <a:latin typeface="Arial"/>
                <a:cs typeface="Arial"/>
              </a:rPr>
              <a:t>(C)@</a:t>
            </a:r>
            <a:r>
              <a:rPr lang="en-US" dirty="0" smtClean="0">
                <a:latin typeface="Arial"/>
                <a:cs typeface="Arial"/>
              </a:rPr>
              <a:t>8</a:t>
            </a:r>
            <a:br>
              <a:rPr lang="en-US" dirty="0" smtClean="0">
                <a:latin typeface="Arial"/>
                <a:cs typeface="Arial"/>
              </a:rPr>
            </a:br>
            <a:r>
              <a:rPr lang="en-US" dirty="0" smtClean="0">
                <a:latin typeface="Arial"/>
                <a:cs typeface="Arial"/>
              </a:rPr>
              <a:t>MW </a:t>
            </a:r>
            <a:r>
              <a:rPr lang="en-US" dirty="0">
                <a:latin typeface="Arial"/>
                <a:cs typeface="Arial"/>
              </a:rPr>
              <a:t>1492.72, Precursor m/z 747.37 charge 2+, delta(ppm) -</a:t>
            </a:r>
            <a:r>
              <a:rPr lang="en-US" dirty="0" smtClean="0">
                <a:latin typeface="Arial"/>
                <a:cs typeface="Arial"/>
              </a:rPr>
              <a:t>4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18288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1828800"/>
            <a:ext cx="2994949" cy="2057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046673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3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A1_HUMAN</a:t>
            </a:r>
            <a:r>
              <a:rPr lang="pt-BR" dirty="0">
                <a:latin typeface="Arial"/>
                <a:cs typeface="Arial"/>
              </a:rPr>
              <a:t>@340: LAGKPTHV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VVMAEVDGTCY_Deamidated(N)@9; Carbamidomethyl(C)@</a:t>
            </a:r>
            <a:r>
              <a:rPr lang="pt-BR" dirty="0" smtClean="0">
                <a:latin typeface="Arial"/>
                <a:cs typeface="Arial"/>
              </a:rPr>
              <a:t>2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347.12, Precursor m/z 1174.57 charge 2+, delta(ppm) -</a:t>
            </a:r>
            <a:r>
              <a:rPr lang="pt-BR" dirty="0" smtClean="0">
                <a:latin typeface="Arial"/>
                <a:cs typeface="Arial"/>
              </a:rPr>
              <a:t>2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969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6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" y="1905000"/>
            <a:ext cx="2667000" cy="22768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062515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73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IGHA1_HUMAN@340: HV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VVMAEVDGTCY_Deamidated(N)@3; Carbamidomethyl(C)@</a:t>
            </a:r>
            <a:r>
              <a:rPr lang="pt-BR" dirty="0" smtClean="0">
                <a:latin typeface="Arial"/>
                <a:cs typeface="Arial"/>
              </a:rPr>
              <a:t>1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779.781, Precursor m/z 890.9 charge 2+, delta(ppm) -</a:t>
            </a:r>
            <a:r>
              <a:rPr lang="pt-BR" dirty="0" smtClean="0">
                <a:latin typeface="Arial"/>
                <a:cs typeface="Arial"/>
              </a:rPr>
              <a:t>2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0600" y="1676400"/>
            <a:ext cx="3567112" cy="25016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657600" y="2153364"/>
            <a:ext cx="243978" cy="24622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?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3618266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3c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A1_HUMAN</a:t>
            </a:r>
            <a:r>
              <a:rPr lang="pt-BR" dirty="0">
                <a:latin typeface="Arial"/>
                <a:cs typeface="Arial"/>
              </a:rPr>
              <a:t>@340: LAGKPTHV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VVM_Deamidated(N)@</a:t>
            </a:r>
            <a:r>
              <a:rPr lang="pt-BR" dirty="0" smtClean="0">
                <a:latin typeface="Arial"/>
                <a:cs typeface="Arial"/>
              </a:rPr>
              <a:t>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451.781, Precursor m/z 726.9 charge 2+, delta(ppm) -</a:t>
            </a:r>
            <a:r>
              <a:rPr lang="pt-BR" dirty="0" smtClean="0">
                <a:latin typeface="Arial"/>
                <a:cs typeface="Arial"/>
              </a:rPr>
              <a:t>3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331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2057400"/>
            <a:ext cx="2847975" cy="19028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296064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73d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IGHA1_HUMAN@340: PTHV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VVMAEVDGTCY_Deamidated(N)@5; Oxidation(M)@10; Carbamidomethyl(C)@</a:t>
            </a:r>
            <a:r>
              <a:rPr lang="pt-BR" dirty="0" smtClean="0">
                <a:latin typeface="Arial"/>
                <a:cs typeface="Arial"/>
              </a:rPr>
              <a:t>17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993.877, Precursor m/z 997.94 charge 2+, delta(ppm) </a:t>
            </a:r>
            <a:r>
              <a:rPr lang="pt-BR" dirty="0" smtClean="0">
                <a:latin typeface="Arial"/>
                <a:cs typeface="Arial"/>
              </a:rPr>
              <a:t>5.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1600200"/>
            <a:ext cx="3118988" cy="2476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61520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4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A2_HUMAN</a:t>
            </a:r>
            <a:r>
              <a:rPr lang="pt-BR" dirty="0">
                <a:latin typeface="Arial"/>
                <a:cs typeface="Arial"/>
              </a:rPr>
              <a:t>@47: LVQGFFPQEPLSVTWSESGQ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AR_Deamidated(N)@</a:t>
            </a:r>
            <a:r>
              <a:rPr lang="pt-BR" dirty="0" smtClean="0">
                <a:latin typeface="Arial"/>
                <a:cs typeface="Arial"/>
              </a:rPr>
              <a:t>2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777.367, Precursor m/z 1389.69 charge 2+, delta(ppm) </a:t>
            </a:r>
            <a:r>
              <a:rPr lang="pt-BR" dirty="0" smtClean="0">
                <a:latin typeface="Arial"/>
                <a:cs typeface="Arial"/>
              </a:rPr>
              <a:t>0.2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1828800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600200"/>
            <a:ext cx="2433637" cy="32366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018179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8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A2ML1_HUMAN</a:t>
            </a:r>
            <a:r>
              <a:rPr lang="pt-BR" dirty="0">
                <a:latin typeface="Arial"/>
                <a:cs typeface="Arial"/>
              </a:rPr>
              <a:t>@1020: HS</a:t>
            </a:r>
            <a:r>
              <a:rPr lang="pt-BR" u="sng" dirty="0">
                <a:latin typeface="Arial"/>
                <a:cs typeface="Arial"/>
              </a:rPr>
              <a:t>NGS</a:t>
            </a:r>
            <a:r>
              <a:rPr lang="pt-BR" dirty="0">
                <a:latin typeface="Arial"/>
                <a:cs typeface="Arial"/>
              </a:rPr>
              <a:t>YSAFGER_Deamidated(N)@</a:t>
            </a:r>
            <a:r>
              <a:rPr lang="pt-BR" dirty="0" smtClean="0">
                <a:latin typeface="Arial"/>
                <a:cs typeface="Arial"/>
              </a:rPr>
              <a:t>3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311.549, Precursor m/z 656.78 charge 2+, delta(ppm) </a:t>
            </a:r>
            <a:r>
              <a:rPr lang="pt-BR" dirty="0" smtClean="0">
                <a:latin typeface="Arial"/>
                <a:cs typeface="Arial"/>
              </a:rPr>
              <a:t>1.9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2147463"/>
            <a:ext cx="4319395" cy="2244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96849234"/>
      </p:ext>
    </p:extLst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4b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A2_HUMAN</a:t>
            </a:r>
            <a:r>
              <a:rPr lang="pt-BR" dirty="0">
                <a:latin typeface="Arial"/>
                <a:cs typeface="Arial"/>
              </a:rPr>
              <a:t>@47: SVTWSESGQ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AR_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21.71, Precursor m/z 761.86 charge 2+, delta(ppm) </a:t>
            </a:r>
            <a:r>
              <a:rPr lang="pt-BR" dirty="0" smtClean="0">
                <a:latin typeface="Arial"/>
                <a:cs typeface="Arial"/>
              </a:rPr>
              <a:t>3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584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84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1200" y="1905000"/>
            <a:ext cx="2254166" cy="1752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198192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4c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A2_HUMAN</a:t>
            </a:r>
            <a:r>
              <a:rPr lang="pt-BR" dirty="0">
                <a:latin typeface="Arial"/>
                <a:cs typeface="Arial"/>
              </a:rPr>
              <a:t>@47: SVTWSESGQ</a:t>
            </a:r>
            <a:r>
              <a:rPr lang="pt-BR" u="sng" dirty="0">
                <a:latin typeface="Arial"/>
                <a:cs typeface="Arial"/>
              </a:rPr>
              <a:t>NVT</a:t>
            </a:r>
            <a:r>
              <a:rPr lang="pt-BR" dirty="0">
                <a:latin typeface="Arial"/>
                <a:cs typeface="Arial"/>
              </a:rPr>
              <a:t>AR_Oxidation(W)@4; Deamidated(N)@</a:t>
            </a:r>
            <a:r>
              <a:rPr lang="pt-BR" dirty="0" smtClean="0">
                <a:latin typeface="Arial"/>
                <a:cs typeface="Arial"/>
              </a:rPr>
              <a:t>1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537.7, Precursor m/z 769.86 charge 2+, delta(ppm) -</a:t>
            </a:r>
            <a:r>
              <a:rPr lang="pt-BR" dirty="0" smtClean="0">
                <a:latin typeface="Arial"/>
                <a:cs typeface="Arial"/>
              </a:rPr>
              <a:t>3.5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457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000" y="1905000"/>
            <a:ext cx="2720684" cy="2195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64827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5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A2_HUMAN</a:t>
            </a:r>
            <a:r>
              <a:rPr lang="pt-BR" dirty="0">
                <a:latin typeface="Arial"/>
                <a:cs typeface="Arial"/>
              </a:rPr>
              <a:t>@205: TPLTA</a:t>
            </a:r>
            <a:r>
              <a:rPr lang="pt-BR" u="sng" dirty="0">
                <a:latin typeface="Arial"/>
                <a:cs typeface="Arial"/>
              </a:rPr>
              <a:t>NIT</a:t>
            </a:r>
            <a:r>
              <a:rPr lang="pt-BR" dirty="0">
                <a:latin typeface="Arial"/>
                <a:cs typeface="Arial"/>
              </a:rPr>
              <a:t>K_Deamidated(N)@</a:t>
            </a:r>
            <a:r>
              <a:rPr lang="pt-BR" dirty="0" smtClean="0">
                <a:latin typeface="Arial"/>
                <a:cs typeface="Arial"/>
              </a:rPr>
              <a:t>6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958.534, Precursor m/z 480.28 charge 2+, delta(ppm) -</a:t>
            </a:r>
            <a:r>
              <a:rPr lang="pt-BR" dirty="0" smtClean="0">
                <a:latin typeface="Arial"/>
                <a:cs typeface="Arial"/>
              </a:rPr>
              <a:t>12.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0187" y="1600200"/>
            <a:ext cx="7223626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600200"/>
            <a:ext cx="3314701" cy="19285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181285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6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G2_HUMAN</a:t>
            </a:r>
            <a:r>
              <a:rPr lang="pt-BR" dirty="0">
                <a:latin typeface="Arial"/>
                <a:cs typeface="Arial"/>
              </a:rPr>
              <a:t>@176: EEQF</a:t>
            </a:r>
            <a:r>
              <a:rPr lang="pt-BR" u="sng" dirty="0">
                <a:latin typeface="Arial"/>
                <a:cs typeface="Arial"/>
              </a:rPr>
              <a:t>NST</a:t>
            </a:r>
            <a:r>
              <a:rPr lang="pt-BR" dirty="0">
                <a:latin typeface="Arial"/>
                <a:cs typeface="Arial"/>
              </a:rPr>
              <a:t>FR_Deamidated(N)@</a:t>
            </a:r>
            <a:r>
              <a:rPr lang="pt-BR" dirty="0" smtClean="0">
                <a:latin typeface="Arial"/>
                <a:cs typeface="Arial"/>
              </a:rPr>
              <a:t>5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57.5, Precursor m/z 579.76 charge 2+, delta(ppm) -</a:t>
            </a:r>
            <a:r>
              <a:rPr lang="pt-BR" dirty="0" smtClean="0">
                <a:latin typeface="Arial"/>
                <a:cs typeface="Arial"/>
              </a:rPr>
              <a:t>4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096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6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7701" y="2209800"/>
            <a:ext cx="3295650" cy="17759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982895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7a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M_HUMAN</a:t>
            </a:r>
            <a:r>
              <a:rPr lang="pt-BR" dirty="0">
                <a:latin typeface="Arial"/>
                <a:cs typeface="Arial"/>
              </a:rPr>
              <a:t>@209: GLTFQQ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SMCVPDQDTAIR_Deamidated(N)@7; Carbamidomethyl(C)@</a:t>
            </a:r>
            <a:r>
              <a:rPr lang="pt-BR" dirty="0" smtClean="0">
                <a:latin typeface="Arial"/>
                <a:cs typeface="Arial"/>
              </a:rPr>
              <a:t>1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339.05, Precursor m/z 780.69 charge 3+, delta(ppm) </a:t>
            </a:r>
            <a:r>
              <a:rPr lang="pt-BR" dirty="0" smtClean="0">
                <a:latin typeface="Arial"/>
                <a:cs typeface="Arial"/>
              </a:rPr>
              <a:t>0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505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7111" y="1600200"/>
            <a:ext cx="7329777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05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2400" y="1752600"/>
            <a:ext cx="3090862" cy="30319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531129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77b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IGHM_HUMAN@209: GLTFQQ</a:t>
            </a:r>
            <a:r>
              <a:rPr lang="pt-BR" u="sng" dirty="0">
                <a:latin typeface="Arial"/>
                <a:cs typeface="Arial"/>
              </a:rPr>
              <a:t>NAS</a:t>
            </a:r>
            <a:r>
              <a:rPr lang="pt-BR" dirty="0">
                <a:latin typeface="Arial"/>
                <a:cs typeface="Arial"/>
              </a:rPr>
              <a:t>SM_Deamidated(N)@7; Oxidation(M)@</a:t>
            </a:r>
            <a:r>
              <a:rPr lang="pt-BR" dirty="0" smtClean="0">
                <a:latin typeface="Arial"/>
                <a:cs typeface="Arial"/>
              </a:rPr>
              <a:t>1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199.51, Precursor m/z 600.76 charge 2+, delta(ppm) </a:t>
            </a:r>
            <a:r>
              <a:rPr lang="pt-BR" dirty="0" smtClean="0">
                <a:latin typeface="Arial"/>
                <a:cs typeface="Arial"/>
              </a:rPr>
              <a:t>3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072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01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752600"/>
            <a:ext cx="2267799" cy="17573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908577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7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IGHM_HUMAN@272|279: THT</a:t>
            </a:r>
            <a:r>
              <a:rPr lang="pt-BR" u="sng" dirty="0">
                <a:latin typeface="Arial"/>
                <a:cs typeface="Arial"/>
              </a:rPr>
              <a:t>NIS</a:t>
            </a:r>
            <a:r>
              <a:rPr lang="pt-BR" dirty="0">
                <a:latin typeface="Arial"/>
                <a:cs typeface="Arial"/>
              </a:rPr>
              <a:t>ESHP</a:t>
            </a:r>
            <a:r>
              <a:rPr lang="pt-BR" u="sng" dirty="0">
                <a:latin typeface="Arial"/>
                <a:cs typeface="Arial"/>
              </a:rPr>
              <a:t>NAT</a:t>
            </a:r>
            <a:r>
              <a:rPr lang="pt-BR" dirty="0">
                <a:latin typeface="Arial"/>
                <a:cs typeface="Arial"/>
              </a:rPr>
              <a:t>FSAVGEASICEDDW</a:t>
            </a:r>
            <a:r>
              <a:rPr lang="pt-BR" u="sng" dirty="0">
                <a:latin typeface="Arial"/>
                <a:cs typeface="Arial"/>
              </a:rPr>
              <a:t>NSG</a:t>
            </a:r>
            <a:r>
              <a:rPr lang="pt-BR" dirty="0">
                <a:latin typeface="Arial"/>
                <a:cs typeface="Arial"/>
              </a:rPr>
              <a:t>ER_Deamidated(N)@4; Deamidated(N)@11; Carbamidomethyl(C)@23; Deamidated(N)@</a:t>
            </a:r>
            <a:r>
              <a:rPr lang="pt-BR" dirty="0" smtClean="0">
                <a:latin typeface="Arial"/>
                <a:cs typeface="Arial"/>
              </a:rPr>
              <a:t>28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520.46, Precursor m/z 881.13 charge 4+, delta(ppm) -</a:t>
            </a:r>
            <a:r>
              <a:rPr lang="pt-BR" dirty="0" smtClean="0">
                <a:latin typeface="Arial"/>
                <a:cs typeface="Arial"/>
              </a:rPr>
              <a:t>8.8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1741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52600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05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200" y="2153771"/>
            <a:ext cx="3733800" cy="3041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49535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</a:t>
            </a:r>
            <a:r>
              <a:rPr lang="pt-BR" dirty="0">
                <a:latin typeface="Arial"/>
                <a:cs typeface="Arial"/>
              </a:rPr>
              <a:t>79 </a:t>
            </a:r>
            <a:r>
              <a:rPr lang="pt-BR" dirty="0" smtClean="0">
                <a:latin typeface="Arial"/>
                <a:cs typeface="Arial"/>
              </a:rPr>
              <a:t/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IGHM_HUMAN</a:t>
            </a:r>
            <a:r>
              <a:rPr lang="pt-BR" dirty="0">
                <a:latin typeface="Arial"/>
                <a:cs typeface="Arial"/>
              </a:rPr>
              <a:t>@439: STGKPTLY</a:t>
            </a:r>
            <a:r>
              <a:rPr lang="pt-BR" u="sng" dirty="0">
                <a:latin typeface="Arial"/>
                <a:cs typeface="Arial"/>
              </a:rPr>
              <a:t>NVS</a:t>
            </a:r>
            <a:r>
              <a:rPr lang="pt-BR" dirty="0">
                <a:latin typeface="Arial"/>
                <a:cs typeface="Arial"/>
              </a:rPr>
              <a:t>LVMSDTAGTCY_Deamidated(N)@9; Oxidation(M)@14; Carbamidomethyl(C)@</a:t>
            </a:r>
            <a:r>
              <a:rPr lang="pt-BR" dirty="0" smtClean="0">
                <a:latin typeface="Arial"/>
                <a:cs typeface="Arial"/>
              </a:rPr>
              <a:t>21439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2381.077, Precursor m/z 1191.54 charge 2+, delta(ppm) </a:t>
            </a:r>
            <a:r>
              <a:rPr lang="pt-BR" dirty="0" smtClean="0">
                <a:latin typeface="Arial"/>
                <a:cs typeface="Arial"/>
              </a:rPr>
              <a:t>4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653571"/>
            <a:ext cx="8229600" cy="4419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1676400"/>
            <a:ext cx="4162425" cy="35055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6588870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80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IGJ_HUMAN@71: E</a:t>
            </a:r>
            <a:r>
              <a:rPr lang="pt-BR" u="sng" dirty="0">
                <a:latin typeface="Arial"/>
                <a:cs typeface="Arial"/>
              </a:rPr>
              <a:t>NIS</a:t>
            </a:r>
            <a:r>
              <a:rPr lang="pt-BR" dirty="0">
                <a:latin typeface="Arial"/>
                <a:cs typeface="Arial"/>
              </a:rPr>
              <a:t>DPTSPLR_Deamidated(N)@</a:t>
            </a:r>
            <a:r>
              <a:rPr lang="pt-BR" dirty="0" smtClean="0">
                <a:latin typeface="Arial"/>
                <a:cs typeface="Arial"/>
              </a:rPr>
              <a:t>2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1228.59, Precursor m/z 615.3 charge 2+, delta(ppm) </a:t>
            </a:r>
            <a:r>
              <a:rPr lang="pt-BR" dirty="0" smtClean="0">
                <a:latin typeface="Arial"/>
                <a:cs typeface="Arial"/>
              </a:rPr>
              <a:t>3.7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32770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8940" y="1600200"/>
            <a:ext cx="686612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10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4025" y="2281238"/>
            <a:ext cx="2619375" cy="1692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968950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Autofit/>
          </a:bodyPr>
          <a:lstStyle/>
          <a:p>
            <a:r>
              <a:rPr lang="pt-BR" dirty="0" smtClean="0">
                <a:latin typeface="Arial"/>
                <a:cs typeface="Arial"/>
              </a:rPr>
              <a:t>Spectrum 8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 </a:t>
            </a:r>
            <a:r>
              <a:rPr lang="pt-BR" dirty="0">
                <a:latin typeface="Arial"/>
                <a:cs typeface="Arial"/>
              </a:rPr>
              <a:t>KLK1_HUMAN@102|108: HNLFDDENTAQFVHVSESFPHPGF</a:t>
            </a:r>
            <a:r>
              <a:rPr lang="pt-BR" u="sng" dirty="0">
                <a:latin typeface="Arial"/>
                <a:cs typeface="Arial"/>
              </a:rPr>
              <a:t>NMS</a:t>
            </a:r>
            <a:r>
              <a:rPr lang="pt-BR" dirty="0">
                <a:latin typeface="Arial"/>
                <a:cs typeface="Arial"/>
              </a:rPr>
              <a:t>LLE</a:t>
            </a:r>
            <a:r>
              <a:rPr lang="pt-BR" u="sng" dirty="0">
                <a:latin typeface="Arial"/>
                <a:cs typeface="Arial"/>
              </a:rPr>
              <a:t>NHT</a:t>
            </a:r>
            <a:r>
              <a:rPr lang="pt-BR" dirty="0">
                <a:latin typeface="Arial"/>
                <a:cs typeface="Arial"/>
              </a:rPr>
              <a:t>R_Deamidated(N)@25; Deamidated(N)@</a:t>
            </a:r>
            <a:r>
              <a:rPr lang="pt-BR" dirty="0" smtClean="0">
                <a:latin typeface="Arial"/>
                <a:cs typeface="Arial"/>
              </a:rPr>
              <a:t>31</a:t>
            </a:r>
            <a:br>
              <a:rPr lang="pt-BR" dirty="0" smtClean="0">
                <a:latin typeface="Arial"/>
                <a:cs typeface="Arial"/>
              </a:rPr>
            </a:br>
            <a:r>
              <a:rPr lang="pt-BR" dirty="0" smtClean="0">
                <a:latin typeface="Arial"/>
                <a:cs typeface="Arial"/>
              </a:rPr>
              <a:t>MW </a:t>
            </a:r>
            <a:r>
              <a:rPr lang="pt-BR" dirty="0">
                <a:latin typeface="Arial"/>
                <a:cs typeface="Arial"/>
              </a:rPr>
              <a:t>3967.787, Precursor m/z 794.56 charge 5+, delta(ppm) </a:t>
            </a:r>
            <a:r>
              <a:rPr lang="pt-BR" dirty="0" smtClean="0">
                <a:latin typeface="Arial"/>
                <a:cs typeface="Arial"/>
              </a:rPr>
              <a:t>5.6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63144"/>
            <a:ext cx="8229600" cy="420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1524000"/>
            <a:ext cx="3252787" cy="38516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871335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5</TotalTime>
  <Words>361</Words>
  <Application>Microsoft Macintosh PowerPoint</Application>
  <PresentationFormat>On-screen Show (4:3)</PresentationFormat>
  <Paragraphs>194</Paragraphs>
  <Slides>184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4</vt:i4>
      </vt:variant>
    </vt:vector>
  </HeadingPairs>
  <TitlesOfParts>
    <vt:vector size="185" baseType="lpstr">
      <vt:lpstr>Office Theme</vt:lpstr>
      <vt:lpstr>PowerPoint Presentation</vt:lpstr>
      <vt:lpstr>Spectrum 1  4F2_HUMAN@424: SLVTQYLNATGNR_Deamidated(N)@8 MW 1436.73, Precursor m/z 719.37 charge 2+, delta(ppm) 3.1 </vt:lpstr>
      <vt:lpstr>Spectrum 2  A1AT_HUMAN@107: ADTHDEILEGLNFNLTEIPEAQIHEGFQELLR_Deamidated(N)@14 MW 3691.801, Precursor m/z 923.95 charge 4+, delta(ppm) 8  </vt:lpstr>
      <vt:lpstr>Spectrum 3 A1AT_HUMAN@271: YLGNATAIFFLPDEGK_Deamidated(N)@4 MW 1755.87, Precursor m/z 878.94 charge 2+, delta(ppm) 2.6  </vt:lpstr>
      <vt:lpstr>Spectrum 4 A2GL_HUMAN@186: LPPGLLANFTLLR_Deamidated(N)@8 MW 1424.84, Precursor m/z 713.43 charge 2+, delta(ppm) -4.4  </vt:lpstr>
      <vt:lpstr>Spectrum 5  A2ML1_HUMAN@120: QGNGTFVQTDKPLYTPGQQVYFR_Deamidated(N)@3 MW 2644.293, Precursor m/z 882.44 charge 3+, delta(ppm) -2.2</vt:lpstr>
      <vt:lpstr>Spectrum 6  A2ML1_HUMAN@409: TLETSGWNGTDVSLEGK_Deamidated(N)@8 MW 1793.832, Precursor m/z 897.92 charge 2+, delta(ppm) 3.6</vt:lpstr>
      <vt:lpstr>Spectrum 7 A2ML1_HUMAN@857: THHWNITAVK_Deamidated(N)@5 MW 1206.615, Precursor m/z 403.21 charge 3+, delta(ppm) 5.2  </vt:lpstr>
      <vt:lpstr>Spectrum 8  A2ML1_HUMAN@1020: HSNGSYSAFGER_Deamidated(N)@3 MW 1311.549, Precursor m/z 656.78 charge 2+, delta(ppm) 1.9</vt:lpstr>
      <vt:lpstr>Spectrum 9 AACT_HUMAN@271: YTGNASALFILPDQDK_Deamidated(N)@4 MW 1752.858, Precursor m/z 877.44 charge 2+, delta(ppm) -4.8  </vt:lpstr>
      <vt:lpstr>Spectrum 10 AGAL_HUMAN@139: LGIYADVGNK_Deamidated(N)@9 MW 1049.54, Precursor m/z 525.78 charge 2+, delta(ppm) -5.1  </vt:lpstr>
      <vt:lpstr>Spectrum 11  AMY1_HUMAN@427: NVVDGQPFTNWYDNGSNQVAFGR_Deamidated(N)@14 MW 2585.158, Precursor m/z 1293.58 charge 2+, delta(ppm) 4.5</vt:lpstr>
      <vt:lpstr>Spectrum 12a AMY1_HUMAN@476: INGNCTGIK_Ammonia-loss(N)@2; Deamidated(N)@4, Carbamidomethyl(C)@5 MW 959.439, Precursor m/z 480.73 charge 2+, delta(ppm) -7.5  </vt:lpstr>
      <vt:lpstr>Spectrum 12b AMY1_HUMAN@476: ISGDKINGNCTGIK_Deamidated(N)@7; Deamidated(N)@9; Carbamidomethyl(C)@10 MW 1477.709, Precursor m/z 739.86 charge 2+, delta(ppm) 1.8  </vt:lpstr>
      <vt:lpstr> Spectrum 12c AMY1_HUMAN@476: VISGDKINGNCTGIK_Deamidated(N)@8; Deamidated(N)@10; Carbamidomethyl(C)@11 MW 1576.777, Precursor m/z 789.4 charge 2+, delta(ppm) -5.6  </vt:lpstr>
      <vt:lpstr>Spectrum 13 ANGP1_HUMAN@154: LTDVETQVLNQTSR_Deamidated(N)@10 MW 1603.81, Precursor m/z 802.91 charge 2+, delta(ppm) 2.8  </vt:lpstr>
      <vt:lpstr> Spectrum 14 ANGP1_HUMAN@295: DCADVYQAGFNK_Carbamidomethyl(C)@2; Deamidated(N)@11 MW 1387.57, Precursor m/z 694.79 charge 2+, delta(ppm) 3.2  </vt:lpstr>
      <vt:lpstr> Spectrum 15 APOD_HUMAN@98: ADGTVNQIEGEATPVNLTEPAKLEVK_Deamidated(N)@16 MW 2723.387, Precursor m/z 908.81 charge 3+, delta(ppm) -7.9  </vt:lpstr>
      <vt:lpstr>Spectrum 16 APOH_HUMAN@162: VYKPSAGNNSLYR_Deamidated(N)@8 MW 1468.732, Precursor m/z 490.58 charge 3+, delta(ppm) 8.7 </vt:lpstr>
      <vt:lpstr>Spectrum 17 ASAH1_HUMAN@259: TVLENSTSYEEAK_Deamidated(N)@5 MW 1470.673, Precursor m/z 736.34 charge 2+, delta(ppm) 4.8 </vt:lpstr>
      <vt:lpstr>Spectrum 18 ATRN_HUMAN@416: IDSTGNVTNELR_Deamidated(N)@6 MW 1318.64, Precursor m/z 660.33 charge 2+, delta(ppm) -4.1 </vt:lpstr>
      <vt:lpstr>Spectrum 19a BPIA2_HUMAN@124|132: GLNLSFPVTANVTVAGPIIGQIINLK_Deamidated(N)@3; Deamidated(N)@11 MW 2650.495, Precursor m/z 884.51 charge 3+, delta(ppm) -5.1  </vt:lpstr>
      <vt:lpstr>Spectrum 19b BPIA2_HUMAN@124|132: GLNLSFPVTANVT_Deamidated(N)@3; Deamidated(N)@11 MW 1333.677, Precursor m/z 667.85 charge 2+, delta(ppm) -6.7 </vt:lpstr>
      <vt:lpstr>Spectrum 19c BPIA2_HUMAN@132: TANVTVAGPIIGQIINLK_Deamidated(N)@3 MW 1822.057, Precursor m/z 912.03 charge 2+, delta(ppm) 6</vt:lpstr>
      <vt:lpstr>Spectrum 20 BPIB2_HUMAN@96: LLAAANFTFK_Deamidated(N)@6 MW 1095.597, Precursor m/z 548.81 charge 2+, delta(ppm) -8.2</vt:lpstr>
      <vt:lpstr>Spectrum 21 BPIB2_HUMAN@293: SDDNLLNTSALGR_Deamidated(N)@7 MW 1375.66, Precursor m/z 688.84 charge 2+, delta(ppm) -3.9 </vt:lpstr>
      <vt:lpstr>Spectrum 22 BPIB2_HUMAN@332: LGATPVAMLHTNNATLR_Deamidated(N)@13 MW 1779.931, Precursor m/z 890.97 charge 2+, delta(ppm) 2.6 </vt:lpstr>
      <vt:lpstr>Spectrum 23 BTD_HUMAN@150: FNDTEVLQR_Deamidated(N)@2 MW 1121.54, Precursor m/z 561.78 charge 2+, delta(ppm) -4.8</vt:lpstr>
      <vt:lpstr>Spectrum 24  BTD_HUMAN@349: NPVGLIGAENATGETDPSHSK_Deamidated(N)@10 MW 2093.99, Precursor m/z 1048 charge 2+, delta(ppm) 2.1</vt:lpstr>
      <vt:lpstr>Spectrum 25  C1QT3_HUMAN@71: TGTVDNNTSTDLK_Deamidated(N)@6 MW 1365.63, Precursor m/z 683.82 charge 2+, delta(ppm) 3.3</vt:lpstr>
      <vt:lpstr>Spectrum 25a C1QT3_HUMAN@70|71: TGTVDNNTSTDLK_Deamidated(N)@6; Deamidated(N)@7 MW 1366.61, Precursor m/z 684.31 charge 2+, delta(ppm) 3.3</vt:lpstr>
      <vt:lpstr>Spectrum 26a CAH6_HUMAN@67: GLNM-&gt;LTGYETQAGEFPMVNNGHTVQISLPSTMR MW 3463.64, Precursor m/z 1155.55 charge 3, delta(ppm) 4.2</vt:lpstr>
      <vt:lpstr>Spectrum 26b CAH6_HUMAN@67: GLNM-&gt;LTGYETQAGEFPMVNNGHTVQIS-&gt;GLPSTMR MW 3434.61, Precursor m/z 1145.88 charge 3, delta(ppm) -1.6</vt:lpstr>
      <vt:lpstr>Spectrum 27a CAH6_HUMAN@256: LENSLLDHRNK_Deamidated(N)@10 MW 1338.69, Precursor m/z 670.35 charge 2+, delta(ppm) 3.4</vt:lpstr>
      <vt:lpstr>Spectrum 27b CAH6_HUMAN@256: NKTIHNDYR_Deamidated(N)@1; Formyl(K)@2 MW 1188.55, Precursor m/z 595.28 charge 2+, delta(ppm) 3.8</vt:lpstr>
      <vt:lpstr>Spectrum 28  CALL5_HUMAN@25: AFSAVDTDGNGTINAQELGAALK_Deamidated(N)@10 MW 2263.097, Precursor m/z 1132.56 charge 2+, delta(ppm) -3.8</vt:lpstr>
      <vt:lpstr>Spectrum 29 CATD_HUMAN@263: GSLSYLNVTR_Deamidated(N)@7 MW 1109.57, Precursor m/z 555.79 charge 2+, delta(ppm) 4.1</vt:lpstr>
      <vt:lpstr>Spectrum 30 CBPD_HUMAN@522: FANEYPNITR_Deamidated(N)@7 MW 1224.58, Precursor m/z 613.3 charge 2+, delta(ppm) -4.4</vt:lpstr>
      <vt:lpstr>Spectrum 31 CBPD_HUMAN@1070: DLDTDFTNNASQPETK_Deamidated(N)@9 MW 1795.77, Precursor m/z 898.89 charge 2+, delta(ppm) 2.5</vt:lpstr>
      <vt:lpstr>Spectrum 32 CBPE_HUMAN@139: GNETIVNLIHSTR_Deamidated(N)@2 MW 1453.753, Precursor m/z 727.88 charge 2+, delta(ppm) 4.8</vt:lpstr>
      <vt:lpstr>Spectrum 33  CERU_HUMAN@138: EHEGAIYPDNTTDFQR_Deamidated(N)@10 MW 1892.818, Precursor m/z 631.9462 charge 3+, delta(ppm) 0.5</vt:lpstr>
      <vt:lpstr>Spectrum 34a  CF058_HUMAN@24: GTSNLSETEPPLWK_Deamidated(N)@4 MW 1558.75, Precursor m/z 780.38 charge 2+, delta(ppm) 2.9</vt:lpstr>
      <vt:lpstr>Spectrum 34b CF058_HUMAN@24: SNLSETEPPLWK_Deamidated(N)@2 MW 1400.683, Precursor m/z 701.35 charge 2+, delta(ppm) -2.2</vt:lpstr>
      <vt:lpstr> Spectrum 35  CF058_HUMAN@69: IILNQTAR_Deamidated(N)@4 MW 928.535, Precursor m/z 465.28 charge 2+, delta(ppm) -12</vt:lpstr>
      <vt:lpstr>Spectrum 36  CLIC1_HUMAN@42: GVTFNVTTVDTK_Deamidated(N)@5 MW 1281.65, Precursor m/z 641.83 charge 2+, delta(ppm) 3.5</vt:lpstr>
      <vt:lpstr>Spectrum 37  CLUS_HUMAN@374: LANLTQGEDQYYLR_Deamidated(N)@3 MW 1683.81, Precursor m/z 842.91 charge 2+, delta(ppm) 2.7</vt:lpstr>
      <vt:lpstr>Spectrum 38  CNTRL_HUMAN@153: NLSYNK_Deamidated(N)@1 MW 738.355, Precursor m/z 739.36 charge 1+, delta(ppm) 2.8</vt:lpstr>
      <vt:lpstr>Spectrum 39  CO4A_HUMAN@226: FSDGLESNSSTQFEVK_Deamidated(N)@8 MW 1774.79, Precursor m/z 888.4 charge 2+, delta(ppm) 2.4</vt:lpstr>
      <vt:lpstr>  Spectrum 40  CO4A_HUMAN@1328: GLNVTLSSTGR_Deamidated(N)@3 MW 1104.578, Precursor m/z 553.3 charge 2+, delta(ppm) -7.1 </vt:lpstr>
      <vt:lpstr>Spectrum 41  CO6A1_HUMAN@212: NFTAADWGQSR_Deamidated(N)@1 MW 1252.548, Precursor m/z 627.28 charge 2+, delta(ppm) 1.4</vt:lpstr>
      <vt:lpstr>Spectrum 42  CO6A1_HUMAN@516: GEDGPAGNGTEGFPGFPGYPGNR_Deamidated(N)@8 MW 2249.962, Precursor m/z 1125.9873 charge 2+, delta(ppm) 0.6</vt:lpstr>
      <vt:lpstr>Spectrum 43  CO6A2_HUMAN@140: GTFTDCALANMTEQIR_Carbamidomethyl(C)@6; Deamidated(N)@10; Oxidation(M)@11 MW 1843.81, Precursor m/z 922.91 charge 2+, delta(ppm) 2.4 </vt:lpstr>
      <vt:lpstr>Spectrum 44a  COEA1_HUMAN@1384: AMNASANITSDGVEVLGK_Oxidation(M)@2; Deamidated(N)@3 MW 1792.85, Precursor m/z 897.43 charge 2+, delta(ppm) 2.5</vt:lpstr>
      <vt:lpstr>Spectrum 44b  COEA1_HUMAN@1384|1388: AMNASANITSDGVEVLGK_Oxidation(M)@2; Deamidated(N)@3; Deamidated(N)@7 MW 1793.84, Precursor m/z 897.92 charge 2+, delta(ppm) 8.1</vt:lpstr>
      <vt:lpstr>Spectrum 45  DAF_HUMAN@95: GSQWSDIEEFCNR_Carbamidomethyl(C)@11; Deamidated(N)@12 MW 1627.66, Precursor m/z 814.84 charge 2+, delta(ppm) -3.3 </vt:lpstr>
      <vt:lpstr>Spectrum 46  DMBT1_HUMAN@1889: LVNLNSSYGLCAGR_Carbamidomethyl(C)@11; Deamidated(N)@5 MW 1523.74, Precursor m/z 762.88 charge 2+, delta(ppm) -3.5</vt:lpstr>
      <vt:lpstr> Spectrum 47  DNER_HUMAN@223: LVSFEVPQNTSVK_Deamidated(N)@9 MW 1447.76, Precursor m/z 724.88 charge 2+, delta(ppm) 10</vt:lpstr>
      <vt:lpstr>Spectrum 48  DSC2_HUMAN@34: NVTLHVPSK_Deamidated(N)@1 MW 994.545, Precursor m/z 498.28 charge 2+, delta(ppm) -0.7</vt:lpstr>
      <vt:lpstr>Spectrum 49  DSG1_HUMAN@110: TGEINITSIVDR_Deamidated(N)@5 MW 1317.678, Precursor m/z 659.84 charge 2+, delta(ppm) 9.2</vt:lpstr>
      <vt:lpstr>Spectrum 50  FAM3D_HUMAN@107: GLNIALVNGTTGAVLGQK_Deamidated(N)@8 MW 1725.963, Precursor m/z 863.99 charge 2+, delta(ppm) -1.7</vt:lpstr>
      <vt:lpstr>Spectrum 51  FCGBP_HUMAN@75: LLISSLSESPASVSILSQADNTSK_Deamidated(N)@21 MW 2447.265, Precursor m/z 1224.64 charge 2+, delta(ppm) -0.4</vt:lpstr>
      <vt:lpstr>Spectrum 52  FCGBP_HUMAN@91: VTVRPGESVMVNISAK_Deamidated(N)@12 MW 1686.898, Precursor m/z 563.31 charge 3+, delta(ppm) -6.3 </vt:lpstr>
      <vt:lpstr>Spectrum 53  FCGBP_HUMAN@1317: VITVQVANFTLR_Deamidated(N)@8 MW 1360.772, Precursor m/z 681.39 charge 2+, delta(ppm) 4.4</vt:lpstr>
      <vt:lpstr>Spectrum 54  FCGBP_HUMAN@1743: VVTVAALGTNISIHKDEIGK_Deamidated(N)@10 MW 2065.142, Precursor m/z 689.38 charge 3+, delta(ppm) 11.5</vt:lpstr>
      <vt:lpstr>Spectrum 55  FCGBP_HUMAN@2111: HGPPLGAENFTVTVANEHR_Deamidated(N)@9 MW 2045.992, Precursor m/z 683 charge 3+, delta(ppm) 6.7</vt:lpstr>
      <vt:lpstr>Spectrum 56  FCGBP_HUMAN@4232: NPNNDQVFPNGTLAPSIPIWGGSWR_Deamidated(N)@10 MW 2737.325, Precursor m/z 913.45 charge 3+, delta(ppm) -1.2</vt:lpstr>
      <vt:lpstr>Spectrum 57  FCGBP_HUMAN@5186: YLPVNSSLLTSDCSER_Deamidated(N)@5; Carbamidomethyl(C)@13 MW 1840.852, Precursor m/z 921.43 charge 2+, delta(ppm) 3.2</vt:lpstr>
      <vt:lpstr>Spectrum 58  FCGBP_HUMAN@5242: SVGANLTTFDGAR_Deamidated(N)@5 MW 1308.632, Precursor m/z 655.32 charge 2+, delta(ppm) 4.2</vt:lpstr>
      <vt:lpstr>Spectrum 59  FIBB_HUMAN@394: ALMDGASQLMGENR_Oxidation(M)@3; Oxidation(M)@10; Deamidated(N)@13 MW 1524.655, Precursor m/z 763.33 charge 2+, delta(ppm) 6.1</vt:lpstr>
      <vt:lpstr>Spectrum 60  FIBG_HUMAN@78: VDKDLQSLEDILHQVENK_Deamidated(N)@17 MW 2123.075, Precursor m/z 708.7 charge 3+, delta(ppm) -1.6</vt:lpstr>
      <vt:lpstr>Spectrum 61  FSTL1_HUMAN@144: GSNYSEILDK_Deamidated(N)@3 MW 1125.52, Precursor m/z 563.77 charge 2+, delta(ppm) -5.7</vt:lpstr>
      <vt:lpstr>Spectrum 62  FURIN_HUMAN@440: LAQNWTTVAPQR_Deamidated(N)@4 MW 1384.71, Precursor m/z 693.36 charge 2+, delta(ppm) 3.2</vt:lpstr>
      <vt:lpstr>Spectrum 63 GOLM1_HUMAN@109: AVLVNNITTGER_Deamidated(N)@6 MW 1286.684, Precursor m/z 644.35 charge 2+, delta(ppm) -1.8</vt:lpstr>
      <vt:lpstr>Spectrum 64  GTR11_HUMAN@289: GTR11_HUMAN@289: ALRRQVTSLVVLGSAMELCGNDSVYAYASSVFR_Carbamidomethyl(C)@19; Deamidated(N)@21 MW 3619.813, Precursor m/z 905.96 charge 4+, delta(ppm) -0.5</vt:lpstr>
      <vt:lpstr>Spectrum 65  HEMO_HUMAN@187: SWPAVGNCSSALR_Deamidated(N)@7; Carbamidomethyl(C)@8 MW 1404.646, Precursor m/z 703.33 charge 2+, delta(ppm) 0.1</vt:lpstr>
      <vt:lpstr>Spectrum 66  HEXA_HUMAN@157: SAEGTFFINK_Deamidated(N)@9 MW 1113.53, Precursor m/z 557.77 charge 2+, delta(ppm) 4</vt:lpstr>
      <vt:lpstr>Spectrum 67  HPT_HUMAN@207|211: NLFLNHSENATAK_Deamidated(N)@5; Deamidated(N)@9 MW 1459.695, Precursor m/z 730.85 charge 2+, delta(ppm) 6</vt:lpstr>
      <vt:lpstr>Spectrum 68  HPT_HUMAN@241: VVLHPNYSQVDIGLIK_Deamidated(N)@6 MW 1794.989, Precursor m/z 599.34 charge 3+, delta(ppm) -5.6</vt:lpstr>
      <vt:lpstr> Spectrum 69  HYOU1_HUMAN@515: VFGSQNLTTVK_Deamidated(N)@6 MW 1193.63, Precursor m/z 597.82 charge 2+, delta(ppm) 3.8</vt:lpstr>
      <vt:lpstr>Spectrum 70  HYOU1_HUMAN@596: ENGTDTVQEEEESPAEGSK_Deamidated(N)@2 MW 2035.835, Precursor m/z 1018.92 charge 2+, delta(ppm) 4.3</vt:lpstr>
      <vt:lpstr>Spectrum 71  HYOU1_HUMAN@931: AEPPLNASASDQGEK_Deamidated(N)@6 MW 1513.69, Precursor m/z 757.85 charge 2+, delta(ppm) 2.7 </vt:lpstr>
      <vt:lpstr>Spectrum 72a  IGHA1_HUMAN@144 or KGHA2@131: PALEDLLLGSEANLTCTLTGLR_Deamidated(N)@13; Carbamidomethyl(C)@16 MW 2357.21, Precursor m/z 1179.61 charge 2+, delta(ppm) 1.9</vt:lpstr>
      <vt:lpstr>Spectrum 72b  IGHA1_HUMAN@144 or KGHA2@131: DLLLGSEANLTCTLTGLR_Deamidated(N)@9; Carbamidomethyl(C)@12 MW 1946.999, Precursor m/z 974.51 charge 2+, delta(ppm) -3.6</vt:lpstr>
      <vt:lpstr>Spectrum 72c  IGHA1_HUMAN@144 or KGHA2@131: GSEANLTCTLTGLR_Deamidated(N)@5; Carbamidomethyl(C)@8 MW 1492.72, Precursor m/z 747.37 charge 2+, delta(ppm) -4.2</vt:lpstr>
      <vt:lpstr>Spectrum 73a  IGHA1_HUMAN@340: LAGKPTHVNVSVVMAEVDGTCY_Deamidated(N)@9; Carbamidomethyl(C)@21 MW 2347.12, Precursor m/z 1174.57 charge 2+, delta(ppm) -2.3</vt:lpstr>
      <vt:lpstr>Spectrum 73b  IGHA1_HUMAN@340: HVNVSVVMAEVDGTCY_Deamidated(N)@3; Carbamidomethyl(C)@15 MW 1779.781, Precursor m/z 890.9 charge 2+, delta(ppm) -2.6</vt:lpstr>
      <vt:lpstr>Spectrum 73c  IGHA1_HUMAN@340: LAGKPTHVNVSVVM_Deamidated(N)@9 MW 1451.781, Precursor m/z 726.9 charge 2+, delta(ppm) -3.3</vt:lpstr>
      <vt:lpstr>Spectrum 73d  IGHA1_HUMAN@340: PTHVNVSVVMAEVDGTCY_Deamidated(N)@5; Oxidation(M)@10; Carbamidomethyl(C)@17 MW 1993.877, Precursor m/z 997.94 charge 2+, delta(ppm) 5.3</vt:lpstr>
      <vt:lpstr>Spectrum 74a  IGHA2_HUMAN@47: LVQGFFPQEPLSVTWSESGQNVTAR_Deamidated(N)@21 MW 2777.367, Precursor m/z 1389.69 charge 2+, delta(ppm) 0.2</vt:lpstr>
      <vt:lpstr>Spectrum 74b  IGHA2_HUMAN@47: SVTWSESGQNVTAR_Deamidated(N)@10 MW 1521.71, Precursor m/z 761.86 charge 2+, delta(ppm) 3</vt:lpstr>
      <vt:lpstr>Spectrum 74c  IGHA2_HUMAN@47: SVTWSESGQNVTAR_Oxidation(W)@4; Deamidated(N)@10 MW 1537.7, Precursor m/z 769.86 charge 2+, delta(ppm) -3.5</vt:lpstr>
      <vt:lpstr>Spectrum 75  IGHA2_HUMAN@205: TPLTANITK_Deamidated(N)@6 MW 958.534, Precursor m/z 480.28 charge 2+, delta(ppm) -12.4</vt:lpstr>
      <vt:lpstr>Spectrum 76  IGHG2_HUMAN@176: EEQFNSTFR_Deamidated(N)@5 MW 1157.5, Precursor m/z 579.76 charge 2+, delta(ppm) -4.7</vt:lpstr>
      <vt:lpstr>Spectrum 77a  IGHM_HUMAN@209: GLTFQQNASSMCVPDQDTAIR_Deamidated(N)@7; Carbamidomethyl(C)@12 MW 2339.05, Precursor m/z 780.69 charge 3+, delta(ppm) 0.7</vt:lpstr>
      <vt:lpstr>Spectrum 77b  IGHM_HUMAN@209: GLTFQQNASSM_Deamidated(N)@7; Oxidation(M)@11 MW 1199.51, Precursor m/z 600.76 charge 2+, delta(ppm) 3.8</vt:lpstr>
      <vt:lpstr>Spectrum 78  IGHM_HUMAN@272|279: THTNISESHPNATFSAVGEASICEDDWNSGER_Deamidated(N)@4; Deamidated(N)@11; Carbamidomethyl(C)@23; Deamidated(N)@28 MW 3520.46, Precursor m/z 881.13 charge 4+, delta(ppm) -8.8</vt:lpstr>
      <vt:lpstr>Spectrum 79  IGHM_HUMAN@439: STGKPTLYNVSLVMSDTAGTCY_Deamidated(N)@9; Oxidation(M)@14; Carbamidomethyl(C)@21439 MW 2381.077, Precursor m/z 1191.54 charge 2+, delta(ppm) 4.7</vt:lpstr>
      <vt:lpstr>Spectrum 80  IGJ_HUMAN@71: ENISDPTSPLR_Deamidated(N)@2 MW 1228.59, Precursor m/z 615.3 charge 2+, delta(ppm) 3.7</vt:lpstr>
      <vt:lpstr>Spectrum 81  KLK1_HUMAN@102|108: HNLFDDENTAQFVHVSESFPHPGFNMSLLENHTR_Deamidated(N)@25; Deamidated(N)@31 MW 3967.787, Precursor m/z 794.56 charge 5+, delta(ppm) 5.6</vt:lpstr>
      <vt:lpstr>Spectrum 82  KLK11_HUMAN@131: TATESFPHPGFNNSLPNK_Deamidated(N)@12 MW 1957.918, Precursor m/z 979.97 charge 2+, delta(ppm) -4.3</vt:lpstr>
      <vt:lpstr>Spectrum 83  KLK11_HUMAN@197: CANITIIEHQK_Carbamidomethyl(C)@1; Deamidated(N)@3 MW 1326.661, Precursor m/z 664.33 charge 2+, delta(ppm) 11.1</vt:lpstr>
      <vt:lpstr>Spectrum 84  KNG1_HUMAN@294: LNAENNATFYFK_Deamidated(N)@6 MW 1432.67, Precursor m/z 716.84 charge 2+, delta(ppm) -1.9</vt:lpstr>
      <vt:lpstr>Spectrum 85  LAMA4_HUMAN@810: RPASNVSASIQR_Deamidated(N)@5 MW 1285.67, Precursor m/z 643.84 charge 2+, delta(ppm) 3.5</vt:lpstr>
      <vt:lpstr>Spectrum 86  LG3BP_HUMAN@69: ALGFENATQALGR_Deamidated(N)@6 MW 1347.68, Precursor m/z 674.85 charge 2+, delta(ppm) -4</vt:lpstr>
      <vt:lpstr>Spectrum 87  LG3BP_HUMAN@125: DAGVVCTNETR_Carbamidomethyl(C)@6; Deamidated(N)@8 MW 1221.53, Precursor m/z 611.77 charge 2+, delta(ppm) 3.3</vt:lpstr>
      <vt:lpstr>Spectrum 88  LG3BP_HUMAN@192: EPGSNVTMSVDAECVPMVR_Deamidated(N)@5; Oxidation(M)@8; Carbamidomethyl(C)@14; Oxidation(M)@17 MW 2109.9, Precursor m/z 1055.96 charge 2+, delta(ppm) -2.5</vt:lpstr>
      <vt:lpstr>Spectrum 89  LG3BP_HUMAN@398: GLNLTEDTYKPR_Deamidated(N)@3 MW 1406.7, Precursor m/z 704.36 charge 2+, delta(ppm) -3.8</vt:lpstr>
      <vt:lpstr>Spectrum 90  LG3BP_HUMAN@551: AAIPSALDTNSSK_Deamidated(N)@10 MW 1274.636, Precursor m/z 638.33 charge 2+, delta(ppm) -7.8</vt:lpstr>
      <vt:lpstr>Spectrum 91  LG3BP_HUMAN@580: TVIRPFYLTNSSGVD_Deamidated(N)@10 MW 1668.84, Precursor m/z 835.42 charge 2+, delta(ppm) 8.7</vt:lpstr>
      <vt:lpstr>Spectrum 92  MUC5B_HUMAN@145: AQGLVLEASNGSVLINGQR_Deamidated(N)@10; Deamidated(N)@16 MW 1927.002, Precursor m/z 964.51 charge 2+, delta(ppm) -2.3</vt:lpstr>
      <vt:lpstr>Spectrum 93  MUC5B_HUMAN@254: LDGPTEQCPDPLPLPAGNCTDEEGICHR_Carbamidomethyl(C)@8; Deamidated(N)@18; Carbamidomethyl(C)@19; Carbamidomethyl(C)@26 MW 3148.354, Precursor m/z 1050.46 charge 3+, delta(ppm) -1.4</vt:lpstr>
      <vt:lpstr>Spectrum 94  MUC5B_HUMAN@805: VYLDCSNSSAGTPGAECLR_Carbamidomethyl(C)@5; Deamidated(N)@7; Carbamidomethyl(C)@17 MW 2056.884, Precursor m/z 1029.45 charge 2+, delta(ppm) -1.1</vt:lpstr>
      <vt:lpstr>Spectrum 95  MUC5B_HUMAN@929: AQDYCGDNTTHGTFR_Carbamidomethyl(C)@5; Deamidated(N)@8 MW 1742.696, Precursor m/z 581.91 charge 3+, delta(ppm) -7.3</vt:lpstr>
      <vt:lpstr>Spectrum 96  MUC5B_HUMAN@1244: VPTAENCQSCNCTPSGIQCAH_Carbamidomethyl(C)@7; Carbamidomethyl(C)@10; Deamidated(N)@11; Carbamidomethyl(C)@12; Carbamidomethyl(C)@19 MW 2390.935, Precursor m/z 797.99 charge 3+, delta(ppm) -5.5</vt:lpstr>
      <vt:lpstr>Spectrum 97  MUC5B_HUMAN@1292: IAICGSNGTIIR_Carbamidomethyl(C)@4; Deamidated(N)@7 MW 1274.666, Precursor m/z 638.34 charge 2+, delta(ppm) -0.1</vt:lpstr>
      <vt:lpstr>Spectrum 98  MUC5B_HUMAN@1556: DIECQAESFPNWTLAQVGQK_Carbamidomethyl(C)@4; Deamidated(N)@11 MW 2321.06, Precursor m/z 774.69 charge 3+, delta(ppm) 5.1</vt:lpstr>
      <vt:lpstr>Spectrum 99  MUC5B_HUMAN@4960: AFGQFFSPGEVIYNK_Deamidated(N)@14 MW 1703.82, Precursor m/z 852.92 charge 2+, delta(ppm) -3.4</vt:lpstr>
      <vt:lpstr> Spectrum 100  MUC5B_HUMAN@5017|5024: QVNETWTLENCTVAR_Deamidated(N)@3; Deamidated(N)@10; Carbamidomethyl(C)@11 MW 1821.82, Precursor m/z 911.92 charge 2+, delta(ppm) -2.9</vt:lpstr>
      <vt:lpstr>Spectrum 101  MUC5B_HUMAN@5046: VVLLDPKPVANVTCVNK_Deamidated(N)@11; Carbamidomethyl(C)@14 MW 1866.029, Precursor m/z 934.02 charge 2+, delta(ppm) 1.6</vt:lpstr>
      <vt:lpstr>Spectrum 102  MUC5B_HUMAN@5096: GNCTYVLMR_Deamidated(N)@2; Carbamidomethyl(C)@3 MW 1113.495, Precursor m/z 557.75 charge 2+, delta(ppm) 8.3</vt:lpstr>
      <vt:lpstr>Spectrum 103  MUC5B_HUMAN@5111: FGNLSLYLDNHYCTASATAAAAR_Deamidated(N)@3; Carbamidomethyl(C)@13 MW 2487.149, Precursor m/z 830.05 charge 3+, delta(ppm) 8.3</vt:lpstr>
      <vt:lpstr>Spectrum 104 MUC5B_HUMAN@5215: LPYSLFHNNTEGQCGTCTNNQR_Deamidated(N)@8; Carbamidomethyl(C)@14; Carbamidomethyl(C)@17 MW 2611.119, Precursor m/z 871.38 charge 3+, delta(ppm) 0</vt:lpstr>
      <vt:lpstr>Spectrum 105  NEUS_HUMAN@157: WVENNTNNLVK_Deamidated(N)@4 MW 1330.65, Precursor m/z 666.33 charge 2+, delta(ppm) 3.4</vt:lpstr>
      <vt:lpstr>Spectrum 106  NEUS_HUMAN@321: DANLTGLSDNK_Deamidated(N)@3 MW 1147.536, Precursor m/z 574.78 charge 2+, delta(ppm) -8.4</vt:lpstr>
      <vt:lpstr>Spectrum 107  NGAL_HUMAN@85: SYNVTSVLFR_Deamidated(N)@3 MW 1185.604, Precursor m/z 593.81 charge 2+, delta(ppm) -2</vt:lpstr>
      <vt:lpstr>Spectrum 108a  PERL_HUMAN@106: ASLTNVTDPSLDLTSLSLEVGCGAPAPVVR_Deamidated(N)@5; Carbamidomethyl(C)@22 MW 3039.544, Precursor m/z 1014.19 charge 3+, delta(ppm) -1.5</vt:lpstr>
      <vt:lpstr>Spectrum 108b  PERL_HUMAN@106: ASLTNVTDPSLDLT_Deamidated(N)@5 MW 1446.709, Precursor m/z 724.36 charge 2+, delta(ppm) 2.4</vt:lpstr>
      <vt:lpstr>Spectrum 109  PERL_HUMAN@212: IVGYLNEEGVLDQNR_Deamidated(N)@12 MW 1718.85, Precursor m/z 860.43 charge 2+, delta(ppm) 2.6</vt:lpstr>
      <vt:lpstr>Spectrum 110  PERL_HUMAN@322: NLSSPLGLMAVNQEVSDHGLPYLPYDSK_Deamidated(N)@1 MW 3044.481, Precursor m/z 1015.83 charge 3+, delta(ppm) 3.9</vt:lpstr>
      <vt:lpstr>Spectrum 111b  PERL_HUMAN@358: KPSPCEFINTTAR_Carbamidomethyl(C)@5; Deamidated(N)@9 MW 1520.73, Precursor m/z 507.92 charge 3+, delta(ppm) -5.3</vt:lpstr>
      <vt:lpstr>Spectrum 111a  PERL_HUMAN@358: KPSPCEFINTTAR_Carbamidomethyl(C)@5; Deamidated(N)@9 MW 1520.73, Precursor m/z 761.37 charge 2+, delta(ppm) 3</vt:lpstr>
      <vt:lpstr>Spectrum 112a  PIGR_HUMAN@83|90: ANLTNFPENGTFVVNIAQLSQDDSGR_Deamidated(N)@2; Deamidated(N)@5 MW 2808.32, Precursor m/z 1405.17 charge 2, delta(ppm) 0.2  PIGR_HUMAN|Sequence: ANLTNFPENGTFVVNIAQLSQDDSGR Deamidated(N)@2;Deamidated(N)@9 Prec MW: 2808.32|Prec m/z: 1405.167|Delta (ppm): 7.1</vt:lpstr>
      <vt:lpstr>Spectrum 112b  PIGR_HUMAN@83|90: ANLTNFPENGTFVVNIAQLSQDDSGR_Deamidated(N)@2; Deamidated(N)@5 MW 2808.32, Precursor m/z 937.11 charge 3, delta(ppm) 4.3  PIGR_HUMAN: ANLTNFPENGTFVVNIAQLSQDDSGR: Deamidated(N)@2; Deamidated(N)@9   PREC M/Z:937.11 Theor MW: 2808.32 Delta ppm: 0 </vt:lpstr>
      <vt:lpstr>Spectrum 112c  PIGR_HUMAN@83: ANLTNFPENGTFVVN_Deamidated(N)@2; Deamidated(N)@9 MW 1637.76, Precursor m/z 819.89 charge 2+, delta(ppm) -3.3  PIGR_HUMAN: ANLTNFPENGTFVV: Deamidated(N)@2; Deamidated(N)@9  PREC M/Z:819.89 Theor MW: 1637.76 Delta ppm: 0</vt:lpstr>
      <vt:lpstr>Spectrum 113  PIGR_HUMAN@135: DVSLEVSQGPGLLNDTK_Deamidated(N)@14 MW 1771.885, Precursor m/z 886.95 charge 2+, delta(ppm) -0.8</vt:lpstr>
      <vt:lpstr>Spectrum 114  PIGR_HUMAN@186: LVIDSSGYVNPNYTGR_Deamidated(N)@12 MW 1754.85, Precursor m/z 878.43 charge 2+, delta(ppm) 2.6</vt:lpstr>
      <vt:lpstr>Spectrum 115  PIGR_HUMAN@421: LSLLEEPGNGTFTVILNQLTSR_Deamidated(N)@9 MW 2402.27, Precursor m/z 1202.14 charge 2+, delta(ppm) 1.6</vt:lpstr>
      <vt:lpstr>Spectrum 116a PIGR_HUMAN@469: VPGNVTAVLGETLK_Deamidated(N)@4 MW 1397.78, Precursor m/z 699.9 charge 2+, delta(ppm) -3.9</vt:lpstr>
      <vt:lpstr>Spectrum 116b  PIGR_HUMAN@469: GNVTAVLGETLK_Deamidated(N)@2 MW 1201.66, Precursor m/z 601.83 charge 2+, delta(ppm) 12.1</vt:lpstr>
      <vt:lpstr>Spectrum 117  PIGR_HUMAN@499: WNNTGCQALPSQDEGPSK_FormaldehydeAdduct(W)@1; Deamidated(N)@2; Carbamidomethyl(C)@6 MW 2000.85, Precursor m/z 1001.43 charge 2+, delta(ppm) 2.2</vt:lpstr>
      <vt:lpstr>Spectrum 118  PIP_HUMAN@105: TFYWDFYTNR_Deamidated(N)@9 MW 1412.604, Precursor m/z 707.31 charge 2+, delta(ppm) -1.2</vt:lpstr>
      <vt:lpstr>Spectrum 119  PLTP_HUMAN@64: EGHFYYNISEVK_Deamidated(N)@7 MW 1485.68, Precursor m/z 743.85 charge 2+, delta(ppm) -3.6</vt:lpstr>
      <vt:lpstr>Spectrum 120  PLTP_HUMAN@117: FYDGGYINASAEGVSIR_Deamidated(N)@8 MW 1818.843, Precursor m/z 910.42 charge 2+, delta(ppm) 9.3</vt:lpstr>
      <vt:lpstr>Spectrum 121  PLTP_HUMAN@143: VSNVSCQASVSR_Deamidated(N)@3; Carbamidomethyl(C)@6 MW 1293.6, Precursor m/z 647.81 charge 2+, delta(ppm) -4.2</vt:lpstr>
      <vt:lpstr>Spectrum 122a  PLTP_HUMAN@398: IYSNHSALESLALIPLQAPLK_Deamidated(N)@4 MW 2278.258, Precursor m/z 760.43 charge 3+, delta(ppm) -4.7</vt:lpstr>
      <vt:lpstr>Spectrum 122b  PLTP_HUMAN@398: IYSNHSALESL_Deamidated(N)@4 MW 1233.59, Precursor m/z 617.8 charge 2+, delta(ppm) 3.7</vt:lpstr>
      <vt:lpstr>Spectrum 123  PPM1L_HUMAN@117: FEVLTDLANK_Deamidated(N)@9 MW 1149.59, Precursor m/z 575.8 charge 2+, delta(ppm) 3.9</vt:lpstr>
      <vt:lpstr>Spectrum 124  PRB2_HUMAN@168: PQGPPPQGDNKSRSSRSPP_Deamidated(N)@10 MW 1988.97, Precursor m/z 664.01 charge 3+, delta(ppm) -19.2</vt:lpstr>
      <vt:lpstr>Spectrum 125  PRB2_HUMAN@272: PQGPPPQGGNKSQGPPPPGKP_Deamidated(N)@10 MW 2019.02, Precursor m/z 674 charge 3+, delta(ppm) 20.7</vt:lpstr>
      <vt:lpstr>Spectrum 126  PRB3_HUMAN@66: PGKPEGPPPQGGNQSQGPPPR_Deamidated(N)@13 MW 2079.014, Precursor m/z 694.0114 charge 3+, delta(ppm) 0.4</vt:lpstr>
      <vt:lpstr>Spectrum 127  PROM1_HUMAN@220: YILAQYNTTK_Deamidated(N)@7 MW 1214.62, Precursor m/z 608.32 charge 2+, delta(ppm) -4.4</vt:lpstr>
      <vt:lpstr>Spectrum 128  PROM1_HUMAN@395: VLNSIGSDIDNVTQR_Deamidated(N)@11 MW 1630.82, Precursor m/z 816.41 charge 2+, delta(ppm) 8.9</vt:lpstr>
      <vt:lpstr> Spectrum 129  PSG1_HUMAN@104: ETAYSNASLLIQNVTR_Deamidated(N)@6; Deamidated(N)@13 MW 1780.885, Precursor m/z 891.4494 charge 2+, delta(ppm) 0</vt:lpstr>
      <vt:lpstr>Spectrum 130  PTPRF_HUMAN@966: DINSQQELQNITTDTR_Deamidated(N)@10 MW 1875.88, Precursor m/z 938.95 charge 2+, delta(ppm) -2.9</vt:lpstr>
      <vt:lpstr>Spectrum 131  RNT2_HUMAN@212: QDQQLQNCTEPGEQPSPK_Deamidated(N)@7; Carbamidomethyl(C)@8 MW 2083.91, Precursor m/z 1042.96 charge 2+, delta(ppm) 2.1</vt:lpstr>
      <vt:lpstr>Spectrum 132  SAP_HUMAN@80: DNATEEEILVYLEK_Deamidated(N)@2 MW 1665.8, Precursor m/z 833.91 charge 2+, delta(ppm) -3.2</vt:lpstr>
      <vt:lpstr>Spectrum 133  SAP_HUMAN@215: TNSTFVQALVEHVK_Deamidated(N)@2 MW 1572.81, Precursor m/z 525.28 charge 3+, delta(ppm) -5.2</vt:lpstr>
      <vt:lpstr>Spectrum 134  SIL1_HUMAN@193: FNSSSSSLEEK_Deamidated(N)@2 MW 1214.53, Precursor m/z 608.27 charge 2+, delta(ppm) 3.7</vt:lpstr>
      <vt:lpstr>Spectrum 135  SRPR_HUMAN@44: GGNNSFTHEALTLK_Deamidated(N)@3 MW 1488.72, Precursor m/z 497.25 charge 3+, delta(ppm) -5.4</vt:lpstr>
      <vt:lpstr>Spectrum 136  SUMF1_HUMAN@141: FVNSTGYLTEAEK_Deamidated(N)@3 MW 1458.69, Precursor m/z 730.35 charge 2+, delta(ppm) 3.1</vt:lpstr>
      <vt:lpstr>Spectrum 137  TCO1_HUMAN@216: ADEGSLKNISIYTK_Deamidated(N)@8 MW 1538.78, Precursor m/z 513.93 charge 3+, delta(ppm) 7.6</vt:lpstr>
      <vt:lpstr>Spectrum 138  TCO1_HUMAN@337: ISVNYSVR_Deamidated(N)@4 MW 937.49, Precursor m/z 469.75 charge 2+, delta(ppm) 4.8</vt:lpstr>
      <vt:lpstr>Spectrum 139  TCO1_HUMAN@369: MNDTIFGFTMEER_Deamidated(N)@2; Oxidation(M)@10 MW 1606.66, Precursor m/z 804.34 charge 2+, delta(ppm) -3.4</vt:lpstr>
      <vt:lpstr>Spectrum 140  TCO1_HUMAN@137: FQAEIENMEAHNGTPLTN_Oxidation(M)@8; Deamidated(N)@12 MW 2031.885, Precursor m/z 1016.95 charge 2+, delta(ppm) -0.5</vt:lpstr>
      <vt:lpstr> Spectrum 141  TIMP1_HUMAN@53: FVGTPEVNQTTLYQR_Deamidated(N)@8 MW 1752.87, Precursor m/z 877.44 charge 2+, delta(ppm) 2.6</vt:lpstr>
      <vt:lpstr>Spectrum 142  TNF13_HUMAN@124: QHSVLHLVPINATSK_Gln-&gt;pyro-Glu@N-term; Deamidated(N)@11 MW 1626.87, Precursor m/z 814.44 charge 2+, delta(ppm) 2.8</vt:lpstr>
      <vt:lpstr>Spectrum 143  TNR11_HUMAN@105: ALVAVVAGNSTTPR_Deamidated(N)@9 MW 1355.74, Precursor m/z 678.88 charge 2+, delta(ppm) -4</vt:lpstr>
      <vt:lpstr>Spectrum 144  TPP1_HUMAN@443: FLSSSPHLPPSSYFNASGR_Deamidated(N)@15 MW 2050.97, Precursor m/z 684.66 charge 3+, delta(ppm) 5.7</vt:lpstr>
      <vt:lpstr>Spectrum 145  TRFE_HUMAN@630: QQQHLFGSNVTDCSGNFCLFR_Gln-&gt;pyro-Glu@N-term; Deamidated(N)@9; Carbamidomethyl(C)@13; Deamidated(N)@16; Carbamidomethyl(C)@18 MW 2499.06, Precursor m/z 834.03 charge 3+, delta(ppm) -3.2</vt:lpstr>
      <vt:lpstr>Spectrum 146  TRFL_HUMAN@156: PFLNWTGPPEPIEAAVAR_Deamidated(N)@4 MW 1965, Precursor m/z 983.51 charge 2+, delta(ppm) -2.7</vt:lpstr>
      <vt:lpstr>Spectrum 147a  TRFL_HUMAN@497: TAGWNIPMGLLFNQTGSCK_Deamidated(N)@13; Carbamidomethyl(C)@18 MW 2094.987, Precursor m/z 1048.5 charge 2+, delta(ppm) 0.6</vt:lpstr>
      <vt:lpstr>Spectrum 147b  TRFL_HUMAN@497: GLLFNQTGSCK_Deamidated(N)@5; Carbamidomethyl(C)@10 MW 1224.58, Precursor m/z 613.3 charge 2+, delta(ppm) -4.4</vt:lpstr>
      <vt:lpstr>Spectrum 148  TRFL_HUMAN@642: NGSDCPDKFCLFQSETK_Deamidated(N)@1; Carbamidomethyl(C)@5; Carbamidomethyl(C)@10 MW 2032.851, Precursor m/z 678.62 charge 3+, delta(ppm) 6.1</vt:lpstr>
      <vt:lpstr>Spectrum 149  TSP1_HUMAN@1067: VVNSTTGPGEHLR_Deamidated(N)@3 MW 1366.685, Precursor m/z 684.35 charge 2+, delta(ppm) -0.9</vt:lpstr>
      <vt:lpstr>Spectrum 150  TTC17_HUMAN@184: VNLSAPLLPK_Deamidated(N)@2 MW 1051.63, Precursor m/z 526.82 charge 2+, delta(ppm) 4.3</vt:lpstr>
      <vt:lpstr>Spectrum 151  VTNC_HUMAN@86: NNATVHEQVGGPSLTSDLQAQSK_Deamidated(N)@2 MW 2381.146, Precursor m/z 794.72 charge 3+, delta(ppm) 3.2</vt:lpstr>
      <vt:lpstr>Spectrum 152  VTNC_HUMAN@242: NISDGFDGIPDNVDAALALPAHSYSGR_Deamidated(N)@1; Deamidated(N)@12 MW 2773.284, Precursor m/z 925.44 charge 3+, delta(ppm) -5.4  VTNC_HUMAN@1: NISDGFDGIPDNVDAALALPAHSYSGR|Modifications: Deamidated(N)@1 Prec MW: 2772.3|Prec m/z: 925.11|Delta (ppm): 7.2</vt:lpstr>
      <vt:lpstr>Spectrum 153 WFDC2_HUMAN@44: TGVCPELQADQNCTQECVSDSECADNLK_Carbamidomethyl(C)@4; Deamidated(N)@12; Carbamidomethyl(C)@13; Carbamidomethyl(C)@17; Carbamidomethyl(C)@23@44_MW 3228.296, Precursor m/z 1077.11 charge 3+, delta(ppm) -4</vt:lpstr>
      <vt:lpstr>Spectrum 154a  ZA2G_HUMAN@109: DIVEYYNDSNGSHVLQGR_Deamidated(N)@7 MW 2065.93, Precursor m/z 1033.97 charge 2+, delta(ppm) 2.2</vt:lpstr>
      <vt:lpstr>Spectrum 154b  ZA2G_HUMAN@109: DIVEYYNDSNGSHVLQGR_Deamidated(N)@7; Ammonia-loss(N)@10 MW 2048.91, Precursor m/z 1025.46 charge 2+, delta(ppm) 2.2</vt:lpstr>
      <vt:lpstr>Spectrum 154c  ZA2G_HUMAN@109: DIVEYYNDSNGSH_Deamidated(N)@7; Deamidated(N)@10 MW 1513.58, Precursor m/z 757.8 charge 2+, delta(ppm) -3.6</vt:lpstr>
      <vt:lpstr>Spectrum 154d  ZA2G_HUMAN@109: EYYNDSNGSHVLQGR_Deamidated(N)@4; Deamidated(N)@7 MW 1739.739, Precursor m/z 870.87 charge 2+, delta(ppm) 7.6</vt:lpstr>
      <vt:lpstr>Spectrum 155  ZA2G_HUMAN@128: FGCEIENNR_Carbamidomethyl(C)@3; Deamidated(N)@8 MW 1138.47, Precursor m/z 570.24 charge 2+, delta(ppm) 4</vt:lpstr>
      <vt:lpstr>Spectrum 156  ZA2G_HUMAN@259: GDVLHNGNGTYQSWVVVAVPPQDTAPYSCHVQ_Carbamidomethyl(C)@29, Deamidated(N)@6; Deamidated(N)@8 MW 3496.6, Precursor m/z 1166.54 charge 3+, delta(ppm) 0.3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MSMS MP_AAL_370  Accession:4F2_HUMAN Sequence: SLVTQYLNATGNR Mod: Deamidated(N)@8 @ Site: 424 Spectrum: 7.1.1.5543.2 PREC M/Z:719.37 Theor MW: 1436.73 Delta ppm: 7</dc:title>
  <dc:creator>Witkowski</dc:creator>
  <cp:lastModifiedBy>Steve Hall</cp:lastModifiedBy>
  <cp:revision>183</cp:revision>
  <cp:lastPrinted>2015-03-13T21:16:08Z</cp:lastPrinted>
  <dcterms:created xsi:type="dcterms:W3CDTF">2015-03-07T00:05:49Z</dcterms:created>
  <dcterms:modified xsi:type="dcterms:W3CDTF">2015-07-21T20:44:09Z</dcterms:modified>
</cp:coreProperties>
</file>